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65" d="100"/>
          <a:sy n="165" d="100"/>
        </p:scale>
        <p:origin x="148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52ABF77-3743-4A6D-B0CC-2A2C1D7617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2" y="1122363"/>
            <a:ext cx="9143999" cy="2387600"/>
          </a:xfrm>
        </p:spPr>
        <p:txBody>
          <a:bodyPr anchor="b"/>
          <a:lstStyle>
            <a:lvl1pPr algn="ctr">
              <a:defRPr sz="405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93301F2F-1495-42C6-A059-C4DD06FD18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2" y="3602038"/>
            <a:ext cx="9143999" cy="1655762"/>
          </a:xfrm>
        </p:spPr>
        <p:txBody>
          <a:bodyPr/>
          <a:lstStyle>
            <a:lvl1pPr marL="0" indent="0" algn="ctr">
              <a:buNone/>
              <a:defRPr sz="1620"/>
            </a:lvl1pPr>
            <a:lvl2pPr marL="308601" indent="0" algn="ctr">
              <a:buNone/>
              <a:defRPr sz="1350"/>
            </a:lvl2pPr>
            <a:lvl3pPr marL="617202" indent="0" algn="ctr">
              <a:buNone/>
              <a:defRPr sz="1215"/>
            </a:lvl3pPr>
            <a:lvl4pPr marL="925802" indent="0" algn="ctr">
              <a:buNone/>
              <a:defRPr sz="1080"/>
            </a:lvl4pPr>
            <a:lvl5pPr marL="1234403" indent="0" algn="ctr">
              <a:buNone/>
              <a:defRPr sz="1080"/>
            </a:lvl5pPr>
            <a:lvl6pPr marL="1543004" indent="0" algn="ctr">
              <a:buNone/>
              <a:defRPr sz="1080"/>
            </a:lvl6pPr>
            <a:lvl7pPr marL="1851604" indent="0" algn="ctr">
              <a:buNone/>
              <a:defRPr sz="1080"/>
            </a:lvl7pPr>
            <a:lvl8pPr marL="2160204" indent="0" algn="ctr">
              <a:buNone/>
              <a:defRPr sz="1080"/>
            </a:lvl8pPr>
            <a:lvl9pPr marL="2468805" indent="0" algn="ctr">
              <a:buNone/>
              <a:defRPr sz="108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56F5A7D-BA2F-47A9-A305-7AC952038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B711-2AF5-4DFF-B62D-019F2C2BF29F}" type="datetimeFigureOut">
              <a:rPr lang="ko-KR" altLang="en-US" smtClean="0"/>
              <a:t>2025-01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493D650-2ED4-4C0A-8D5D-F13D33379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AFB67CE-BC2A-4639-A68F-11D760D452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85AD6F-4797-41B0-AFDE-1420248BDB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92451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35F519D-8EA5-49FB-8C39-07275BDA33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18321DC3-11BC-4CC8-A144-CF25564768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DDA2265-CCF5-424E-A56A-CEA01637EF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B711-2AF5-4DFF-B62D-019F2C2BF29F}" type="datetimeFigureOut">
              <a:rPr lang="ko-KR" altLang="en-US" smtClean="0"/>
              <a:t>2025-01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776DB2B-3371-4814-B044-6FE33832CA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3057183-B2BE-4472-8339-A7E5BF85B7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85AD6F-4797-41B0-AFDE-1420248BDB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5101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7AF8222-436B-498C-9B34-0D41E5209CB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899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DE70C65-69B2-4FF9-A4E8-BC8D38596B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165C8C8-4345-4BBD-BA15-84BAC0616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B711-2AF5-4DFF-B62D-019F2C2BF29F}" type="datetimeFigureOut">
              <a:rPr lang="ko-KR" altLang="en-US" smtClean="0"/>
              <a:t>2025-01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7D3D6A2-5CFF-4BC0-88C5-7999BA1AF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64E2B54-765E-4AB5-BD3B-0FD05F0D6D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85AD6F-4797-41B0-AFDE-1420248BDB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7650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ED04A1D-9BDA-47B2-B01C-3F322365DE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08AB3AB-4A74-4451-B470-ED2FAF50BF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943364B-6C03-4D5C-8D86-502AE658F1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B711-2AF5-4DFF-B62D-019F2C2BF29F}" type="datetimeFigureOut">
              <a:rPr lang="ko-KR" altLang="en-US" smtClean="0"/>
              <a:t>2025-01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68DE28A-72BD-4F49-ABA4-B995B983A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D8F248A-0FFF-4C28-BFAE-DE1FFEDAD3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85AD6F-4797-41B0-AFDE-1420248BDB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6469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EC3727-2BDE-4E91-8144-74F447EF15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9"/>
            <a:ext cx="10515601" cy="2852737"/>
          </a:xfrm>
        </p:spPr>
        <p:txBody>
          <a:bodyPr anchor="b"/>
          <a:lstStyle>
            <a:lvl1pPr>
              <a:defRPr sz="405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4C8661F-968D-4648-9F1D-A4A4EA2D4B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4"/>
            <a:ext cx="10515601" cy="1500187"/>
          </a:xfrm>
        </p:spPr>
        <p:txBody>
          <a:bodyPr/>
          <a:lstStyle>
            <a:lvl1pPr marL="0" indent="0">
              <a:buNone/>
              <a:defRPr sz="1620">
                <a:solidFill>
                  <a:schemeClr val="tx1">
                    <a:tint val="75000"/>
                  </a:schemeClr>
                </a:solidFill>
              </a:defRPr>
            </a:lvl1pPr>
            <a:lvl2pPr marL="308601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17202" indent="0">
              <a:buNone/>
              <a:defRPr sz="1215">
                <a:solidFill>
                  <a:schemeClr val="tx1">
                    <a:tint val="75000"/>
                  </a:schemeClr>
                </a:solidFill>
              </a:defRPr>
            </a:lvl3pPr>
            <a:lvl4pPr marL="925802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4pPr>
            <a:lvl5pPr marL="1234403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5pPr>
            <a:lvl6pPr marL="1543004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6pPr>
            <a:lvl7pPr marL="1851604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7pPr>
            <a:lvl8pPr marL="2160204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8pPr>
            <a:lvl9pPr marL="2468805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A6A2FB0-3DD6-4CDD-9028-C422C7CE9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B711-2AF5-4DFF-B62D-019F2C2BF29F}" type="datetimeFigureOut">
              <a:rPr lang="ko-KR" altLang="en-US" smtClean="0"/>
              <a:t>2025-01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9301E80-E85A-4A02-8191-3F049DF60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C82AB2E-C1D6-4E74-93B1-002142364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85AD6F-4797-41B0-AFDE-1420248BDB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9767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DED054C-5E9C-41EF-8775-A70CAC6636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47B0964-3C97-4EA2-AE9A-30D84D10A79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2" y="1825625"/>
            <a:ext cx="5181599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24F91A3-107E-4C03-99C9-4078ADF6EA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2" y="1825625"/>
            <a:ext cx="5181599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B4E0B51-C7EB-4359-8042-2D10769DEB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B711-2AF5-4DFF-B62D-019F2C2BF29F}" type="datetimeFigureOut">
              <a:rPr lang="ko-KR" altLang="en-US" smtClean="0"/>
              <a:t>2025-01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8857A32-347D-426A-BB50-FBFEF5833E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8A9A3B1-0D61-429D-91D8-B9063E63CA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85AD6F-4797-41B0-AFDE-1420248BDB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4070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9C7A90B-7EE1-415B-9C37-E166298C0A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7" y="365126"/>
            <a:ext cx="10515601" cy="132556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0D27374-549B-4697-AD82-FD92A742A5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1620" b="1"/>
            </a:lvl1pPr>
            <a:lvl2pPr marL="308601" indent="0">
              <a:buNone/>
              <a:defRPr sz="1350" b="1"/>
            </a:lvl2pPr>
            <a:lvl3pPr marL="617202" indent="0">
              <a:buNone/>
              <a:defRPr sz="1215" b="1"/>
            </a:lvl3pPr>
            <a:lvl4pPr marL="925802" indent="0">
              <a:buNone/>
              <a:defRPr sz="1080" b="1"/>
            </a:lvl4pPr>
            <a:lvl5pPr marL="1234403" indent="0">
              <a:buNone/>
              <a:defRPr sz="1080" b="1"/>
            </a:lvl5pPr>
            <a:lvl6pPr marL="1543004" indent="0">
              <a:buNone/>
              <a:defRPr sz="1080" b="1"/>
            </a:lvl6pPr>
            <a:lvl7pPr marL="1851604" indent="0">
              <a:buNone/>
              <a:defRPr sz="1080" b="1"/>
            </a:lvl7pPr>
            <a:lvl8pPr marL="2160204" indent="0">
              <a:buNone/>
              <a:defRPr sz="1080" b="1"/>
            </a:lvl8pPr>
            <a:lvl9pPr marL="2468805" indent="0">
              <a:buNone/>
              <a:defRPr sz="108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9389785-E5BA-405A-8381-30BF2FB044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001B22A4-94CE-49C6-ABC3-4EB964A6AB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1620" b="1"/>
            </a:lvl1pPr>
            <a:lvl2pPr marL="308601" indent="0">
              <a:buNone/>
              <a:defRPr sz="1350" b="1"/>
            </a:lvl2pPr>
            <a:lvl3pPr marL="617202" indent="0">
              <a:buNone/>
              <a:defRPr sz="1215" b="1"/>
            </a:lvl3pPr>
            <a:lvl4pPr marL="925802" indent="0">
              <a:buNone/>
              <a:defRPr sz="1080" b="1"/>
            </a:lvl4pPr>
            <a:lvl5pPr marL="1234403" indent="0">
              <a:buNone/>
              <a:defRPr sz="1080" b="1"/>
            </a:lvl5pPr>
            <a:lvl6pPr marL="1543004" indent="0">
              <a:buNone/>
              <a:defRPr sz="1080" b="1"/>
            </a:lvl6pPr>
            <a:lvl7pPr marL="1851604" indent="0">
              <a:buNone/>
              <a:defRPr sz="1080" b="1"/>
            </a:lvl7pPr>
            <a:lvl8pPr marL="2160204" indent="0">
              <a:buNone/>
              <a:defRPr sz="1080" b="1"/>
            </a:lvl8pPr>
            <a:lvl9pPr marL="2468805" indent="0">
              <a:buNone/>
              <a:defRPr sz="108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737FFB5-5EC3-45B8-AD4B-56A3D34BD0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6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80C5615E-AE69-42E6-80D8-F4CB82B11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B711-2AF5-4DFF-B62D-019F2C2BF29F}" type="datetimeFigureOut">
              <a:rPr lang="ko-KR" altLang="en-US" smtClean="0"/>
              <a:t>2025-01-2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C66E12B7-98D8-499A-8DD3-5F42F76AD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643FEE52-FC68-4DCE-A845-17C75A6BE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85AD6F-4797-41B0-AFDE-1420248BDB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9129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26D87F5-286B-4718-9FE3-7817D9B5C4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E1F40EFC-EFCB-4564-A2A2-63BFD4BC55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B711-2AF5-4DFF-B62D-019F2C2BF29F}" type="datetimeFigureOut">
              <a:rPr lang="ko-KR" altLang="en-US" smtClean="0"/>
              <a:t>2025-01-2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A0E90495-0537-4018-A1F3-241A88CAF8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DBF46FCD-77C5-49DF-A93B-E9BAF7F942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85AD6F-4797-41B0-AFDE-1420248BDB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7232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6E958E7D-536F-4720-9BAD-7EFAE02B18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B711-2AF5-4DFF-B62D-019F2C2BF29F}" type="datetimeFigureOut">
              <a:rPr lang="ko-KR" altLang="en-US" smtClean="0"/>
              <a:t>2025-01-2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DF9A7E31-D7AC-4ABF-BD37-47560421C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3769687E-2AB6-4A3F-B1B0-5FADA22FF3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85AD6F-4797-41B0-AFDE-1420248BDB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8504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15E1B80-A73F-4A28-A3BB-B103967319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216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3BF6104-F5FF-4C44-9F51-B29E10B629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>
              <a:defRPr sz="2160"/>
            </a:lvl1pPr>
            <a:lvl2pPr>
              <a:defRPr sz="1890"/>
            </a:lvl2pPr>
            <a:lvl3pPr>
              <a:defRPr sz="162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C07CEAB-438D-4D28-903C-F65BBCE4D7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080"/>
            </a:lvl1pPr>
            <a:lvl2pPr marL="308601" indent="0">
              <a:buNone/>
              <a:defRPr sz="945"/>
            </a:lvl2pPr>
            <a:lvl3pPr marL="617202" indent="0">
              <a:buNone/>
              <a:defRPr sz="810"/>
            </a:lvl3pPr>
            <a:lvl4pPr marL="925802" indent="0">
              <a:buNone/>
              <a:defRPr sz="675"/>
            </a:lvl4pPr>
            <a:lvl5pPr marL="1234403" indent="0">
              <a:buNone/>
              <a:defRPr sz="675"/>
            </a:lvl5pPr>
            <a:lvl6pPr marL="1543004" indent="0">
              <a:buNone/>
              <a:defRPr sz="675"/>
            </a:lvl6pPr>
            <a:lvl7pPr marL="1851604" indent="0">
              <a:buNone/>
              <a:defRPr sz="675"/>
            </a:lvl7pPr>
            <a:lvl8pPr marL="2160204" indent="0">
              <a:buNone/>
              <a:defRPr sz="675"/>
            </a:lvl8pPr>
            <a:lvl9pPr marL="2468805" indent="0">
              <a:buNone/>
              <a:defRPr sz="67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B55A889-5997-4AF7-B70A-0ADE14BBD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B711-2AF5-4DFF-B62D-019F2C2BF29F}" type="datetimeFigureOut">
              <a:rPr lang="ko-KR" altLang="en-US" smtClean="0"/>
              <a:t>2025-01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878B714-6547-48D9-A32E-EA50924AF5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4F7D015B-6758-4352-9B46-63A81A843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85AD6F-4797-41B0-AFDE-1420248BDB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6520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0EF07F2-BEAE-4DC8-A716-6E88B298E3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216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863E4955-649E-49A7-9196-9844E5FAD5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 marL="0" indent="0">
              <a:buNone/>
              <a:defRPr sz="2160"/>
            </a:lvl1pPr>
            <a:lvl2pPr marL="308601" indent="0">
              <a:buNone/>
              <a:defRPr sz="1890"/>
            </a:lvl2pPr>
            <a:lvl3pPr marL="617202" indent="0">
              <a:buNone/>
              <a:defRPr sz="1620"/>
            </a:lvl3pPr>
            <a:lvl4pPr marL="925802" indent="0">
              <a:buNone/>
              <a:defRPr sz="1350"/>
            </a:lvl4pPr>
            <a:lvl5pPr marL="1234403" indent="0">
              <a:buNone/>
              <a:defRPr sz="1350"/>
            </a:lvl5pPr>
            <a:lvl6pPr marL="1543004" indent="0">
              <a:buNone/>
              <a:defRPr sz="1350"/>
            </a:lvl6pPr>
            <a:lvl7pPr marL="1851604" indent="0">
              <a:buNone/>
              <a:defRPr sz="1350"/>
            </a:lvl7pPr>
            <a:lvl8pPr marL="2160204" indent="0">
              <a:buNone/>
              <a:defRPr sz="1350"/>
            </a:lvl8pPr>
            <a:lvl9pPr marL="2468805" indent="0">
              <a:buNone/>
              <a:defRPr sz="135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1DA2040D-9254-4B9E-875A-67507D2275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080"/>
            </a:lvl1pPr>
            <a:lvl2pPr marL="308601" indent="0">
              <a:buNone/>
              <a:defRPr sz="945"/>
            </a:lvl2pPr>
            <a:lvl3pPr marL="617202" indent="0">
              <a:buNone/>
              <a:defRPr sz="810"/>
            </a:lvl3pPr>
            <a:lvl4pPr marL="925802" indent="0">
              <a:buNone/>
              <a:defRPr sz="675"/>
            </a:lvl4pPr>
            <a:lvl5pPr marL="1234403" indent="0">
              <a:buNone/>
              <a:defRPr sz="675"/>
            </a:lvl5pPr>
            <a:lvl6pPr marL="1543004" indent="0">
              <a:buNone/>
              <a:defRPr sz="675"/>
            </a:lvl6pPr>
            <a:lvl7pPr marL="1851604" indent="0">
              <a:buNone/>
              <a:defRPr sz="675"/>
            </a:lvl7pPr>
            <a:lvl8pPr marL="2160204" indent="0">
              <a:buNone/>
              <a:defRPr sz="675"/>
            </a:lvl8pPr>
            <a:lvl9pPr marL="2468805" indent="0">
              <a:buNone/>
              <a:defRPr sz="67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E95860C-FAF0-4532-9F68-DEF3E46718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B711-2AF5-4DFF-B62D-019F2C2BF29F}" type="datetimeFigureOut">
              <a:rPr lang="ko-KR" altLang="en-US" smtClean="0"/>
              <a:t>2025-01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CE20ABB-3111-4914-9370-BB35CB19BD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A28F084-EEE4-4D46-B149-51FFCAE8B4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85AD6F-4797-41B0-AFDE-1420248BDB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6657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5EF635F-8A50-4A79-8F04-0643CF4C74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1" cy="13255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5F8F90E-F463-4DF6-8974-930E425B5B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1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E7E8F1A-5113-4860-8BCD-788F931E01C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81B711-2AF5-4DFF-B62D-019F2C2BF29F}" type="datetimeFigureOut">
              <a:rPr lang="ko-KR" altLang="en-US" smtClean="0"/>
              <a:t>2025-01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7E1979C-CD1D-4D71-89BD-F89AD7446E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69FA001-83B7-4FFD-BF55-EED5B7611B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85AD6F-4797-41B0-AFDE-1420248BDB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5973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7202" rtl="0" eaLnBrk="1" latinLnBrk="1" hangingPunct="1">
        <a:lnSpc>
          <a:spcPct val="90000"/>
        </a:lnSpc>
        <a:spcBef>
          <a:spcPct val="0"/>
        </a:spcBef>
        <a:buNone/>
        <a:defRPr sz="297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4300" indent="-154300" algn="l" defTabSz="617202" rtl="0" eaLnBrk="1" latinLnBrk="1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62901" indent="-154300" algn="l" defTabSz="617202" rtl="0" eaLnBrk="1" latinLnBrk="1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771501" indent="-154300" algn="l" defTabSz="617202" rtl="0" eaLnBrk="1" latinLnBrk="1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80102" indent="-154300" algn="l" defTabSz="617202" rtl="0" eaLnBrk="1" latinLnBrk="1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215" kern="1200">
          <a:solidFill>
            <a:schemeClr val="tx1"/>
          </a:solidFill>
          <a:latin typeface="+mn-lt"/>
          <a:ea typeface="+mn-ea"/>
          <a:cs typeface="+mn-cs"/>
        </a:defRPr>
      </a:lvl4pPr>
      <a:lvl5pPr marL="1388703" indent="-154300" algn="l" defTabSz="617202" rtl="0" eaLnBrk="1" latinLnBrk="1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215" kern="1200">
          <a:solidFill>
            <a:schemeClr val="tx1"/>
          </a:solidFill>
          <a:latin typeface="+mn-lt"/>
          <a:ea typeface="+mn-ea"/>
          <a:cs typeface="+mn-cs"/>
        </a:defRPr>
      </a:lvl5pPr>
      <a:lvl6pPr marL="1697304" indent="-154300" algn="l" defTabSz="617202" rtl="0" eaLnBrk="1" latinLnBrk="1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215" kern="1200">
          <a:solidFill>
            <a:schemeClr val="tx1"/>
          </a:solidFill>
          <a:latin typeface="+mn-lt"/>
          <a:ea typeface="+mn-ea"/>
          <a:cs typeface="+mn-cs"/>
        </a:defRPr>
      </a:lvl6pPr>
      <a:lvl7pPr marL="2005904" indent="-154300" algn="l" defTabSz="617202" rtl="0" eaLnBrk="1" latinLnBrk="1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215" kern="1200">
          <a:solidFill>
            <a:schemeClr val="tx1"/>
          </a:solidFill>
          <a:latin typeface="+mn-lt"/>
          <a:ea typeface="+mn-ea"/>
          <a:cs typeface="+mn-cs"/>
        </a:defRPr>
      </a:lvl7pPr>
      <a:lvl8pPr marL="2314505" indent="-154300" algn="l" defTabSz="617202" rtl="0" eaLnBrk="1" latinLnBrk="1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215" kern="1200">
          <a:solidFill>
            <a:schemeClr val="tx1"/>
          </a:solidFill>
          <a:latin typeface="+mn-lt"/>
          <a:ea typeface="+mn-ea"/>
          <a:cs typeface="+mn-cs"/>
        </a:defRPr>
      </a:lvl8pPr>
      <a:lvl9pPr marL="2623106" indent="-154300" algn="l" defTabSz="617202" rtl="0" eaLnBrk="1" latinLnBrk="1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2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617202" rtl="0" eaLnBrk="1" latinLnBrk="1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1pPr>
      <a:lvl2pPr marL="308601" algn="l" defTabSz="617202" rtl="0" eaLnBrk="1" latinLnBrk="1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2pPr>
      <a:lvl3pPr marL="617202" algn="l" defTabSz="617202" rtl="0" eaLnBrk="1" latinLnBrk="1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3pPr>
      <a:lvl4pPr marL="925802" algn="l" defTabSz="617202" rtl="0" eaLnBrk="1" latinLnBrk="1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4pPr>
      <a:lvl5pPr marL="1234403" algn="l" defTabSz="617202" rtl="0" eaLnBrk="1" latinLnBrk="1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5pPr>
      <a:lvl6pPr marL="1543004" algn="l" defTabSz="617202" rtl="0" eaLnBrk="1" latinLnBrk="1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6pPr>
      <a:lvl7pPr marL="1851604" algn="l" defTabSz="617202" rtl="0" eaLnBrk="1" latinLnBrk="1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7pPr>
      <a:lvl8pPr marL="2160204" algn="l" defTabSz="617202" rtl="0" eaLnBrk="1" latinLnBrk="1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8pPr>
      <a:lvl9pPr marL="2468805" algn="l" defTabSz="617202" rtl="0" eaLnBrk="1" latinLnBrk="1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8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2913787" y="246786"/>
            <a:ext cx="6381364" cy="6354471"/>
            <a:chOff x="2913787" y="246786"/>
            <a:chExt cx="6381364" cy="6354471"/>
          </a:xfrm>
        </p:grpSpPr>
        <p:sp>
          <p:nvSpPr>
            <p:cNvPr id="103" name="사각형: 둥근 모서리 102">
              <a:extLst>
                <a:ext uri="{FF2B5EF4-FFF2-40B4-BE49-F238E27FC236}">
                  <a16:creationId xmlns:a16="http://schemas.microsoft.com/office/drawing/2014/main" id="{009392AF-D204-4621-A0AE-CDF5EB714182}"/>
                </a:ext>
              </a:extLst>
            </p:cNvPr>
            <p:cNvSpPr/>
            <p:nvPr/>
          </p:nvSpPr>
          <p:spPr>
            <a:xfrm>
              <a:off x="2913787" y="246786"/>
              <a:ext cx="6381364" cy="6354471"/>
            </a:xfrm>
            <a:prstGeom prst="roundRect">
              <a:avLst>
                <a:gd name="adj" fmla="val 3416"/>
              </a:avLst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545434"/>
              <a:endParaRPr lang="ko-KR" altLang="en-US" sz="1074" dirty="0">
                <a:solidFill>
                  <a:prstClr val="white"/>
                </a:solidFill>
                <a:latin typeface="맑은 고딕" panose="020F0502020204030204"/>
                <a:ea typeface="맑은 고딕" panose="020B0503020000020004" pitchFamily="50" charset="-127"/>
              </a:endParaRPr>
            </a:p>
          </p:txBody>
        </p:sp>
        <p:sp>
          <p:nvSpPr>
            <p:cNvPr id="105" name="사각형: 둥근 모서리 104">
              <a:extLst>
                <a:ext uri="{FF2B5EF4-FFF2-40B4-BE49-F238E27FC236}">
                  <a16:creationId xmlns:a16="http://schemas.microsoft.com/office/drawing/2014/main" id="{C63DCD42-1B8D-4069-8D1F-F76EBEE6CCF9}"/>
                </a:ext>
              </a:extLst>
            </p:cNvPr>
            <p:cNvSpPr/>
            <p:nvPr/>
          </p:nvSpPr>
          <p:spPr>
            <a:xfrm>
              <a:off x="6142162" y="3009125"/>
              <a:ext cx="2745981" cy="1658597"/>
            </a:xfrm>
            <a:prstGeom prst="roundRect">
              <a:avLst>
                <a:gd name="adj" fmla="val 5668"/>
              </a:avLst>
            </a:prstGeom>
            <a:solidFill>
              <a:schemeClr val="bg1"/>
            </a:solidFill>
            <a:ln>
              <a:noFill/>
            </a:ln>
            <a:effectLst>
              <a:outerShdw blurRad="177800" algn="ctr" rotWithShape="0">
                <a:prstClr val="black">
                  <a:alpha val="34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1724" tIns="30862" rIns="61724" bIns="3086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545434"/>
              <a:endParaRPr lang="ko-KR" altLang="en-US" sz="1215">
                <a:solidFill>
                  <a:prstClr val="white"/>
                </a:solidFill>
                <a:latin typeface="맑은 고딕" panose="020F0502020204030204"/>
                <a:ea typeface="맑은 고딕" panose="020B0503020000020004" pitchFamily="50" charset="-127"/>
              </a:endParaRPr>
            </a:p>
          </p:txBody>
        </p:sp>
        <p:sp>
          <p:nvSpPr>
            <p:cNvPr id="106" name="사각형: 둥근 모서리 105">
              <a:extLst>
                <a:ext uri="{FF2B5EF4-FFF2-40B4-BE49-F238E27FC236}">
                  <a16:creationId xmlns:a16="http://schemas.microsoft.com/office/drawing/2014/main" id="{527BA5B9-EB09-4D0E-B98A-F913DDD7EA8F}"/>
                </a:ext>
              </a:extLst>
            </p:cNvPr>
            <p:cNvSpPr/>
            <p:nvPr/>
          </p:nvSpPr>
          <p:spPr>
            <a:xfrm>
              <a:off x="6142162" y="4754378"/>
              <a:ext cx="2745981" cy="1658597"/>
            </a:xfrm>
            <a:prstGeom prst="roundRect">
              <a:avLst>
                <a:gd name="adj" fmla="val 5668"/>
              </a:avLst>
            </a:prstGeom>
            <a:solidFill>
              <a:schemeClr val="bg1"/>
            </a:solidFill>
            <a:ln>
              <a:noFill/>
            </a:ln>
            <a:effectLst>
              <a:outerShdw blurRad="177800" algn="ctr" rotWithShape="0">
                <a:prstClr val="black">
                  <a:alpha val="34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1724" tIns="30862" rIns="61724" bIns="3086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545434"/>
              <a:endParaRPr lang="ko-KR" altLang="en-US" sz="1215">
                <a:solidFill>
                  <a:prstClr val="white"/>
                </a:solidFill>
                <a:latin typeface="맑은 고딕" panose="020F0502020204030204"/>
                <a:ea typeface="맑은 고딕" panose="020B0503020000020004" pitchFamily="50" charset="-127"/>
              </a:endParaRPr>
            </a:p>
          </p:txBody>
        </p:sp>
        <p:pic>
          <p:nvPicPr>
            <p:cNvPr id="107" name="그림 106">
              <a:extLst>
                <a:ext uri="{FF2B5EF4-FFF2-40B4-BE49-F238E27FC236}">
                  <a16:creationId xmlns:a16="http://schemas.microsoft.com/office/drawing/2014/main" id="{502069C7-A125-4185-B0DB-0F334A3BA1A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58083" y="3539374"/>
              <a:ext cx="1561064" cy="1013537"/>
            </a:xfrm>
            <a:prstGeom prst="rect">
              <a:avLst/>
            </a:prstGeom>
          </p:spPr>
        </p:pic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E4C24CD6-4BC6-44E7-98BC-ECE715F41E3B}"/>
                </a:ext>
              </a:extLst>
            </p:cNvPr>
            <p:cNvSpPr txBox="1"/>
            <p:nvPr/>
          </p:nvSpPr>
          <p:spPr>
            <a:xfrm>
              <a:off x="6901058" y="4767752"/>
              <a:ext cx="1670084" cy="237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617202">
                <a:defRPr/>
              </a:pPr>
              <a:endParaRPr lang="ko-KR" altLang="en-US" sz="945" dirty="0">
                <a:ln>
                  <a:solidFill>
                    <a:srgbClr val="1E94A2">
                      <a:shade val="50000"/>
                      <a:alpha val="0"/>
                    </a:srgbClr>
                  </a:solidFill>
                </a:ln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B07BD78D-38C4-4BED-88C8-6E4FA90F8254}"/>
                </a:ext>
              </a:extLst>
            </p:cNvPr>
            <p:cNvSpPr txBox="1"/>
            <p:nvPr/>
          </p:nvSpPr>
          <p:spPr>
            <a:xfrm>
              <a:off x="5476911" y="5736660"/>
              <a:ext cx="1412140" cy="23775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617202">
                <a:defRPr/>
              </a:pPr>
              <a:endParaRPr lang="ko-KR" altLang="en-US" sz="945" dirty="0">
                <a:ln>
                  <a:solidFill>
                    <a:srgbClr val="1E94A2">
                      <a:shade val="50000"/>
                      <a:alpha val="0"/>
                    </a:srgbClr>
                  </a:solidFill>
                </a:ln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4D8D81F3-25DA-4500-A466-59D976605E19}"/>
                </a:ext>
              </a:extLst>
            </p:cNvPr>
            <p:cNvSpPr txBox="1"/>
            <p:nvPr/>
          </p:nvSpPr>
          <p:spPr>
            <a:xfrm>
              <a:off x="4679576" y="297608"/>
              <a:ext cx="3111938" cy="2800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545434">
                <a:defRPr/>
              </a:pPr>
              <a:r>
                <a:rPr lang="en-US" altLang="ko-KR" sz="1829" b="1" baseline="-25000" dirty="0">
                  <a:ln>
                    <a:solidFill>
                      <a:srgbClr val="1E94A2">
                        <a:shade val="50000"/>
                        <a:alpha val="0"/>
                      </a:srgbClr>
                    </a:solidFill>
                  </a:ln>
                  <a:solidFill>
                    <a:prstClr val="black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Age-and Sex-matched pairs</a:t>
              </a:r>
            </a:p>
          </p:txBody>
        </p:sp>
        <p:sp>
          <p:nvSpPr>
            <p:cNvPr id="112" name="사각형: 둥근 위쪽 모서리 111">
              <a:extLst>
                <a:ext uri="{FF2B5EF4-FFF2-40B4-BE49-F238E27FC236}">
                  <a16:creationId xmlns:a16="http://schemas.microsoft.com/office/drawing/2014/main" id="{EA7F7F72-5B02-474B-B813-09F15738D458}"/>
                </a:ext>
              </a:extLst>
            </p:cNvPr>
            <p:cNvSpPr/>
            <p:nvPr/>
          </p:nvSpPr>
          <p:spPr>
            <a:xfrm>
              <a:off x="6139297" y="3009126"/>
              <a:ext cx="2745981" cy="411501"/>
            </a:xfrm>
            <a:prstGeom prst="round2SameRect">
              <a:avLst>
                <a:gd name="adj1" fmla="val 26504"/>
                <a:gd name="adj2" fmla="val 0"/>
              </a:avLst>
            </a:prstGeom>
            <a:gradFill flip="none" rotWithShape="1">
              <a:gsLst>
                <a:gs pos="0">
                  <a:schemeClr val="accent5"/>
                </a:gs>
                <a:gs pos="42000">
                  <a:schemeClr val="accent1"/>
                </a:gs>
              </a:gsLst>
              <a:lin ang="108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1724" tIns="30862" rIns="61724" bIns="3086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545434"/>
              <a:r>
                <a:rPr lang="en-US" altLang="ko-KR" sz="1067" b="1" dirty="0">
                  <a:ln>
                    <a:solidFill>
                      <a:srgbClr val="1E94A2">
                        <a:shade val="50000"/>
                        <a:alpha val="0"/>
                      </a:srgbClr>
                    </a:solidFill>
                  </a:ln>
                  <a:solidFill>
                    <a:prstClr val="white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Dietary fiber breakdown &amp; </a:t>
              </a:r>
              <a:br>
                <a:rPr lang="en-US" altLang="ko-KR" sz="1067" b="1" dirty="0">
                  <a:ln>
                    <a:solidFill>
                      <a:srgbClr val="1E94A2">
                        <a:shade val="50000"/>
                        <a:alpha val="0"/>
                      </a:srgbClr>
                    </a:solidFill>
                  </a:ln>
                  <a:solidFill>
                    <a:prstClr val="white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</a:br>
              <a:r>
                <a:rPr lang="en-US" altLang="ko-KR" sz="1067" b="1" dirty="0">
                  <a:ln>
                    <a:solidFill>
                      <a:srgbClr val="1E94A2">
                        <a:shade val="50000"/>
                        <a:alpha val="0"/>
                      </a:srgbClr>
                    </a:solidFill>
                  </a:ln>
                  <a:solidFill>
                    <a:prstClr val="white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generating short-chain fatty acids</a:t>
              </a:r>
            </a:p>
          </p:txBody>
        </p:sp>
        <p:sp>
          <p:nvSpPr>
            <p:cNvPr id="113" name="사각형: 둥근 위쪽 모서리 112">
              <a:extLst>
                <a:ext uri="{FF2B5EF4-FFF2-40B4-BE49-F238E27FC236}">
                  <a16:creationId xmlns:a16="http://schemas.microsoft.com/office/drawing/2014/main" id="{067D92BD-0D72-4B91-B5C1-96C68CADF5D6}"/>
                </a:ext>
              </a:extLst>
            </p:cNvPr>
            <p:cNvSpPr/>
            <p:nvPr/>
          </p:nvSpPr>
          <p:spPr>
            <a:xfrm>
              <a:off x="6139297" y="4754378"/>
              <a:ext cx="2745981" cy="411501"/>
            </a:xfrm>
            <a:prstGeom prst="round2SameRect">
              <a:avLst>
                <a:gd name="adj1" fmla="val 26504"/>
                <a:gd name="adj2" fmla="val 0"/>
              </a:avLst>
            </a:prstGeom>
            <a:gradFill flip="none" rotWithShape="1">
              <a:gsLst>
                <a:gs pos="0">
                  <a:schemeClr val="accent5"/>
                </a:gs>
                <a:gs pos="42000">
                  <a:schemeClr val="accent1"/>
                </a:gs>
              </a:gsLst>
              <a:lin ang="108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1724" tIns="30862" rIns="61724" bIns="3086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545434"/>
              <a:r>
                <a:rPr lang="en-US" altLang="ko-KR" sz="1067" b="1" dirty="0">
                  <a:ln>
                    <a:solidFill>
                      <a:srgbClr val="1E94A2">
                        <a:shade val="50000"/>
                        <a:alpha val="0"/>
                      </a:srgbClr>
                    </a:solidFill>
                  </a:ln>
                  <a:solidFill>
                    <a:prstClr val="white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Protective barrier function</a:t>
              </a:r>
            </a:p>
          </p:txBody>
        </p:sp>
        <p:sp>
          <p:nvSpPr>
            <p:cNvPr id="114" name="직사각형 113">
              <a:extLst>
                <a:ext uri="{FF2B5EF4-FFF2-40B4-BE49-F238E27FC236}">
                  <a16:creationId xmlns:a16="http://schemas.microsoft.com/office/drawing/2014/main" id="{E4DD64E7-EDC6-47C8-8958-9C6D0E480927}"/>
                </a:ext>
              </a:extLst>
            </p:cNvPr>
            <p:cNvSpPr/>
            <p:nvPr/>
          </p:nvSpPr>
          <p:spPr>
            <a:xfrm>
              <a:off x="8219146" y="3685376"/>
              <a:ext cx="657552" cy="23775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defTabSz="545434"/>
              <a:r>
                <a:rPr lang="en-US" altLang="ko-KR" sz="945" dirty="0">
                  <a:ln>
                    <a:solidFill>
                      <a:srgbClr val="1E94A2">
                        <a:shade val="50000"/>
                        <a:alpha val="0"/>
                      </a:srgbClr>
                    </a:solidFill>
                  </a:ln>
                  <a:solidFill>
                    <a:prstClr val="black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cellulose</a:t>
              </a:r>
              <a:endParaRPr lang="ko-KR" altLang="en-US" sz="945" dirty="0">
                <a:ln>
                  <a:solidFill>
                    <a:srgbClr val="1E94A2">
                      <a:shade val="50000"/>
                      <a:alpha val="0"/>
                    </a:srgbClr>
                  </a:solidFill>
                </a:ln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5" name="직사각형 114">
              <a:extLst>
                <a:ext uri="{FF2B5EF4-FFF2-40B4-BE49-F238E27FC236}">
                  <a16:creationId xmlns:a16="http://schemas.microsoft.com/office/drawing/2014/main" id="{BD3D56FC-C501-4A52-A233-10A208BA464B}"/>
                </a:ext>
              </a:extLst>
            </p:cNvPr>
            <p:cNvSpPr/>
            <p:nvPr/>
          </p:nvSpPr>
          <p:spPr>
            <a:xfrm>
              <a:off x="7468279" y="3901728"/>
              <a:ext cx="724878" cy="23775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defTabSz="545434"/>
              <a:r>
                <a:rPr lang="en-US" altLang="ko-KR" sz="945" dirty="0">
                  <a:ln>
                    <a:solidFill>
                      <a:srgbClr val="1E94A2">
                        <a:shade val="50000"/>
                        <a:alpha val="0"/>
                      </a:srgbClr>
                    </a:solidFill>
                  </a:ln>
                  <a:solidFill>
                    <a:prstClr val="black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hydrolysis</a:t>
              </a:r>
              <a:endParaRPr lang="ko-KR" altLang="en-US" sz="945" dirty="0">
                <a:ln>
                  <a:solidFill>
                    <a:srgbClr val="1E94A2">
                      <a:shade val="50000"/>
                      <a:alpha val="0"/>
                    </a:srgbClr>
                  </a:solidFill>
                </a:ln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6" name="직사각형 115">
              <a:extLst>
                <a:ext uri="{FF2B5EF4-FFF2-40B4-BE49-F238E27FC236}">
                  <a16:creationId xmlns:a16="http://schemas.microsoft.com/office/drawing/2014/main" id="{FA06AF83-982A-4BB3-884A-D241519ACB6C}"/>
                </a:ext>
              </a:extLst>
            </p:cNvPr>
            <p:cNvSpPr/>
            <p:nvPr/>
          </p:nvSpPr>
          <p:spPr>
            <a:xfrm>
              <a:off x="6986299" y="5188916"/>
              <a:ext cx="1112805" cy="23775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defTabSz="545434"/>
              <a:r>
                <a:rPr lang="en-US" altLang="ko-KR" sz="945" dirty="0">
                  <a:ln>
                    <a:solidFill>
                      <a:srgbClr val="1E94A2">
                        <a:shade val="50000"/>
                        <a:alpha val="0"/>
                      </a:srgbClr>
                    </a:solidFill>
                  </a:ln>
                  <a:solidFill>
                    <a:prstClr val="black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ABC transporters</a:t>
              </a:r>
              <a:endParaRPr lang="ko-KR" altLang="en-US" sz="945" dirty="0">
                <a:ln>
                  <a:solidFill>
                    <a:srgbClr val="1E94A2">
                      <a:shade val="50000"/>
                      <a:alpha val="0"/>
                    </a:srgbClr>
                  </a:solidFill>
                </a:ln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7" name="사각형: 둥근 모서리 116">
              <a:extLst>
                <a:ext uri="{FF2B5EF4-FFF2-40B4-BE49-F238E27FC236}">
                  <a16:creationId xmlns:a16="http://schemas.microsoft.com/office/drawing/2014/main" id="{66F7BC97-0DC3-4967-93CE-58E54E9B8311}"/>
                </a:ext>
              </a:extLst>
            </p:cNvPr>
            <p:cNvSpPr/>
            <p:nvPr/>
          </p:nvSpPr>
          <p:spPr>
            <a:xfrm>
              <a:off x="3306585" y="3009125"/>
              <a:ext cx="2745981" cy="1658597"/>
            </a:xfrm>
            <a:prstGeom prst="roundRect">
              <a:avLst>
                <a:gd name="adj" fmla="val 5668"/>
              </a:avLst>
            </a:prstGeom>
            <a:solidFill>
              <a:schemeClr val="bg1"/>
            </a:solidFill>
            <a:ln>
              <a:noFill/>
            </a:ln>
            <a:effectLst>
              <a:outerShdw blurRad="177800" algn="ctr" rotWithShape="0">
                <a:prstClr val="black">
                  <a:alpha val="34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1724" tIns="30862" rIns="61724" bIns="3086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545434"/>
              <a:endParaRPr lang="ko-KR" altLang="en-US" sz="1215" dirty="0">
                <a:solidFill>
                  <a:prstClr val="white"/>
                </a:solidFill>
                <a:latin typeface="맑은 고딕" panose="020F0502020204030204"/>
                <a:ea typeface="맑은 고딕" panose="020B0503020000020004" pitchFamily="50" charset="-127"/>
              </a:endParaRPr>
            </a:p>
          </p:txBody>
        </p:sp>
        <p:sp>
          <p:nvSpPr>
            <p:cNvPr id="118" name="사각형: 둥근 모서리 117">
              <a:extLst>
                <a:ext uri="{FF2B5EF4-FFF2-40B4-BE49-F238E27FC236}">
                  <a16:creationId xmlns:a16="http://schemas.microsoft.com/office/drawing/2014/main" id="{CA98FE49-E30F-42CA-ADDA-4D3A04EBE595}"/>
                </a:ext>
              </a:extLst>
            </p:cNvPr>
            <p:cNvSpPr/>
            <p:nvPr/>
          </p:nvSpPr>
          <p:spPr>
            <a:xfrm>
              <a:off x="3306585" y="4754378"/>
              <a:ext cx="2745981" cy="1658597"/>
            </a:xfrm>
            <a:prstGeom prst="roundRect">
              <a:avLst>
                <a:gd name="adj" fmla="val 5668"/>
              </a:avLst>
            </a:prstGeom>
            <a:solidFill>
              <a:schemeClr val="bg1"/>
            </a:solidFill>
            <a:ln>
              <a:noFill/>
            </a:ln>
            <a:effectLst>
              <a:outerShdw blurRad="177800" algn="ctr" rotWithShape="0">
                <a:prstClr val="black">
                  <a:alpha val="34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1724" tIns="30862" rIns="61724" bIns="3086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545434"/>
              <a:endParaRPr lang="ko-KR" altLang="en-US" sz="1215">
                <a:solidFill>
                  <a:prstClr val="white"/>
                </a:solidFill>
                <a:latin typeface="맑은 고딕" panose="020F0502020204030204"/>
                <a:ea typeface="맑은 고딕" panose="020B0503020000020004" pitchFamily="50" charset="-127"/>
              </a:endParaRPr>
            </a:p>
          </p:txBody>
        </p:sp>
        <p:pic>
          <p:nvPicPr>
            <p:cNvPr id="119" name="그림 118">
              <a:extLst>
                <a:ext uri="{FF2B5EF4-FFF2-40B4-BE49-F238E27FC236}">
                  <a16:creationId xmlns:a16="http://schemas.microsoft.com/office/drawing/2014/main" id="{76CA5AC2-906D-44D2-B337-2261A3ED07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595" t="-1124"/>
            <a:stretch/>
          </p:blipFill>
          <p:spPr>
            <a:xfrm>
              <a:off x="3541778" y="5278679"/>
              <a:ext cx="1052699" cy="885044"/>
            </a:xfrm>
            <a:prstGeom prst="rect">
              <a:avLst/>
            </a:prstGeom>
          </p:spPr>
        </p:pic>
        <p:pic>
          <p:nvPicPr>
            <p:cNvPr id="120" name="그림 119">
              <a:extLst>
                <a:ext uri="{FF2B5EF4-FFF2-40B4-BE49-F238E27FC236}">
                  <a16:creationId xmlns:a16="http://schemas.microsoft.com/office/drawing/2014/main" id="{A0BB956A-8624-4D48-B7F4-5E03C823F0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72" t="20941" r="8189"/>
            <a:stretch/>
          </p:blipFill>
          <p:spPr>
            <a:xfrm>
              <a:off x="3482828" y="3478687"/>
              <a:ext cx="2381921" cy="1179074"/>
            </a:xfrm>
            <a:prstGeom prst="rect">
              <a:avLst/>
            </a:prstGeom>
          </p:spPr>
        </p:pic>
        <p:sp>
          <p:nvSpPr>
            <p:cNvPr id="121" name="사각형: 둥근 위쪽 모서리 120">
              <a:extLst>
                <a:ext uri="{FF2B5EF4-FFF2-40B4-BE49-F238E27FC236}">
                  <a16:creationId xmlns:a16="http://schemas.microsoft.com/office/drawing/2014/main" id="{50179F53-5312-42FE-B712-8BD2E2DF6F14}"/>
                </a:ext>
              </a:extLst>
            </p:cNvPr>
            <p:cNvSpPr/>
            <p:nvPr/>
          </p:nvSpPr>
          <p:spPr>
            <a:xfrm>
              <a:off x="3306585" y="3009126"/>
              <a:ext cx="2745981" cy="411501"/>
            </a:xfrm>
            <a:prstGeom prst="round2SameRect">
              <a:avLst>
                <a:gd name="adj1" fmla="val 26504"/>
                <a:gd name="adj2" fmla="val 0"/>
              </a:avLst>
            </a:prstGeom>
            <a:gradFill flip="none" rotWithShape="1">
              <a:gsLst>
                <a:gs pos="0">
                  <a:schemeClr val="accent5"/>
                </a:gs>
                <a:gs pos="42000">
                  <a:schemeClr val="accent1"/>
                </a:gs>
              </a:gsLst>
              <a:lin ang="108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1724" tIns="30862" rIns="61724" bIns="3086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545434"/>
              <a:r>
                <a:rPr lang="en-US" altLang="ko-KR" sz="1067" b="1" dirty="0">
                  <a:ln>
                    <a:solidFill>
                      <a:srgbClr val="1E94A2">
                        <a:shade val="50000"/>
                        <a:alpha val="0"/>
                      </a:srgbClr>
                    </a:solidFill>
                  </a:ln>
                  <a:solidFill>
                    <a:prstClr val="white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Differential fecal microbiota </a:t>
              </a:r>
            </a:p>
          </p:txBody>
        </p:sp>
        <p:sp>
          <p:nvSpPr>
            <p:cNvPr id="122" name="사각형: 둥근 위쪽 모서리 121">
              <a:extLst>
                <a:ext uri="{FF2B5EF4-FFF2-40B4-BE49-F238E27FC236}">
                  <a16:creationId xmlns:a16="http://schemas.microsoft.com/office/drawing/2014/main" id="{2761CC36-F3AC-48AE-B3C3-835BECFA6116}"/>
                </a:ext>
              </a:extLst>
            </p:cNvPr>
            <p:cNvSpPr/>
            <p:nvPr/>
          </p:nvSpPr>
          <p:spPr>
            <a:xfrm>
              <a:off x="3306585" y="4754378"/>
              <a:ext cx="2745981" cy="411501"/>
            </a:xfrm>
            <a:prstGeom prst="round2SameRect">
              <a:avLst>
                <a:gd name="adj1" fmla="val 26504"/>
                <a:gd name="adj2" fmla="val 0"/>
              </a:avLst>
            </a:prstGeom>
            <a:gradFill flip="none" rotWithShape="1">
              <a:gsLst>
                <a:gs pos="0">
                  <a:schemeClr val="accent5"/>
                </a:gs>
                <a:gs pos="42000">
                  <a:schemeClr val="accent1"/>
                </a:gs>
              </a:gsLst>
              <a:lin ang="108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1724" tIns="30862" rIns="61724" bIns="3086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545434"/>
              <a:r>
                <a:rPr lang="en-US" altLang="ko-KR" sz="1067" b="1">
                  <a:ln>
                    <a:solidFill>
                      <a:srgbClr val="1E94A2">
                        <a:shade val="50000"/>
                        <a:alpha val="0"/>
                      </a:srgbClr>
                    </a:solidFill>
                  </a:ln>
                  <a:solidFill>
                    <a:prstClr val="white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Differential diversity</a:t>
              </a:r>
              <a:endParaRPr lang="en-US" altLang="ko-KR" sz="1067" b="1" dirty="0">
                <a:ln>
                  <a:solidFill>
                    <a:srgbClr val="1E94A2">
                      <a:shade val="50000"/>
                      <a:alpha val="0"/>
                    </a:srgbClr>
                  </a:solidFill>
                </a:ln>
                <a:solidFill>
                  <a:prstClr val="white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123" name="그림 122">
              <a:extLst>
                <a:ext uri="{FF2B5EF4-FFF2-40B4-BE49-F238E27FC236}">
                  <a16:creationId xmlns:a16="http://schemas.microsoft.com/office/drawing/2014/main" id="{53C55C2F-3857-4969-B5F7-9CB9E838FF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728" r="62140"/>
            <a:stretch/>
          </p:blipFill>
          <p:spPr>
            <a:xfrm>
              <a:off x="4984428" y="5370352"/>
              <a:ext cx="756173" cy="798681"/>
            </a:xfrm>
            <a:prstGeom prst="rect">
              <a:avLst/>
            </a:prstGeom>
          </p:spPr>
        </p:pic>
        <p:sp>
          <p:nvSpPr>
            <p:cNvPr id="124" name="직사각형 123">
              <a:extLst>
                <a:ext uri="{FF2B5EF4-FFF2-40B4-BE49-F238E27FC236}">
                  <a16:creationId xmlns:a16="http://schemas.microsoft.com/office/drawing/2014/main" id="{AF293CFA-BD91-43A9-8093-F850B5B08A76}"/>
                </a:ext>
              </a:extLst>
            </p:cNvPr>
            <p:cNvSpPr/>
            <p:nvPr/>
          </p:nvSpPr>
          <p:spPr>
            <a:xfrm>
              <a:off x="4984428" y="6154839"/>
              <a:ext cx="811441" cy="23775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defTabSz="545434"/>
              <a:r>
                <a:rPr lang="en-US" altLang="ko-KR" sz="945" dirty="0">
                  <a:ln>
                    <a:solidFill>
                      <a:srgbClr val="1E94A2">
                        <a:shade val="50000"/>
                        <a:alpha val="0"/>
                      </a:srgbClr>
                    </a:solidFill>
                  </a:ln>
                  <a:solidFill>
                    <a:prstClr val="black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food allergy</a:t>
              </a:r>
              <a:endParaRPr lang="ko-KR" altLang="en-US" sz="945" dirty="0">
                <a:ln>
                  <a:solidFill>
                    <a:srgbClr val="1E94A2">
                      <a:shade val="50000"/>
                      <a:alpha val="0"/>
                    </a:srgbClr>
                  </a:solidFill>
                </a:ln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25" name="직사각형 124">
              <a:extLst>
                <a:ext uri="{FF2B5EF4-FFF2-40B4-BE49-F238E27FC236}">
                  <a16:creationId xmlns:a16="http://schemas.microsoft.com/office/drawing/2014/main" id="{A4FFDB0D-8674-4FA8-A816-8D02790DD8D3}"/>
                </a:ext>
              </a:extLst>
            </p:cNvPr>
            <p:cNvSpPr/>
            <p:nvPr/>
          </p:nvSpPr>
          <p:spPr>
            <a:xfrm>
              <a:off x="3850007" y="6163637"/>
              <a:ext cx="575799" cy="23775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defTabSz="545434"/>
              <a:r>
                <a:rPr lang="en-US" altLang="ko-KR" sz="945" dirty="0">
                  <a:ln>
                    <a:solidFill>
                      <a:srgbClr val="1E94A2">
                        <a:shade val="50000"/>
                        <a:alpha val="0"/>
                      </a:srgbClr>
                    </a:solidFill>
                  </a:ln>
                  <a:solidFill>
                    <a:prstClr val="black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healthy</a:t>
              </a:r>
              <a:endParaRPr lang="ko-KR" altLang="en-US" sz="945" dirty="0">
                <a:ln>
                  <a:solidFill>
                    <a:srgbClr val="1E94A2">
                      <a:shade val="50000"/>
                      <a:alpha val="0"/>
                    </a:srgbClr>
                  </a:solidFill>
                </a:ln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28" name="Freeform 5">
              <a:extLst>
                <a:ext uri="{FF2B5EF4-FFF2-40B4-BE49-F238E27FC236}">
                  <a16:creationId xmlns:a16="http://schemas.microsoft.com/office/drawing/2014/main" id="{0DCC3CDB-DA6F-4F61-A49F-00520858D260}"/>
                </a:ext>
              </a:extLst>
            </p:cNvPr>
            <p:cNvSpPr>
              <a:spLocks/>
            </p:cNvSpPr>
            <p:nvPr/>
          </p:nvSpPr>
          <p:spPr bwMode="auto">
            <a:xfrm rot="5400000">
              <a:off x="5770007" y="1901215"/>
              <a:ext cx="913186" cy="1160831"/>
            </a:xfrm>
            <a:custGeom>
              <a:avLst/>
              <a:gdLst>
                <a:gd name="T0" fmla="*/ 279 w 281"/>
                <a:gd name="T1" fmla="*/ 24 h 221"/>
                <a:gd name="T2" fmla="*/ 263 w 281"/>
                <a:gd name="T3" fmla="*/ 12 h 221"/>
                <a:gd name="T4" fmla="*/ 255 w 281"/>
                <a:gd name="T5" fmla="*/ 6 h 221"/>
                <a:gd name="T6" fmla="*/ 245 w 281"/>
                <a:gd name="T7" fmla="*/ 0 h 221"/>
                <a:gd name="T8" fmla="*/ 242 w 281"/>
                <a:gd name="T9" fmla="*/ 3 h 221"/>
                <a:gd name="T10" fmla="*/ 249 w 281"/>
                <a:gd name="T11" fmla="*/ 10 h 221"/>
                <a:gd name="T12" fmla="*/ 258 w 281"/>
                <a:gd name="T13" fmla="*/ 16 h 221"/>
                <a:gd name="T14" fmla="*/ 264 w 281"/>
                <a:gd name="T15" fmla="*/ 21 h 221"/>
                <a:gd name="T16" fmla="*/ 237 w 281"/>
                <a:gd name="T17" fmla="*/ 20 h 221"/>
                <a:gd name="T18" fmla="*/ 199 w 281"/>
                <a:gd name="T19" fmla="*/ 26 h 221"/>
                <a:gd name="T20" fmla="*/ 127 w 281"/>
                <a:gd name="T21" fmla="*/ 54 h 221"/>
                <a:gd name="T22" fmla="*/ 25 w 281"/>
                <a:gd name="T23" fmla="*/ 150 h 221"/>
                <a:gd name="T24" fmla="*/ 9 w 281"/>
                <a:gd name="T25" fmla="*/ 183 h 221"/>
                <a:gd name="T26" fmla="*/ 0 w 281"/>
                <a:gd name="T27" fmla="*/ 217 h 221"/>
                <a:gd name="T28" fmla="*/ 5 w 281"/>
                <a:gd name="T29" fmla="*/ 218 h 221"/>
                <a:gd name="T30" fmla="*/ 15 w 281"/>
                <a:gd name="T31" fmla="*/ 189 h 221"/>
                <a:gd name="T32" fmla="*/ 28 w 281"/>
                <a:gd name="T33" fmla="*/ 160 h 221"/>
                <a:gd name="T34" fmla="*/ 66 w 281"/>
                <a:gd name="T35" fmla="*/ 108 h 221"/>
                <a:gd name="T36" fmla="*/ 191 w 281"/>
                <a:gd name="T37" fmla="*/ 35 h 221"/>
                <a:gd name="T38" fmla="*/ 231 w 281"/>
                <a:gd name="T39" fmla="*/ 27 h 221"/>
                <a:gd name="T40" fmla="*/ 262 w 281"/>
                <a:gd name="T41" fmla="*/ 28 h 221"/>
                <a:gd name="T42" fmla="*/ 256 w 281"/>
                <a:gd name="T43" fmla="*/ 31 h 221"/>
                <a:gd name="T44" fmla="*/ 247 w 281"/>
                <a:gd name="T45" fmla="*/ 37 h 221"/>
                <a:gd name="T46" fmla="*/ 243 w 281"/>
                <a:gd name="T47" fmla="*/ 40 h 221"/>
                <a:gd name="T48" fmla="*/ 240 w 281"/>
                <a:gd name="T49" fmla="*/ 44 h 221"/>
                <a:gd name="T50" fmla="*/ 244 w 281"/>
                <a:gd name="T51" fmla="*/ 47 h 221"/>
                <a:gd name="T52" fmla="*/ 248 w 281"/>
                <a:gd name="T53" fmla="*/ 45 h 221"/>
                <a:gd name="T54" fmla="*/ 252 w 281"/>
                <a:gd name="T55" fmla="*/ 42 h 221"/>
                <a:gd name="T56" fmla="*/ 259 w 281"/>
                <a:gd name="T57" fmla="*/ 37 h 221"/>
                <a:gd name="T58" fmla="*/ 277 w 281"/>
                <a:gd name="T59" fmla="*/ 30 h 221"/>
                <a:gd name="T60" fmla="*/ 279 w 281"/>
                <a:gd name="T61" fmla="*/ 24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281" h="221">
                  <a:moveTo>
                    <a:pt x="279" y="24"/>
                  </a:moveTo>
                  <a:cubicBezTo>
                    <a:pt x="275" y="19"/>
                    <a:pt x="269" y="15"/>
                    <a:pt x="263" y="12"/>
                  </a:cubicBezTo>
                  <a:cubicBezTo>
                    <a:pt x="255" y="6"/>
                    <a:pt x="255" y="6"/>
                    <a:pt x="255" y="6"/>
                  </a:cubicBezTo>
                  <a:cubicBezTo>
                    <a:pt x="252" y="4"/>
                    <a:pt x="249" y="1"/>
                    <a:pt x="245" y="0"/>
                  </a:cubicBezTo>
                  <a:cubicBezTo>
                    <a:pt x="243" y="0"/>
                    <a:pt x="241" y="2"/>
                    <a:pt x="242" y="3"/>
                  </a:cubicBezTo>
                  <a:cubicBezTo>
                    <a:pt x="244" y="6"/>
                    <a:pt x="247" y="8"/>
                    <a:pt x="249" y="10"/>
                  </a:cubicBezTo>
                  <a:cubicBezTo>
                    <a:pt x="252" y="12"/>
                    <a:pt x="255" y="14"/>
                    <a:pt x="258" y="16"/>
                  </a:cubicBezTo>
                  <a:cubicBezTo>
                    <a:pt x="260" y="18"/>
                    <a:pt x="262" y="20"/>
                    <a:pt x="264" y="21"/>
                  </a:cubicBezTo>
                  <a:cubicBezTo>
                    <a:pt x="256" y="19"/>
                    <a:pt x="246" y="19"/>
                    <a:pt x="237" y="20"/>
                  </a:cubicBezTo>
                  <a:cubicBezTo>
                    <a:pt x="225" y="21"/>
                    <a:pt x="212" y="23"/>
                    <a:pt x="199" y="26"/>
                  </a:cubicBezTo>
                  <a:cubicBezTo>
                    <a:pt x="174" y="32"/>
                    <a:pt x="150" y="41"/>
                    <a:pt x="127" y="54"/>
                  </a:cubicBezTo>
                  <a:cubicBezTo>
                    <a:pt x="84" y="77"/>
                    <a:pt x="49" y="111"/>
                    <a:pt x="25" y="150"/>
                  </a:cubicBezTo>
                  <a:cubicBezTo>
                    <a:pt x="19" y="161"/>
                    <a:pt x="14" y="172"/>
                    <a:pt x="9" y="183"/>
                  </a:cubicBezTo>
                  <a:cubicBezTo>
                    <a:pt x="5" y="194"/>
                    <a:pt x="1" y="206"/>
                    <a:pt x="0" y="217"/>
                  </a:cubicBezTo>
                  <a:cubicBezTo>
                    <a:pt x="0" y="220"/>
                    <a:pt x="4" y="221"/>
                    <a:pt x="5" y="218"/>
                  </a:cubicBezTo>
                  <a:cubicBezTo>
                    <a:pt x="8" y="208"/>
                    <a:pt x="11" y="198"/>
                    <a:pt x="15" y="189"/>
                  </a:cubicBezTo>
                  <a:cubicBezTo>
                    <a:pt x="18" y="179"/>
                    <a:pt x="23" y="169"/>
                    <a:pt x="28" y="160"/>
                  </a:cubicBezTo>
                  <a:cubicBezTo>
                    <a:pt x="38" y="141"/>
                    <a:pt x="51" y="124"/>
                    <a:pt x="66" y="108"/>
                  </a:cubicBezTo>
                  <a:cubicBezTo>
                    <a:pt x="99" y="74"/>
                    <a:pt x="143" y="48"/>
                    <a:pt x="191" y="35"/>
                  </a:cubicBezTo>
                  <a:cubicBezTo>
                    <a:pt x="204" y="31"/>
                    <a:pt x="218" y="28"/>
                    <a:pt x="231" y="27"/>
                  </a:cubicBezTo>
                  <a:cubicBezTo>
                    <a:pt x="242" y="26"/>
                    <a:pt x="252" y="26"/>
                    <a:pt x="262" y="28"/>
                  </a:cubicBezTo>
                  <a:cubicBezTo>
                    <a:pt x="260" y="29"/>
                    <a:pt x="258" y="30"/>
                    <a:pt x="256" y="31"/>
                  </a:cubicBezTo>
                  <a:cubicBezTo>
                    <a:pt x="253" y="33"/>
                    <a:pt x="250" y="35"/>
                    <a:pt x="247" y="37"/>
                  </a:cubicBezTo>
                  <a:cubicBezTo>
                    <a:pt x="245" y="38"/>
                    <a:pt x="244" y="39"/>
                    <a:pt x="243" y="40"/>
                  </a:cubicBezTo>
                  <a:cubicBezTo>
                    <a:pt x="241" y="41"/>
                    <a:pt x="241" y="42"/>
                    <a:pt x="240" y="44"/>
                  </a:cubicBezTo>
                  <a:cubicBezTo>
                    <a:pt x="240" y="46"/>
                    <a:pt x="242" y="47"/>
                    <a:pt x="244" y="47"/>
                  </a:cubicBezTo>
                  <a:cubicBezTo>
                    <a:pt x="245" y="46"/>
                    <a:pt x="246" y="46"/>
                    <a:pt x="248" y="45"/>
                  </a:cubicBezTo>
                  <a:cubicBezTo>
                    <a:pt x="249" y="44"/>
                    <a:pt x="251" y="43"/>
                    <a:pt x="252" y="42"/>
                  </a:cubicBezTo>
                  <a:cubicBezTo>
                    <a:pt x="254" y="40"/>
                    <a:pt x="257" y="39"/>
                    <a:pt x="259" y="37"/>
                  </a:cubicBezTo>
                  <a:cubicBezTo>
                    <a:pt x="265" y="34"/>
                    <a:pt x="271" y="32"/>
                    <a:pt x="277" y="30"/>
                  </a:cubicBezTo>
                  <a:cubicBezTo>
                    <a:pt x="279" y="29"/>
                    <a:pt x="281" y="26"/>
                    <a:pt x="279" y="24"/>
                  </a:cubicBezTo>
                  <a:close/>
                </a:path>
              </a:pathLst>
            </a:custGeom>
            <a:solidFill>
              <a:schemeClr val="accent1"/>
            </a:solidFill>
            <a:ln w="63500">
              <a:solidFill>
                <a:schemeClr val="accent1"/>
              </a:solidFill>
              <a:round/>
              <a:headEnd/>
              <a:tailEnd/>
            </a:ln>
          </p:spPr>
          <p:txBody>
            <a:bodyPr vert="horz" wrap="square" lIns="69681" tIns="34840" rIns="69681" bIns="34840" numCol="1" anchor="t" anchorCtr="0" compatLnSpc="1">
              <a:prstTxWarp prst="textNoShape">
                <a:avLst/>
              </a:prstTxWarp>
            </a:bodyPr>
            <a:lstStyle/>
            <a:p>
              <a:pPr defTabSz="545434"/>
              <a:endParaRPr lang="ko-KR" altLang="en-US" sz="1074">
                <a:solidFill>
                  <a:prstClr val="black"/>
                </a:solidFill>
                <a:latin typeface="맑은 고딕" panose="020F0502020204030204"/>
                <a:ea typeface="맑은 고딕" panose="020B0503020000020004" pitchFamily="50" charset="-127"/>
              </a:endParaRPr>
            </a:p>
          </p:txBody>
        </p:sp>
        <p:sp>
          <p:nvSpPr>
            <p:cNvPr id="129" name="Freeform 5">
              <a:extLst>
                <a:ext uri="{FF2B5EF4-FFF2-40B4-BE49-F238E27FC236}">
                  <a16:creationId xmlns:a16="http://schemas.microsoft.com/office/drawing/2014/main" id="{388CA60C-11F8-49CE-9D4F-F8E43B347907}"/>
                </a:ext>
              </a:extLst>
            </p:cNvPr>
            <p:cNvSpPr>
              <a:spLocks/>
            </p:cNvSpPr>
            <p:nvPr/>
          </p:nvSpPr>
          <p:spPr bwMode="auto">
            <a:xfrm rot="16200000" flipH="1">
              <a:off x="5523500" y="1910948"/>
              <a:ext cx="944968" cy="1201232"/>
            </a:xfrm>
            <a:custGeom>
              <a:avLst/>
              <a:gdLst>
                <a:gd name="T0" fmla="*/ 279 w 281"/>
                <a:gd name="T1" fmla="*/ 24 h 221"/>
                <a:gd name="T2" fmla="*/ 263 w 281"/>
                <a:gd name="T3" fmla="*/ 12 h 221"/>
                <a:gd name="T4" fmla="*/ 255 w 281"/>
                <a:gd name="T5" fmla="*/ 6 h 221"/>
                <a:gd name="T6" fmla="*/ 245 w 281"/>
                <a:gd name="T7" fmla="*/ 0 h 221"/>
                <a:gd name="T8" fmla="*/ 242 w 281"/>
                <a:gd name="T9" fmla="*/ 3 h 221"/>
                <a:gd name="T10" fmla="*/ 249 w 281"/>
                <a:gd name="T11" fmla="*/ 10 h 221"/>
                <a:gd name="T12" fmla="*/ 258 w 281"/>
                <a:gd name="T13" fmla="*/ 16 h 221"/>
                <a:gd name="T14" fmla="*/ 264 w 281"/>
                <a:gd name="T15" fmla="*/ 21 h 221"/>
                <a:gd name="T16" fmla="*/ 237 w 281"/>
                <a:gd name="T17" fmla="*/ 20 h 221"/>
                <a:gd name="T18" fmla="*/ 199 w 281"/>
                <a:gd name="T19" fmla="*/ 26 h 221"/>
                <a:gd name="T20" fmla="*/ 127 w 281"/>
                <a:gd name="T21" fmla="*/ 54 h 221"/>
                <a:gd name="T22" fmla="*/ 25 w 281"/>
                <a:gd name="T23" fmla="*/ 150 h 221"/>
                <a:gd name="T24" fmla="*/ 9 w 281"/>
                <a:gd name="T25" fmla="*/ 183 h 221"/>
                <a:gd name="T26" fmla="*/ 0 w 281"/>
                <a:gd name="T27" fmla="*/ 217 h 221"/>
                <a:gd name="T28" fmla="*/ 5 w 281"/>
                <a:gd name="T29" fmla="*/ 218 h 221"/>
                <a:gd name="T30" fmla="*/ 15 w 281"/>
                <a:gd name="T31" fmla="*/ 189 h 221"/>
                <a:gd name="T32" fmla="*/ 28 w 281"/>
                <a:gd name="T33" fmla="*/ 160 h 221"/>
                <a:gd name="T34" fmla="*/ 66 w 281"/>
                <a:gd name="T35" fmla="*/ 108 h 221"/>
                <a:gd name="T36" fmla="*/ 191 w 281"/>
                <a:gd name="T37" fmla="*/ 35 h 221"/>
                <a:gd name="T38" fmla="*/ 231 w 281"/>
                <a:gd name="T39" fmla="*/ 27 h 221"/>
                <a:gd name="T40" fmla="*/ 262 w 281"/>
                <a:gd name="T41" fmla="*/ 28 h 221"/>
                <a:gd name="T42" fmla="*/ 256 w 281"/>
                <a:gd name="T43" fmla="*/ 31 h 221"/>
                <a:gd name="T44" fmla="*/ 247 w 281"/>
                <a:gd name="T45" fmla="*/ 37 h 221"/>
                <a:gd name="T46" fmla="*/ 243 w 281"/>
                <a:gd name="T47" fmla="*/ 40 h 221"/>
                <a:gd name="T48" fmla="*/ 240 w 281"/>
                <a:gd name="T49" fmla="*/ 44 h 221"/>
                <a:gd name="T50" fmla="*/ 244 w 281"/>
                <a:gd name="T51" fmla="*/ 47 h 221"/>
                <a:gd name="T52" fmla="*/ 248 w 281"/>
                <a:gd name="T53" fmla="*/ 45 h 221"/>
                <a:gd name="T54" fmla="*/ 252 w 281"/>
                <a:gd name="T55" fmla="*/ 42 h 221"/>
                <a:gd name="T56" fmla="*/ 259 w 281"/>
                <a:gd name="T57" fmla="*/ 37 h 221"/>
                <a:gd name="T58" fmla="*/ 277 w 281"/>
                <a:gd name="T59" fmla="*/ 30 h 221"/>
                <a:gd name="T60" fmla="*/ 279 w 281"/>
                <a:gd name="T61" fmla="*/ 24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281" h="221">
                  <a:moveTo>
                    <a:pt x="279" y="24"/>
                  </a:moveTo>
                  <a:cubicBezTo>
                    <a:pt x="275" y="19"/>
                    <a:pt x="269" y="15"/>
                    <a:pt x="263" y="12"/>
                  </a:cubicBezTo>
                  <a:cubicBezTo>
                    <a:pt x="255" y="6"/>
                    <a:pt x="255" y="6"/>
                    <a:pt x="255" y="6"/>
                  </a:cubicBezTo>
                  <a:cubicBezTo>
                    <a:pt x="252" y="4"/>
                    <a:pt x="249" y="1"/>
                    <a:pt x="245" y="0"/>
                  </a:cubicBezTo>
                  <a:cubicBezTo>
                    <a:pt x="243" y="0"/>
                    <a:pt x="241" y="2"/>
                    <a:pt x="242" y="3"/>
                  </a:cubicBezTo>
                  <a:cubicBezTo>
                    <a:pt x="244" y="6"/>
                    <a:pt x="247" y="8"/>
                    <a:pt x="249" y="10"/>
                  </a:cubicBezTo>
                  <a:cubicBezTo>
                    <a:pt x="252" y="12"/>
                    <a:pt x="255" y="14"/>
                    <a:pt x="258" y="16"/>
                  </a:cubicBezTo>
                  <a:cubicBezTo>
                    <a:pt x="260" y="18"/>
                    <a:pt x="262" y="20"/>
                    <a:pt x="264" y="21"/>
                  </a:cubicBezTo>
                  <a:cubicBezTo>
                    <a:pt x="256" y="19"/>
                    <a:pt x="246" y="19"/>
                    <a:pt x="237" y="20"/>
                  </a:cubicBezTo>
                  <a:cubicBezTo>
                    <a:pt x="225" y="21"/>
                    <a:pt x="212" y="23"/>
                    <a:pt x="199" y="26"/>
                  </a:cubicBezTo>
                  <a:cubicBezTo>
                    <a:pt x="174" y="32"/>
                    <a:pt x="150" y="41"/>
                    <a:pt x="127" y="54"/>
                  </a:cubicBezTo>
                  <a:cubicBezTo>
                    <a:pt x="84" y="77"/>
                    <a:pt x="49" y="111"/>
                    <a:pt x="25" y="150"/>
                  </a:cubicBezTo>
                  <a:cubicBezTo>
                    <a:pt x="19" y="161"/>
                    <a:pt x="14" y="172"/>
                    <a:pt x="9" y="183"/>
                  </a:cubicBezTo>
                  <a:cubicBezTo>
                    <a:pt x="5" y="194"/>
                    <a:pt x="1" y="206"/>
                    <a:pt x="0" y="217"/>
                  </a:cubicBezTo>
                  <a:cubicBezTo>
                    <a:pt x="0" y="220"/>
                    <a:pt x="4" y="221"/>
                    <a:pt x="5" y="218"/>
                  </a:cubicBezTo>
                  <a:cubicBezTo>
                    <a:pt x="8" y="208"/>
                    <a:pt x="11" y="198"/>
                    <a:pt x="15" y="189"/>
                  </a:cubicBezTo>
                  <a:cubicBezTo>
                    <a:pt x="18" y="179"/>
                    <a:pt x="23" y="169"/>
                    <a:pt x="28" y="160"/>
                  </a:cubicBezTo>
                  <a:cubicBezTo>
                    <a:pt x="38" y="141"/>
                    <a:pt x="51" y="124"/>
                    <a:pt x="66" y="108"/>
                  </a:cubicBezTo>
                  <a:cubicBezTo>
                    <a:pt x="99" y="74"/>
                    <a:pt x="143" y="48"/>
                    <a:pt x="191" y="35"/>
                  </a:cubicBezTo>
                  <a:cubicBezTo>
                    <a:pt x="204" y="31"/>
                    <a:pt x="218" y="28"/>
                    <a:pt x="231" y="27"/>
                  </a:cubicBezTo>
                  <a:cubicBezTo>
                    <a:pt x="242" y="26"/>
                    <a:pt x="252" y="26"/>
                    <a:pt x="262" y="28"/>
                  </a:cubicBezTo>
                  <a:cubicBezTo>
                    <a:pt x="260" y="29"/>
                    <a:pt x="258" y="30"/>
                    <a:pt x="256" y="31"/>
                  </a:cubicBezTo>
                  <a:cubicBezTo>
                    <a:pt x="253" y="33"/>
                    <a:pt x="250" y="35"/>
                    <a:pt x="247" y="37"/>
                  </a:cubicBezTo>
                  <a:cubicBezTo>
                    <a:pt x="245" y="38"/>
                    <a:pt x="244" y="39"/>
                    <a:pt x="243" y="40"/>
                  </a:cubicBezTo>
                  <a:cubicBezTo>
                    <a:pt x="241" y="41"/>
                    <a:pt x="241" y="42"/>
                    <a:pt x="240" y="44"/>
                  </a:cubicBezTo>
                  <a:cubicBezTo>
                    <a:pt x="240" y="46"/>
                    <a:pt x="242" y="47"/>
                    <a:pt x="244" y="47"/>
                  </a:cubicBezTo>
                  <a:cubicBezTo>
                    <a:pt x="245" y="46"/>
                    <a:pt x="246" y="46"/>
                    <a:pt x="248" y="45"/>
                  </a:cubicBezTo>
                  <a:cubicBezTo>
                    <a:pt x="249" y="44"/>
                    <a:pt x="251" y="43"/>
                    <a:pt x="252" y="42"/>
                  </a:cubicBezTo>
                  <a:cubicBezTo>
                    <a:pt x="254" y="40"/>
                    <a:pt x="257" y="39"/>
                    <a:pt x="259" y="37"/>
                  </a:cubicBezTo>
                  <a:cubicBezTo>
                    <a:pt x="265" y="34"/>
                    <a:pt x="271" y="32"/>
                    <a:pt x="277" y="30"/>
                  </a:cubicBezTo>
                  <a:cubicBezTo>
                    <a:pt x="279" y="29"/>
                    <a:pt x="281" y="26"/>
                    <a:pt x="279" y="24"/>
                  </a:cubicBezTo>
                  <a:close/>
                </a:path>
              </a:pathLst>
            </a:custGeom>
            <a:solidFill>
              <a:schemeClr val="accent5"/>
            </a:solidFill>
            <a:ln w="9525">
              <a:solidFill>
                <a:schemeClr val="accent5"/>
              </a:solidFill>
              <a:round/>
              <a:headEnd/>
              <a:tailEnd/>
            </a:ln>
          </p:spPr>
          <p:txBody>
            <a:bodyPr vert="horz" wrap="square" lIns="69681" tIns="34840" rIns="69681" bIns="34840" numCol="1" anchor="t" anchorCtr="0" compatLnSpc="1">
              <a:prstTxWarp prst="textNoShape">
                <a:avLst/>
              </a:prstTxWarp>
            </a:bodyPr>
            <a:lstStyle/>
            <a:p>
              <a:pPr defTabSz="545434"/>
              <a:endParaRPr lang="ko-KR" altLang="en-US" sz="1074" dirty="0">
                <a:solidFill>
                  <a:prstClr val="black"/>
                </a:solidFill>
                <a:latin typeface="맑은 고딕" panose="020F0502020204030204"/>
                <a:ea typeface="맑은 고딕" panose="020B0503020000020004" pitchFamily="50" charset="-127"/>
              </a:endParaRPr>
            </a:p>
          </p:txBody>
        </p:sp>
        <p:sp>
          <p:nvSpPr>
            <p:cNvPr id="130" name="Freeform 5">
              <a:extLst>
                <a:ext uri="{FF2B5EF4-FFF2-40B4-BE49-F238E27FC236}">
                  <a16:creationId xmlns:a16="http://schemas.microsoft.com/office/drawing/2014/main" id="{47E1223B-2673-4729-A117-F2448AF9F5DD}"/>
                </a:ext>
              </a:extLst>
            </p:cNvPr>
            <p:cNvSpPr>
              <a:spLocks/>
            </p:cNvSpPr>
            <p:nvPr/>
          </p:nvSpPr>
          <p:spPr bwMode="auto">
            <a:xfrm rot="5400000">
              <a:off x="7585358" y="1910950"/>
              <a:ext cx="944968" cy="1201232"/>
            </a:xfrm>
            <a:custGeom>
              <a:avLst/>
              <a:gdLst>
                <a:gd name="T0" fmla="*/ 279 w 281"/>
                <a:gd name="T1" fmla="*/ 24 h 221"/>
                <a:gd name="T2" fmla="*/ 263 w 281"/>
                <a:gd name="T3" fmla="*/ 12 h 221"/>
                <a:gd name="T4" fmla="*/ 255 w 281"/>
                <a:gd name="T5" fmla="*/ 6 h 221"/>
                <a:gd name="T6" fmla="*/ 245 w 281"/>
                <a:gd name="T7" fmla="*/ 0 h 221"/>
                <a:gd name="T8" fmla="*/ 242 w 281"/>
                <a:gd name="T9" fmla="*/ 3 h 221"/>
                <a:gd name="T10" fmla="*/ 249 w 281"/>
                <a:gd name="T11" fmla="*/ 10 h 221"/>
                <a:gd name="T12" fmla="*/ 258 w 281"/>
                <a:gd name="T13" fmla="*/ 16 h 221"/>
                <a:gd name="T14" fmla="*/ 264 w 281"/>
                <a:gd name="T15" fmla="*/ 21 h 221"/>
                <a:gd name="T16" fmla="*/ 237 w 281"/>
                <a:gd name="T17" fmla="*/ 20 h 221"/>
                <a:gd name="T18" fmla="*/ 199 w 281"/>
                <a:gd name="T19" fmla="*/ 26 h 221"/>
                <a:gd name="T20" fmla="*/ 127 w 281"/>
                <a:gd name="T21" fmla="*/ 54 h 221"/>
                <a:gd name="T22" fmla="*/ 25 w 281"/>
                <a:gd name="T23" fmla="*/ 150 h 221"/>
                <a:gd name="T24" fmla="*/ 9 w 281"/>
                <a:gd name="T25" fmla="*/ 183 h 221"/>
                <a:gd name="T26" fmla="*/ 0 w 281"/>
                <a:gd name="T27" fmla="*/ 217 h 221"/>
                <a:gd name="T28" fmla="*/ 5 w 281"/>
                <a:gd name="T29" fmla="*/ 218 h 221"/>
                <a:gd name="T30" fmla="*/ 15 w 281"/>
                <a:gd name="T31" fmla="*/ 189 h 221"/>
                <a:gd name="T32" fmla="*/ 28 w 281"/>
                <a:gd name="T33" fmla="*/ 160 h 221"/>
                <a:gd name="T34" fmla="*/ 66 w 281"/>
                <a:gd name="T35" fmla="*/ 108 h 221"/>
                <a:gd name="T36" fmla="*/ 191 w 281"/>
                <a:gd name="T37" fmla="*/ 35 h 221"/>
                <a:gd name="T38" fmla="*/ 231 w 281"/>
                <a:gd name="T39" fmla="*/ 27 h 221"/>
                <a:gd name="T40" fmla="*/ 262 w 281"/>
                <a:gd name="T41" fmla="*/ 28 h 221"/>
                <a:gd name="T42" fmla="*/ 256 w 281"/>
                <a:gd name="T43" fmla="*/ 31 h 221"/>
                <a:gd name="T44" fmla="*/ 247 w 281"/>
                <a:gd name="T45" fmla="*/ 37 h 221"/>
                <a:gd name="T46" fmla="*/ 243 w 281"/>
                <a:gd name="T47" fmla="*/ 40 h 221"/>
                <a:gd name="T48" fmla="*/ 240 w 281"/>
                <a:gd name="T49" fmla="*/ 44 h 221"/>
                <a:gd name="T50" fmla="*/ 244 w 281"/>
                <a:gd name="T51" fmla="*/ 47 h 221"/>
                <a:gd name="T52" fmla="*/ 248 w 281"/>
                <a:gd name="T53" fmla="*/ 45 h 221"/>
                <a:gd name="T54" fmla="*/ 252 w 281"/>
                <a:gd name="T55" fmla="*/ 42 h 221"/>
                <a:gd name="T56" fmla="*/ 259 w 281"/>
                <a:gd name="T57" fmla="*/ 37 h 221"/>
                <a:gd name="T58" fmla="*/ 277 w 281"/>
                <a:gd name="T59" fmla="*/ 30 h 221"/>
                <a:gd name="T60" fmla="*/ 279 w 281"/>
                <a:gd name="T61" fmla="*/ 24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281" h="221">
                  <a:moveTo>
                    <a:pt x="279" y="24"/>
                  </a:moveTo>
                  <a:cubicBezTo>
                    <a:pt x="275" y="19"/>
                    <a:pt x="269" y="15"/>
                    <a:pt x="263" y="12"/>
                  </a:cubicBezTo>
                  <a:cubicBezTo>
                    <a:pt x="255" y="6"/>
                    <a:pt x="255" y="6"/>
                    <a:pt x="255" y="6"/>
                  </a:cubicBezTo>
                  <a:cubicBezTo>
                    <a:pt x="252" y="4"/>
                    <a:pt x="249" y="1"/>
                    <a:pt x="245" y="0"/>
                  </a:cubicBezTo>
                  <a:cubicBezTo>
                    <a:pt x="243" y="0"/>
                    <a:pt x="241" y="2"/>
                    <a:pt x="242" y="3"/>
                  </a:cubicBezTo>
                  <a:cubicBezTo>
                    <a:pt x="244" y="6"/>
                    <a:pt x="247" y="8"/>
                    <a:pt x="249" y="10"/>
                  </a:cubicBezTo>
                  <a:cubicBezTo>
                    <a:pt x="252" y="12"/>
                    <a:pt x="255" y="14"/>
                    <a:pt x="258" y="16"/>
                  </a:cubicBezTo>
                  <a:cubicBezTo>
                    <a:pt x="260" y="18"/>
                    <a:pt x="262" y="20"/>
                    <a:pt x="264" y="21"/>
                  </a:cubicBezTo>
                  <a:cubicBezTo>
                    <a:pt x="256" y="19"/>
                    <a:pt x="246" y="19"/>
                    <a:pt x="237" y="20"/>
                  </a:cubicBezTo>
                  <a:cubicBezTo>
                    <a:pt x="225" y="21"/>
                    <a:pt x="212" y="23"/>
                    <a:pt x="199" y="26"/>
                  </a:cubicBezTo>
                  <a:cubicBezTo>
                    <a:pt x="174" y="32"/>
                    <a:pt x="150" y="41"/>
                    <a:pt x="127" y="54"/>
                  </a:cubicBezTo>
                  <a:cubicBezTo>
                    <a:pt x="84" y="77"/>
                    <a:pt x="49" y="111"/>
                    <a:pt x="25" y="150"/>
                  </a:cubicBezTo>
                  <a:cubicBezTo>
                    <a:pt x="19" y="161"/>
                    <a:pt x="14" y="172"/>
                    <a:pt x="9" y="183"/>
                  </a:cubicBezTo>
                  <a:cubicBezTo>
                    <a:pt x="5" y="194"/>
                    <a:pt x="1" y="206"/>
                    <a:pt x="0" y="217"/>
                  </a:cubicBezTo>
                  <a:cubicBezTo>
                    <a:pt x="0" y="220"/>
                    <a:pt x="4" y="221"/>
                    <a:pt x="5" y="218"/>
                  </a:cubicBezTo>
                  <a:cubicBezTo>
                    <a:pt x="8" y="208"/>
                    <a:pt x="11" y="198"/>
                    <a:pt x="15" y="189"/>
                  </a:cubicBezTo>
                  <a:cubicBezTo>
                    <a:pt x="18" y="179"/>
                    <a:pt x="23" y="169"/>
                    <a:pt x="28" y="160"/>
                  </a:cubicBezTo>
                  <a:cubicBezTo>
                    <a:pt x="38" y="141"/>
                    <a:pt x="51" y="124"/>
                    <a:pt x="66" y="108"/>
                  </a:cubicBezTo>
                  <a:cubicBezTo>
                    <a:pt x="99" y="74"/>
                    <a:pt x="143" y="48"/>
                    <a:pt x="191" y="35"/>
                  </a:cubicBezTo>
                  <a:cubicBezTo>
                    <a:pt x="204" y="31"/>
                    <a:pt x="218" y="28"/>
                    <a:pt x="231" y="27"/>
                  </a:cubicBezTo>
                  <a:cubicBezTo>
                    <a:pt x="242" y="26"/>
                    <a:pt x="252" y="26"/>
                    <a:pt x="262" y="28"/>
                  </a:cubicBezTo>
                  <a:cubicBezTo>
                    <a:pt x="260" y="29"/>
                    <a:pt x="258" y="30"/>
                    <a:pt x="256" y="31"/>
                  </a:cubicBezTo>
                  <a:cubicBezTo>
                    <a:pt x="253" y="33"/>
                    <a:pt x="250" y="35"/>
                    <a:pt x="247" y="37"/>
                  </a:cubicBezTo>
                  <a:cubicBezTo>
                    <a:pt x="245" y="38"/>
                    <a:pt x="244" y="39"/>
                    <a:pt x="243" y="40"/>
                  </a:cubicBezTo>
                  <a:cubicBezTo>
                    <a:pt x="241" y="41"/>
                    <a:pt x="241" y="42"/>
                    <a:pt x="240" y="44"/>
                  </a:cubicBezTo>
                  <a:cubicBezTo>
                    <a:pt x="240" y="46"/>
                    <a:pt x="242" y="47"/>
                    <a:pt x="244" y="47"/>
                  </a:cubicBezTo>
                  <a:cubicBezTo>
                    <a:pt x="245" y="46"/>
                    <a:pt x="246" y="46"/>
                    <a:pt x="248" y="45"/>
                  </a:cubicBezTo>
                  <a:cubicBezTo>
                    <a:pt x="249" y="44"/>
                    <a:pt x="251" y="43"/>
                    <a:pt x="252" y="42"/>
                  </a:cubicBezTo>
                  <a:cubicBezTo>
                    <a:pt x="254" y="40"/>
                    <a:pt x="257" y="39"/>
                    <a:pt x="259" y="37"/>
                  </a:cubicBezTo>
                  <a:cubicBezTo>
                    <a:pt x="265" y="34"/>
                    <a:pt x="271" y="32"/>
                    <a:pt x="277" y="30"/>
                  </a:cubicBezTo>
                  <a:cubicBezTo>
                    <a:pt x="279" y="29"/>
                    <a:pt x="281" y="26"/>
                    <a:pt x="279" y="24"/>
                  </a:cubicBezTo>
                  <a:close/>
                </a:path>
              </a:pathLst>
            </a:custGeom>
            <a:solidFill>
              <a:schemeClr val="accent5"/>
            </a:solidFill>
            <a:ln w="9525">
              <a:solidFill>
                <a:schemeClr val="accent5"/>
              </a:solidFill>
              <a:round/>
              <a:headEnd/>
              <a:tailEnd/>
            </a:ln>
          </p:spPr>
          <p:txBody>
            <a:bodyPr vert="horz" wrap="square" lIns="69681" tIns="34840" rIns="69681" bIns="34840" numCol="1" anchor="t" anchorCtr="0" compatLnSpc="1">
              <a:prstTxWarp prst="textNoShape">
                <a:avLst/>
              </a:prstTxWarp>
            </a:bodyPr>
            <a:lstStyle/>
            <a:p>
              <a:pPr defTabSz="545434"/>
              <a:endParaRPr lang="ko-KR" altLang="en-US" sz="1074" dirty="0">
                <a:solidFill>
                  <a:prstClr val="black"/>
                </a:solidFill>
                <a:latin typeface="맑은 고딕" panose="020F0502020204030204"/>
                <a:ea typeface="맑은 고딕" panose="020B0503020000020004" pitchFamily="50" charset="-127"/>
              </a:endParaRPr>
            </a:p>
          </p:txBody>
        </p:sp>
        <p:sp>
          <p:nvSpPr>
            <p:cNvPr id="131" name="Freeform 5">
              <a:extLst>
                <a:ext uri="{FF2B5EF4-FFF2-40B4-BE49-F238E27FC236}">
                  <a16:creationId xmlns:a16="http://schemas.microsoft.com/office/drawing/2014/main" id="{1579EF47-4A95-458F-AFBD-D69FFD560E5D}"/>
                </a:ext>
              </a:extLst>
            </p:cNvPr>
            <p:cNvSpPr>
              <a:spLocks/>
            </p:cNvSpPr>
            <p:nvPr/>
          </p:nvSpPr>
          <p:spPr bwMode="auto">
            <a:xfrm rot="16200000" flipH="1">
              <a:off x="3853209" y="1901217"/>
              <a:ext cx="913186" cy="1160831"/>
            </a:xfrm>
            <a:custGeom>
              <a:avLst/>
              <a:gdLst>
                <a:gd name="T0" fmla="*/ 279 w 281"/>
                <a:gd name="T1" fmla="*/ 24 h 221"/>
                <a:gd name="T2" fmla="*/ 263 w 281"/>
                <a:gd name="T3" fmla="*/ 12 h 221"/>
                <a:gd name="T4" fmla="*/ 255 w 281"/>
                <a:gd name="T5" fmla="*/ 6 h 221"/>
                <a:gd name="T6" fmla="*/ 245 w 281"/>
                <a:gd name="T7" fmla="*/ 0 h 221"/>
                <a:gd name="T8" fmla="*/ 242 w 281"/>
                <a:gd name="T9" fmla="*/ 3 h 221"/>
                <a:gd name="T10" fmla="*/ 249 w 281"/>
                <a:gd name="T11" fmla="*/ 10 h 221"/>
                <a:gd name="T12" fmla="*/ 258 w 281"/>
                <a:gd name="T13" fmla="*/ 16 h 221"/>
                <a:gd name="T14" fmla="*/ 264 w 281"/>
                <a:gd name="T15" fmla="*/ 21 h 221"/>
                <a:gd name="T16" fmla="*/ 237 w 281"/>
                <a:gd name="T17" fmla="*/ 20 h 221"/>
                <a:gd name="T18" fmla="*/ 199 w 281"/>
                <a:gd name="T19" fmla="*/ 26 h 221"/>
                <a:gd name="T20" fmla="*/ 127 w 281"/>
                <a:gd name="T21" fmla="*/ 54 h 221"/>
                <a:gd name="T22" fmla="*/ 25 w 281"/>
                <a:gd name="T23" fmla="*/ 150 h 221"/>
                <a:gd name="T24" fmla="*/ 9 w 281"/>
                <a:gd name="T25" fmla="*/ 183 h 221"/>
                <a:gd name="T26" fmla="*/ 0 w 281"/>
                <a:gd name="T27" fmla="*/ 217 h 221"/>
                <a:gd name="T28" fmla="*/ 5 w 281"/>
                <a:gd name="T29" fmla="*/ 218 h 221"/>
                <a:gd name="T30" fmla="*/ 15 w 281"/>
                <a:gd name="T31" fmla="*/ 189 h 221"/>
                <a:gd name="T32" fmla="*/ 28 w 281"/>
                <a:gd name="T33" fmla="*/ 160 h 221"/>
                <a:gd name="T34" fmla="*/ 66 w 281"/>
                <a:gd name="T35" fmla="*/ 108 h 221"/>
                <a:gd name="T36" fmla="*/ 191 w 281"/>
                <a:gd name="T37" fmla="*/ 35 h 221"/>
                <a:gd name="T38" fmla="*/ 231 w 281"/>
                <a:gd name="T39" fmla="*/ 27 h 221"/>
                <a:gd name="T40" fmla="*/ 262 w 281"/>
                <a:gd name="T41" fmla="*/ 28 h 221"/>
                <a:gd name="T42" fmla="*/ 256 w 281"/>
                <a:gd name="T43" fmla="*/ 31 h 221"/>
                <a:gd name="T44" fmla="*/ 247 w 281"/>
                <a:gd name="T45" fmla="*/ 37 h 221"/>
                <a:gd name="T46" fmla="*/ 243 w 281"/>
                <a:gd name="T47" fmla="*/ 40 h 221"/>
                <a:gd name="T48" fmla="*/ 240 w 281"/>
                <a:gd name="T49" fmla="*/ 44 h 221"/>
                <a:gd name="T50" fmla="*/ 244 w 281"/>
                <a:gd name="T51" fmla="*/ 47 h 221"/>
                <a:gd name="T52" fmla="*/ 248 w 281"/>
                <a:gd name="T53" fmla="*/ 45 h 221"/>
                <a:gd name="T54" fmla="*/ 252 w 281"/>
                <a:gd name="T55" fmla="*/ 42 h 221"/>
                <a:gd name="T56" fmla="*/ 259 w 281"/>
                <a:gd name="T57" fmla="*/ 37 h 221"/>
                <a:gd name="T58" fmla="*/ 277 w 281"/>
                <a:gd name="T59" fmla="*/ 30 h 221"/>
                <a:gd name="T60" fmla="*/ 279 w 281"/>
                <a:gd name="T61" fmla="*/ 24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281" h="221">
                  <a:moveTo>
                    <a:pt x="279" y="24"/>
                  </a:moveTo>
                  <a:cubicBezTo>
                    <a:pt x="275" y="19"/>
                    <a:pt x="269" y="15"/>
                    <a:pt x="263" y="12"/>
                  </a:cubicBezTo>
                  <a:cubicBezTo>
                    <a:pt x="255" y="6"/>
                    <a:pt x="255" y="6"/>
                    <a:pt x="255" y="6"/>
                  </a:cubicBezTo>
                  <a:cubicBezTo>
                    <a:pt x="252" y="4"/>
                    <a:pt x="249" y="1"/>
                    <a:pt x="245" y="0"/>
                  </a:cubicBezTo>
                  <a:cubicBezTo>
                    <a:pt x="243" y="0"/>
                    <a:pt x="241" y="2"/>
                    <a:pt x="242" y="3"/>
                  </a:cubicBezTo>
                  <a:cubicBezTo>
                    <a:pt x="244" y="6"/>
                    <a:pt x="247" y="8"/>
                    <a:pt x="249" y="10"/>
                  </a:cubicBezTo>
                  <a:cubicBezTo>
                    <a:pt x="252" y="12"/>
                    <a:pt x="255" y="14"/>
                    <a:pt x="258" y="16"/>
                  </a:cubicBezTo>
                  <a:cubicBezTo>
                    <a:pt x="260" y="18"/>
                    <a:pt x="262" y="20"/>
                    <a:pt x="264" y="21"/>
                  </a:cubicBezTo>
                  <a:cubicBezTo>
                    <a:pt x="256" y="19"/>
                    <a:pt x="246" y="19"/>
                    <a:pt x="237" y="20"/>
                  </a:cubicBezTo>
                  <a:cubicBezTo>
                    <a:pt x="225" y="21"/>
                    <a:pt x="212" y="23"/>
                    <a:pt x="199" y="26"/>
                  </a:cubicBezTo>
                  <a:cubicBezTo>
                    <a:pt x="174" y="32"/>
                    <a:pt x="150" y="41"/>
                    <a:pt x="127" y="54"/>
                  </a:cubicBezTo>
                  <a:cubicBezTo>
                    <a:pt x="84" y="77"/>
                    <a:pt x="49" y="111"/>
                    <a:pt x="25" y="150"/>
                  </a:cubicBezTo>
                  <a:cubicBezTo>
                    <a:pt x="19" y="161"/>
                    <a:pt x="14" y="172"/>
                    <a:pt x="9" y="183"/>
                  </a:cubicBezTo>
                  <a:cubicBezTo>
                    <a:pt x="5" y="194"/>
                    <a:pt x="1" y="206"/>
                    <a:pt x="0" y="217"/>
                  </a:cubicBezTo>
                  <a:cubicBezTo>
                    <a:pt x="0" y="220"/>
                    <a:pt x="4" y="221"/>
                    <a:pt x="5" y="218"/>
                  </a:cubicBezTo>
                  <a:cubicBezTo>
                    <a:pt x="8" y="208"/>
                    <a:pt x="11" y="198"/>
                    <a:pt x="15" y="189"/>
                  </a:cubicBezTo>
                  <a:cubicBezTo>
                    <a:pt x="18" y="179"/>
                    <a:pt x="23" y="169"/>
                    <a:pt x="28" y="160"/>
                  </a:cubicBezTo>
                  <a:cubicBezTo>
                    <a:pt x="38" y="141"/>
                    <a:pt x="51" y="124"/>
                    <a:pt x="66" y="108"/>
                  </a:cubicBezTo>
                  <a:cubicBezTo>
                    <a:pt x="99" y="74"/>
                    <a:pt x="143" y="48"/>
                    <a:pt x="191" y="35"/>
                  </a:cubicBezTo>
                  <a:cubicBezTo>
                    <a:pt x="204" y="31"/>
                    <a:pt x="218" y="28"/>
                    <a:pt x="231" y="27"/>
                  </a:cubicBezTo>
                  <a:cubicBezTo>
                    <a:pt x="242" y="26"/>
                    <a:pt x="252" y="26"/>
                    <a:pt x="262" y="28"/>
                  </a:cubicBezTo>
                  <a:cubicBezTo>
                    <a:pt x="260" y="29"/>
                    <a:pt x="258" y="30"/>
                    <a:pt x="256" y="31"/>
                  </a:cubicBezTo>
                  <a:cubicBezTo>
                    <a:pt x="253" y="33"/>
                    <a:pt x="250" y="35"/>
                    <a:pt x="247" y="37"/>
                  </a:cubicBezTo>
                  <a:cubicBezTo>
                    <a:pt x="245" y="38"/>
                    <a:pt x="244" y="39"/>
                    <a:pt x="243" y="40"/>
                  </a:cubicBezTo>
                  <a:cubicBezTo>
                    <a:pt x="241" y="41"/>
                    <a:pt x="241" y="42"/>
                    <a:pt x="240" y="44"/>
                  </a:cubicBezTo>
                  <a:cubicBezTo>
                    <a:pt x="240" y="46"/>
                    <a:pt x="242" y="47"/>
                    <a:pt x="244" y="47"/>
                  </a:cubicBezTo>
                  <a:cubicBezTo>
                    <a:pt x="245" y="46"/>
                    <a:pt x="246" y="46"/>
                    <a:pt x="248" y="45"/>
                  </a:cubicBezTo>
                  <a:cubicBezTo>
                    <a:pt x="249" y="44"/>
                    <a:pt x="251" y="43"/>
                    <a:pt x="252" y="42"/>
                  </a:cubicBezTo>
                  <a:cubicBezTo>
                    <a:pt x="254" y="40"/>
                    <a:pt x="257" y="39"/>
                    <a:pt x="259" y="37"/>
                  </a:cubicBezTo>
                  <a:cubicBezTo>
                    <a:pt x="265" y="34"/>
                    <a:pt x="271" y="32"/>
                    <a:pt x="277" y="30"/>
                  </a:cubicBezTo>
                  <a:cubicBezTo>
                    <a:pt x="279" y="29"/>
                    <a:pt x="281" y="26"/>
                    <a:pt x="279" y="24"/>
                  </a:cubicBezTo>
                  <a:close/>
                </a:path>
              </a:pathLst>
            </a:custGeom>
            <a:solidFill>
              <a:schemeClr val="accent1"/>
            </a:solidFill>
            <a:ln w="63500">
              <a:solidFill>
                <a:schemeClr val="accent1"/>
              </a:solidFill>
              <a:round/>
              <a:headEnd/>
              <a:tailEnd/>
            </a:ln>
          </p:spPr>
          <p:txBody>
            <a:bodyPr vert="horz" wrap="square" lIns="69681" tIns="34840" rIns="69681" bIns="34840" numCol="1" anchor="t" anchorCtr="0" compatLnSpc="1">
              <a:prstTxWarp prst="textNoShape">
                <a:avLst/>
              </a:prstTxWarp>
            </a:bodyPr>
            <a:lstStyle/>
            <a:p>
              <a:pPr defTabSz="545434"/>
              <a:endParaRPr lang="ko-KR" altLang="en-US" sz="1074">
                <a:solidFill>
                  <a:prstClr val="black"/>
                </a:solidFill>
                <a:latin typeface="맑은 고딕" panose="020F0502020204030204"/>
                <a:ea typeface="맑은 고딕" panose="020B0503020000020004" pitchFamily="50" charset="-127"/>
              </a:endParaRPr>
            </a:p>
          </p:txBody>
        </p:sp>
        <p:grpSp>
          <p:nvGrpSpPr>
            <p:cNvPr id="53" name="그룹 52">
              <a:extLst>
                <a:ext uri="{FF2B5EF4-FFF2-40B4-BE49-F238E27FC236}">
                  <a16:creationId xmlns:a16="http://schemas.microsoft.com/office/drawing/2014/main" id="{009E33BD-F0BC-4B4A-804F-69F50D9C6A3C}"/>
                </a:ext>
              </a:extLst>
            </p:cNvPr>
            <p:cNvGrpSpPr/>
            <p:nvPr/>
          </p:nvGrpSpPr>
          <p:grpSpPr>
            <a:xfrm>
              <a:off x="4428190" y="669297"/>
              <a:ext cx="3525692" cy="1754338"/>
              <a:chOff x="2311155" y="878298"/>
              <a:chExt cx="4626654" cy="2302162"/>
            </a:xfrm>
          </p:grpSpPr>
          <p:sp>
            <p:nvSpPr>
              <p:cNvPr id="154" name="타원 153">
                <a:extLst>
                  <a:ext uri="{FF2B5EF4-FFF2-40B4-BE49-F238E27FC236}">
                    <a16:creationId xmlns:a16="http://schemas.microsoft.com/office/drawing/2014/main" id="{866B0A87-6E3B-4514-8AE6-8DA53FCEDEFB}"/>
                  </a:ext>
                </a:extLst>
              </p:cNvPr>
              <p:cNvSpPr/>
              <p:nvPr/>
            </p:nvSpPr>
            <p:spPr>
              <a:xfrm>
                <a:off x="2311155" y="878298"/>
                <a:ext cx="2302164" cy="2302162"/>
              </a:xfrm>
              <a:prstGeom prst="ellipse">
                <a:avLst/>
              </a:prstGeom>
              <a:solidFill>
                <a:schemeClr val="tx2">
                  <a:lumMod val="10000"/>
                  <a:lumOff val="9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defTabSz="545434"/>
                <a:endParaRPr lang="ko-KR" altLang="en-US" sz="1215" dirty="0">
                  <a:solidFill>
                    <a:prstClr val="white"/>
                  </a:solidFill>
                  <a:latin typeface="맑은 고딕" panose="020F0502020204030204"/>
                  <a:ea typeface="맑은 고딕" panose="020B0503020000020004" pitchFamily="50" charset="-127"/>
                </a:endParaRPr>
              </a:p>
            </p:txBody>
          </p:sp>
          <p:grpSp>
            <p:nvGrpSpPr>
              <p:cNvPr id="156" name="그룹 155">
                <a:extLst>
                  <a:ext uri="{FF2B5EF4-FFF2-40B4-BE49-F238E27FC236}">
                    <a16:creationId xmlns:a16="http://schemas.microsoft.com/office/drawing/2014/main" id="{FB5B923D-2412-4E6C-ADF9-4308E9634112}"/>
                  </a:ext>
                </a:extLst>
              </p:cNvPr>
              <p:cNvGrpSpPr/>
              <p:nvPr/>
            </p:nvGrpSpPr>
            <p:grpSpPr>
              <a:xfrm>
                <a:off x="2948614" y="1365235"/>
                <a:ext cx="565300" cy="742484"/>
                <a:chOff x="595129" y="2405834"/>
                <a:chExt cx="638175" cy="838200"/>
              </a:xfrm>
            </p:grpSpPr>
            <p:sp>
              <p:nvSpPr>
                <p:cNvPr id="168" name="AutoShape 3">
                  <a:extLst>
                    <a:ext uri="{FF2B5EF4-FFF2-40B4-BE49-F238E27FC236}">
                      <a16:creationId xmlns:a16="http://schemas.microsoft.com/office/drawing/2014/main" id="{F6A4F462-F419-48CC-849B-D1006BBF01A8}"/>
                    </a:ext>
                  </a:extLst>
                </p:cNvPr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598304" y="2405834"/>
                  <a:ext cx="631825" cy="8350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69" name="Freeform 5">
                  <a:extLst>
                    <a:ext uri="{FF2B5EF4-FFF2-40B4-BE49-F238E27FC236}">
                      <a16:creationId xmlns:a16="http://schemas.microsoft.com/office/drawing/2014/main" id="{66FEC1D8-A6D9-466F-B534-B6B99E66EBB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25292" y="2734447"/>
                  <a:ext cx="53975" cy="60325"/>
                </a:xfrm>
                <a:custGeom>
                  <a:avLst/>
                  <a:gdLst>
                    <a:gd name="T0" fmla="*/ 5 w 14"/>
                    <a:gd name="T1" fmla="*/ 0 h 16"/>
                    <a:gd name="T2" fmla="*/ 14 w 14"/>
                    <a:gd name="T3" fmla="*/ 12 h 16"/>
                    <a:gd name="T4" fmla="*/ 12 w 14"/>
                    <a:gd name="T5" fmla="*/ 14 h 16"/>
                    <a:gd name="T6" fmla="*/ 2 w 14"/>
                    <a:gd name="T7" fmla="*/ 13 h 16"/>
                    <a:gd name="T8" fmla="*/ 0 w 14"/>
                    <a:gd name="T9" fmla="*/ 8 h 16"/>
                    <a:gd name="T10" fmla="*/ 2 w 14"/>
                    <a:gd name="T11" fmla="*/ 3 h 16"/>
                    <a:gd name="T12" fmla="*/ 5 w 14"/>
                    <a:gd name="T13" fmla="*/ 0 h 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14" h="16">
                      <a:moveTo>
                        <a:pt x="5" y="0"/>
                      </a:moveTo>
                      <a:cubicBezTo>
                        <a:pt x="14" y="12"/>
                        <a:pt x="14" y="12"/>
                        <a:pt x="14" y="12"/>
                      </a:cubicBezTo>
                      <a:cubicBezTo>
                        <a:pt x="12" y="14"/>
                        <a:pt x="12" y="14"/>
                        <a:pt x="12" y="14"/>
                      </a:cubicBezTo>
                      <a:cubicBezTo>
                        <a:pt x="9" y="16"/>
                        <a:pt x="5" y="16"/>
                        <a:pt x="2" y="13"/>
                      </a:cubicBezTo>
                      <a:cubicBezTo>
                        <a:pt x="0" y="12"/>
                        <a:pt x="0" y="10"/>
                        <a:pt x="0" y="8"/>
                      </a:cubicBezTo>
                      <a:cubicBezTo>
                        <a:pt x="0" y="6"/>
                        <a:pt x="1" y="4"/>
                        <a:pt x="2" y="3"/>
                      </a:cubicBezTo>
                      <a:lnTo>
                        <a:pt x="5" y="0"/>
                      </a:lnTo>
                      <a:close/>
                    </a:path>
                  </a:pathLst>
                </a:custGeom>
                <a:solidFill>
                  <a:srgbClr val="FDC367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70" name="Freeform 6">
                  <a:extLst>
                    <a:ext uri="{FF2B5EF4-FFF2-40B4-BE49-F238E27FC236}">
                      <a16:creationId xmlns:a16="http://schemas.microsoft.com/office/drawing/2014/main" id="{D9DC623B-0D2F-4D6F-8AC4-286AA575545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145992" y="2734447"/>
                  <a:ext cx="57150" cy="60325"/>
                </a:xfrm>
                <a:custGeom>
                  <a:avLst/>
                  <a:gdLst>
                    <a:gd name="T0" fmla="*/ 15 w 15"/>
                    <a:gd name="T1" fmla="*/ 8 h 16"/>
                    <a:gd name="T2" fmla="*/ 12 w 15"/>
                    <a:gd name="T3" fmla="*/ 13 h 16"/>
                    <a:gd name="T4" fmla="*/ 3 w 15"/>
                    <a:gd name="T5" fmla="*/ 14 h 16"/>
                    <a:gd name="T6" fmla="*/ 0 w 15"/>
                    <a:gd name="T7" fmla="*/ 12 h 16"/>
                    <a:gd name="T8" fmla="*/ 9 w 15"/>
                    <a:gd name="T9" fmla="*/ 0 h 16"/>
                    <a:gd name="T10" fmla="*/ 12 w 15"/>
                    <a:gd name="T11" fmla="*/ 3 h 16"/>
                    <a:gd name="T12" fmla="*/ 15 w 15"/>
                    <a:gd name="T13" fmla="*/ 8 h 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15" h="16">
                      <a:moveTo>
                        <a:pt x="15" y="8"/>
                      </a:moveTo>
                      <a:cubicBezTo>
                        <a:pt x="15" y="10"/>
                        <a:pt x="14" y="12"/>
                        <a:pt x="12" y="13"/>
                      </a:cubicBezTo>
                      <a:cubicBezTo>
                        <a:pt x="10" y="16"/>
                        <a:pt x="5" y="16"/>
                        <a:pt x="3" y="14"/>
                      </a:cubicBezTo>
                      <a:cubicBezTo>
                        <a:pt x="0" y="12"/>
                        <a:pt x="0" y="12"/>
                        <a:pt x="0" y="12"/>
                      </a:cubicBezTo>
                      <a:cubicBezTo>
                        <a:pt x="9" y="0"/>
                        <a:pt x="9" y="0"/>
                        <a:pt x="9" y="0"/>
                      </a:cubicBezTo>
                      <a:cubicBezTo>
                        <a:pt x="12" y="3"/>
                        <a:pt x="12" y="3"/>
                        <a:pt x="12" y="3"/>
                      </a:cubicBezTo>
                      <a:cubicBezTo>
                        <a:pt x="14" y="4"/>
                        <a:pt x="15" y="6"/>
                        <a:pt x="15" y="8"/>
                      </a:cubicBezTo>
                      <a:close/>
                    </a:path>
                  </a:pathLst>
                </a:custGeom>
                <a:solidFill>
                  <a:srgbClr val="FDC367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71" name="Freeform 7">
                  <a:extLst>
                    <a:ext uri="{FF2B5EF4-FFF2-40B4-BE49-F238E27FC236}">
                      <a16:creationId xmlns:a16="http://schemas.microsoft.com/office/drawing/2014/main" id="{596AAB15-2409-4853-A36D-3C4697BDC39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17379" y="2947172"/>
                  <a:ext cx="95250" cy="266700"/>
                </a:xfrm>
                <a:custGeom>
                  <a:avLst/>
                  <a:gdLst>
                    <a:gd name="T0" fmla="*/ 25 w 25"/>
                    <a:gd name="T1" fmla="*/ 0 h 70"/>
                    <a:gd name="T2" fmla="*/ 25 w 25"/>
                    <a:gd name="T3" fmla="*/ 5 h 70"/>
                    <a:gd name="T4" fmla="*/ 21 w 25"/>
                    <a:gd name="T5" fmla="*/ 9 h 70"/>
                    <a:gd name="T6" fmla="*/ 21 w 25"/>
                    <a:gd name="T7" fmla="*/ 70 h 70"/>
                    <a:gd name="T8" fmla="*/ 3 w 25"/>
                    <a:gd name="T9" fmla="*/ 70 h 70"/>
                    <a:gd name="T10" fmla="*/ 0 w 25"/>
                    <a:gd name="T11" fmla="*/ 67 h 70"/>
                    <a:gd name="T12" fmla="*/ 0 w 25"/>
                    <a:gd name="T13" fmla="*/ 0 h 70"/>
                    <a:gd name="T14" fmla="*/ 25 w 25"/>
                    <a:gd name="T15" fmla="*/ 0 h 7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25" h="70">
                      <a:moveTo>
                        <a:pt x="25" y="0"/>
                      </a:moveTo>
                      <a:cubicBezTo>
                        <a:pt x="25" y="5"/>
                        <a:pt x="25" y="5"/>
                        <a:pt x="25" y="5"/>
                      </a:cubicBezTo>
                      <a:cubicBezTo>
                        <a:pt x="23" y="5"/>
                        <a:pt x="21" y="7"/>
                        <a:pt x="21" y="9"/>
                      </a:cubicBezTo>
                      <a:cubicBezTo>
                        <a:pt x="21" y="70"/>
                        <a:pt x="21" y="70"/>
                        <a:pt x="21" y="70"/>
                      </a:cubicBezTo>
                      <a:cubicBezTo>
                        <a:pt x="3" y="70"/>
                        <a:pt x="3" y="70"/>
                        <a:pt x="3" y="70"/>
                      </a:cubicBezTo>
                      <a:cubicBezTo>
                        <a:pt x="1" y="70"/>
                        <a:pt x="0" y="69"/>
                        <a:pt x="0" y="67"/>
                      </a:cubicBezTo>
                      <a:cubicBezTo>
                        <a:pt x="0" y="0"/>
                        <a:pt x="0" y="0"/>
                        <a:pt x="0" y="0"/>
                      </a:cubicBez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43AAC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72" name="Freeform 8">
                  <a:extLst>
                    <a:ext uri="{FF2B5EF4-FFF2-40B4-BE49-F238E27FC236}">
                      <a16:creationId xmlns:a16="http://schemas.microsoft.com/office/drawing/2014/main" id="{78B8112D-482F-44F6-A595-04A1030917C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12629" y="2947172"/>
                  <a:ext cx="95250" cy="266700"/>
                </a:xfrm>
                <a:custGeom>
                  <a:avLst/>
                  <a:gdLst>
                    <a:gd name="T0" fmla="*/ 25 w 25"/>
                    <a:gd name="T1" fmla="*/ 0 h 70"/>
                    <a:gd name="T2" fmla="*/ 25 w 25"/>
                    <a:gd name="T3" fmla="*/ 67 h 70"/>
                    <a:gd name="T4" fmla="*/ 22 w 25"/>
                    <a:gd name="T5" fmla="*/ 70 h 70"/>
                    <a:gd name="T6" fmla="*/ 4 w 25"/>
                    <a:gd name="T7" fmla="*/ 70 h 70"/>
                    <a:gd name="T8" fmla="*/ 4 w 25"/>
                    <a:gd name="T9" fmla="*/ 9 h 70"/>
                    <a:gd name="T10" fmla="*/ 0 w 25"/>
                    <a:gd name="T11" fmla="*/ 5 h 70"/>
                    <a:gd name="T12" fmla="*/ 0 w 25"/>
                    <a:gd name="T13" fmla="*/ 0 h 70"/>
                    <a:gd name="T14" fmla="*/ 25 w 25"/>
                    <a:gd name="T15" fmla="*/ 0 h 7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25" h="70">
                      <a:moveTo>
                        <a:pt x="25" y="0"/>
                      </a:moveTo>
                      <a:cubicBezTo>
                        <a:pt x="25" y="67"/>
                        <a:pt x="25" y="67"/>
                        <a:pt x="25" y="67"/>
                      </a:cubicBezTo>
                      <a:cubicBezTo>
                        <a:pt x="25" y="69"/>
                        <a:pt x="24" y="70"/>
                        <a:pt x="22" y="70"/>
                      </a:cubicBezTo>
                      <a:cubicBezTo>
                        <a:pt x="4" y="70"/>
                        <a:pt x="4" y="70"/>
                        <a:pt x="4" y="70"/>
                      </a:cubicBezTo>
                      <a:cubicBezTo>
                        <a:pt x="4" y="9"/>
                        <a:pt x="4" y="9"/>
                        <a:pt x="4" y="9"/>
                      </a:cubicBezTo>
                      <a:cubicBezTo>
                        <a:pt x="4" y="7"/>
                        <a:pt x="2" y="5"/>
                        <a:pt x="0" y="5"/>
                      </a:cubicBezTo>
                      <a:cubicBezTo>
                        <a:pt x="0" y="0"/>
                        <a:pt x="0" y="0"/>
                        <a:pt x="0" y="0"/>
                      </a:cubicBez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43AAC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73" name="Freeform 9">
                  <a:extLst>
                    <a:ext uri="{FF2B5EF4-FFF2-40B4-BE49-F238E27FC236}">
                      <a16:creationId xmlns:a16="http://schemas.microsoft.com/office/drawing/2014/main" id="{C072F6AB-5292-4669-BDCE-EB0AAAAF02A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66567" y="2612209"/>
                  <a:ext cx="490538" cy="304800"/>
                </a:xfrm>
                <a:custGeom>
                  <a:avLst/>
                  <a:gdLst>
                    <a:gd name="T0" fmla="*/ 128 w 128"/>
                    <a:gd name="T1" fmla="*/ 27 h 80"/>
                    <a:gd name="T2" fmla="*/ 119 w 128"/>
                    <a:gd name="T3" fmla="*/ 39 h 80"/>
                    <a:gd name="T4" fmla="*/ 96 w 128"/>
                    <a:gd name="T5" fmla="*/ 18 h 80"/>
                    <a:gd name="T6" fmla="*/ 92 w 128"/>
                    <a:gd name="T7" fmla="*/ 18 h 80"/>
                    <a:gd name="T8" fmla="*/ 89 w 128"/>
                    <a:gd name="T9" fmla="*/ 21 h 80"/>
                    <a:gd name="T10" fmla="*/ 89 w 128"/>
                    <a:gd name="T11" fmla="*/ 80 h 80"/>
                    <a:gd name="T12" fmla="*/ 39 w 128"/>
                    <a:gd name="T13" fmla="*/ 80 h 80"/>
                    <a:gd name="T14" fmla="*/ 39 w 128"/>
                    <a:gd name="T15" fmla="*/ 21 h 80"/>
                    <a:gd name="T16" fmla="*/ 37 w 128"/>
                    <a:gd name="T17" fmla="*/ 18 h 80"/>
                    <a:gd name="T18" fmla="*/ 35 w 128"/>
                    <a:gd name="T19" fmla="*/ 17 h 80"/>
                    <a:gd name="T20" fmla="*/ 33 w 128"/>
                    <a:gd name="T21" fmla="*/ 18 h 80"/>
                    <a:gd name="T22" fmla="*/ 9 w 128"/>
                    <a:gd name="T23" fmla="*/ 39 h 80"/>
                    <a:gd name="T24" fmla="*/ 0 w 128"/>
                    <a:gd name="T25" fmla="*/ 27 h 80"/>
                    <a:gd name="T26" fmla="*/ 26 w 128"/>
                    <a:gd name="T27" fmla="*/ 5 h 80"/>
                    <a:gd name="T28" fmla="*/ 46 w 128"/>
                    <a:gd name="T29" fmla="*/ 5 h 80"/>
                    <a:gd name="T30" fmla="*/ 64 w 128"/>
                    <a:gd name="T31" fmla="*/ 11 h 80"/>
                    <a:gd name="T32" fmla="*/ 82 w 128"/>
                    <a:gd name="T33" fmla="*/ 5 h 80"/>
                    <a:gd name="T34" fmla="*/ 102 w 128"/>
                    <a:gd name="T35" fmla="*/ 5 h 80"/>
                    <a:gd name="T36" fmla="*/ 128 w 128"/>
                    <a:gd name="T37" fmla="*/ 27 h 8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</a:cxnLst>
                  <a:rect l="0" t="0" r="r" b="b"/>
                  <a:pathLst>
                    <a:path w="128" h="80">
                      <a:moveTo>
                        <a:pt x="128" y="27"/>
                      </a:moveTo>
                      <a:cubicBezTo>
                        <a:pt x="119" y="39"/>
                        <a:pt x="119" y="39"/>
                        <a:pt x="119" y="39"/>
                      </a:cubicBezTo>
                      <a:cubicBezTo>
                        <a:pt x="96" y="18"/>
                        <a:pt x="96" y="18"/>
                        <a:pt x="96" y="18"/>
                      </a:cubicBezTo>
                      <a:cubicBezTo>
                        <a:pt x="95" y="17"/>
                        <a:pt x="93" y="17"/>
                        <a:pt x="92" y="18"/>
                      </a:cubicBezTo>
                      <a:cubicBezTo>
                        <a:pt x="90" y="18"/>
                        <a:pt x="89" y="20"/>
                        <a:pt x="89" y="21"/>
                      </a:cubicBezTo>
                      <a:cubicBezTo>
                        <a:pt x="89" y="80"/>
                        <a:pt x="89" y="80"/>
                        <a:pt x="89" y="80"/>
                      </a:cubicBezTo>
                      <a:cubicBezTo>
                        <a:pt x="39" y="80"/>
                        <a:pt x="39" y="80"/>
                        <a:pt x="39" y="80"/>
                      </a:cubicBezTo>
                      <a:cubicBezTo>
                        <a:pt x="39" y="21"/>
                        <a:pt x="39" y="21"/>
                        <a:pt x="39" y="21"/>
                      </a:cubicBezTo>
                      <a:cubicBezTo>
                        <a:pt x="39" y="20"/>
                        <a:pt x="38" y="18"/>
                        <a:pt x="37" y="18"/>
                      </a:cubicBezTo>
                      <a:cubicBezTo>
                        <a:pt x="36" y="18"/>
                        <a:pt x="36" y="17"/>
                        <a:pt x="35" y="17"/>
                      </a:cubicBezTo>
                      <a:cubicBezTo>
                        <a:pt x="34" y="17"/>
                        <a:pt x="33" y="18"/>
                        <a:pt x="33" y="18"/>
                      </a:cubicBezTo>
                      <a:cubicBezTo>
                        <a:pt x="9" y="39"/>
                        <a:pt x="9" y="39"/>
                        <a:pt x="9" y="39"/>
                      </a:cubicBezTo>
                      <a:cubicBezTo>
                        <a:pt x="0" y="27"/>
                        <a:pt x="0" y="27"/>
                        <a:pt x="0" y="27"/>
                      </a:cubicBezTo>
                      <a:cubicBezTo>
                        <a:pt x="26" y="5"/>
                        <a:pt x="26" y="5"/>
                        <a:pt x="26" y="5"/>
                      </a:cubicBezTo>
                      <a:cubicBezTo>
                        <a:pt x="32" y="0"/>
                        <a:pt x="41" y="0"/>
                        <a:pt x="46" y="5"/>
                      </a:cubicBezTo>
                      <a:cubicBezTo>
                        <a:pt x="52" y="9"/>
                        <a:pt x="58" y="11"/>
                        <a:pt x="64" y="11"/>
                      </a:cubicBezTo>
                      <a:cubicBezTo>
                        <a:pt x="71" y="11"/>
                        <a:pt x="77" y="9"/>
                        <a:pt x="82" y="5"/>
                      </a:cubicBezTo>
                      <a:cubicBezTo>
                        <a:pt x="88" y="0"/>
                        <a:pt x="97" y="0"/>
                        <a:pt x="102" y="5"/>
                      </a:cubicBezTo>
                      <a:lnTo>
                        <a:pt x="128" y="27"/>
                      </a:lnTo>
                      <a:close/>
                    </a:path>
                  </a:pathLst>
                </a:custGeom>
                <a:solidFill>
                  <a:srgbClr val="97D0DC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74" name="Freeform 10">
                  <a:extLst>
                    <a:ext uri="{FF2B5EF4-FFF2-40B4-BE49-F238E27FC236}">
                      <a16:creationId xmlns:a16="http://schemas.microsoft.com/office/drawing/2014/main" id="{03262B58-070E-47C4-9534-DC3502EACC0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55479" y="2440759"/>
                  <a:ext cx="114300" cy="128588"/>
                </a:xfrm>
                <a:custGeom>
                  <a:avLst/>
                  <a:gdLst>
                    <a:gd name="T0" fmla="*/ 30 w 30"/>
                    <a:gd name="T1" fmla="*/ 10 h 34"/>
                    <a:gd name="T2" fmla="*/ 26 w 30"/>
                    <a:gd name="T3" fmla="*/ 25 h 34"/>
                    <a:gd name="T4" fmla="*/ 15 w 30"/>
                    <a:gd name="T5" fmla="*/ 34 h 34"/>
                    <a:gd name="T6" fmla="*/ 4 w 30"/>
                    <a:gd name="T7" fmla="*/ 25 h 34"/>
                    <a:gd name="T8" fmla="*/ 0 w 30"/>
                    <a:gd name="T9" fmla="*/ 10 h 34"/>
                    <a:gd name="T10" fmla="*/ 5 w 30"/>
                    <a:gd name="T11" fmla="*/ 2 h 34"/>
                    <a:gd name="T12" fmla="*/ 15 w 30"/>
                    <a:gd name="T13" fmla="*/ 0 h 34"/>
                    <a:gd name="T14" fmla="*/ 26 w 30"/>
                    <a:gd name="T15" fmla="*/ 3 h 34"/>
                    <a:gd name="T16" fmla="*/ 30 w 30"/>
                    <a:gd name="T17" fmla="*/ 10 h 3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0" h="34">
                      <a:moveTo>
                        <a:pt x="30" y="10"/>
                      </a:moveTo>
                      <a:cubicBezTo>
                        <a:pt x="30" y="16"/>
                        <a:pt x="29" y="21"/>
                        <a:pt x="26" y="25"/>
                      </a:cubicBezTo>
                      <a:cubicBezTo>
                        <a:pt x="23" y="31"/>
                        <a:pt x="20" y="34"/>
                        <a:pt x="15" y="34"/>
                      </a:cubicBezTo>
                      <a:cubicBezTo>
                        <a:pt x="11" y="34"/>
                        <a:pt x="7" y="31"/>
                        <a:pt x="4" y="25"/>
                      </a:cubicBezTo>
                      <a:cubicBezTo>
                        <a:pt x="1" y="21"/>
                        <a:pt x="0" y="16"/>
                        <a:pt x="0" y="10"/>
                      </a:cubicBezTo>
                      <a:cubicBezTo>
                        <a:pt x="0" y="7"/>
                        <a:pt x="2" y="4"/>
                        <a:pt x="5" y="2"/>
                      </a:cubicBezTo>
                      <a:cubicBezTo>
                        <a:pt x="7" y="1"/>
                        <a:pt x="11" y="0"/>
                        <a:pt x="15" y="0"/>
                      </a:cubicBezTo>
                      <a:cubicBezTo>
                        <a:pt x="20" y="0"/>
                        <a:pt x="24" y="1"/>
                        <a:pt x="26" y="3"/>
                      </a:cubicBezTo>
                      <a:cubicBezTo>
                        <a:pt x="29" y="4"/>
                        <a:pt x="30" y="7"/>
                        <a:pt x="30" y="10"/>
                      </a:cubicBezTo>
                      <a:close/>
                    </a:path>
                  </a:pathLst>
                </a:custGeom>
                <a:solidFill>
                  <a:srgbClr val="FFEB9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75" name="Freeform 11">
                  <a:extLst>
                    <a:ext uri="{FF2B5EF4-FFF2-40B4-BE49-F238E27FC236}">
                      <a16:creationId xmlns:a16="http://schemas.microsoft.com/office/drawing/2014/main" id="{08309992-AFC0-4E03-9ADB-7A6529E6B348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595129" y="2577284"/>
                  <a:ext cx="638175" cy="666750"/>
                </a:xfrm>
                <a:custGeom>
                  <a:avLst/>
                  <a:gdLst>
                    <a:gd name="T0" fmla="*/ 162 w 167"/>
                    <a:gd name="T1" fmla="*/ 60 h 175"/>
                    <a:gd name="T2" fmla="*/ 116 w 167"/>
                    <a:gd name="T3" fmla="*/ 39 h 175"/>
                    <a:gd name="T4" fmla="*/ 105 w 167"/>
                    <a:gd name="T5" fmla="*/ 175 h 175"/>
                    <a:gd name="T6" fmla="*/ 50 w 167"/>
                    <a:gd name="T7" fmla="*/ 164 h 175"/>
                    <a:gd name="T8" fmla="*/ 25 w 167"/>
                    <a:gd name="T9" fmla="*/ 61 h 175"/>
                    <a:gd name="T10" fmla="*/ 0 w 167"/>
                    <a:gd name="T11" fmla="*/ 49 h 175"/>
                    <a:gd name="T12" fmla="*/ 40 w 167"/>
                    <a:gd name="T13" fmla="*/ 8 h 175"/>
                    <a:gd name="T14" fmla="*/ 83 w 167"/>
                    <a:gd name="T15" fmla="*/ 12 h 175"/>
                    <a:gd name="T16" fmla="*/ 127 w 167"/>
                    <a:gd name="T17" fmla="*/ 8 h 175"/>
                    <a:gd name="T18" fmla="*/ 166 w 167"/>
                    <a:gd name="T19" fmla="*/ 49 h 175"/>
                    <a:gd name="T20" fmla="*/ 159 w 167"/>
                    <a:gd name="T21" fmla="*/ 49 h 175"/>
                    <a:gd name="T22" fmla="*/ 153 w 167"/>
                    <a:gd name="T23" fmla="*/ 41 h 175"/>
                    <a:gd name="T24" fmla="*/ 147 w 167"/>
                    <a:gd name="T25" fmla="*/ 55 h 175"/>
                    <a:gd name="T26" fmla="*/ 138 w 167"/>
                    <a:gd name="T27" fmla="*/ 48 h 175"/>
                    <a:gd name="T28" fmla="*/ 121 w 167"/>
                    <a:gd name="T29" fmla="*/ 14 h 175"/>
                    <a:gd name="T30" fmla="*/ 83 w 167"/>
                    <a:gd name="T31" fmla="*/ 20 h 175"/>
                    <a:gd name="T32" fmla="*/ 45 w 167"/>
                    <a:gd name="T33" fmla="*/ 14 h 175"/>
                    <a:gd name="T34" fmla="*/ 28 w 167"/>
                    <a:gd name="T35" fmla="*/ 48 h 175"/>
                    <a:gd name="T36" fmla="*/ 54 w 167"/>
                    <a:gd name="T37" fmla="*/ 26 h 175"/>
                    <a:gd name="T38" fmla="*/ 58 w 167"/>
                    <a:gd name="T39" fmla="*/ 30 h 175"/>
                    <a:gd name="T40" fmla="*/ 108 w 167"/>
                    <a:gd name="T41" fmla="*/ 89 h 175"/>
                    <a:gd name="T42" fmla="*/ 111 w 167"/>
                    <a:gd name="T43" fmla="*/ 27 h 175"/>
                    <a:gd name="T44" fmla="*/ 138 w 167"/>
                    <a:gd name="T45" fmla="*/ 48 h 175"/>
                    <a:gd name="T46" fmla="*/ 108 w 167"/>
                    <a:gd name="T47" fmla="*/ 97 h 175"/>
                    <a:gd name="T48" fmla="*/ 58 w 167"/>
                    <a:gd name="T49" fmla="*/ 97 h 175"/>
                    <a:gd name="T50" fmla="*/ 61 w 167"/>
                    <a:gd name="T51" fmla="*/ 167 h 175"/>
                    <a:gd name="T52" fmla="*/ 79 w 167"/>
                    <a:gd name="T53" fmla="*/ 106 h 175"/>
                    <a:gd name="T54" fmla="*/ 87 w 167"/>
                    <a:gd name="T55" fmla="*/ 106 h 175"/>
                    <a:gd name="T56" fmla="*/ 105 w 167"/>
                    <a:gd name="T57" fmla="*/ 167 h 175"/>
                    <a:gd name="T58" fmla="*/ 22 w 167"/>
                    <a:gd name="T59" fmla="*/ 53 h 175"/>
                    <a:gd name="T60" fmla="*/ 10 w 167"/>
                    <a:gd name="T61" fmla="*/ 44 h 175"/>
                    <a:gd name="T62" fmla="*/ 10 w 167"/>
                    <a:gd name="T63" fmla="*/ 54 h 175"/>
                    <a:gd name="T64" fmla="*/ 22 w 167"/>
                    <a:gd name="T65" fmla="*/ 53 h 17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</a:cxnLst>
                  <a:rect l="0" t="0" r="r" b="b"/>
                  <a:pathLst>
                    <a:path w="167" h="175">
                      <a:moveTo>
                        <a:pt x="166" y="49"/>
                      </a:moveTo>
                      <a:cubicBezTo>
                        <a:pt x="167" y="53"/>
                        <a:pt x="165" y="57"/>
                        <a:pt x="162" y="60"/>
                      </a:cubicBezTo>
                      <a:cubicBezTo>
                        <a:pt x="156" y="65"/>
                        <a:pt x="147" y="66"/>
                        <a:pt x="142" y="61"/>
                      </a:cubicBezTo>
                      <a:cubicBezTo>
                        <a:pt x="116" y="39"/>
                        <a:pt x="116" y="39"/>
                        <a:pt x="116" y="39"/>
                      </a:cubicBezTo>
                      <a:cubicBezTo>
                        <a:pt x="116" y="164"/>
                        <a:pt x="116" y="164"/>
                        <a:pt x="116" y="164"/>
                      </a:cubicBezTo>
                      <a:cubicBezTo>
                        <a:pt x="116" y="170"/>
                        <a:pt x="111" y="175"/>
                        <a:pt x="105" y="175"/>
                      </a:cubicBezTo>
                      <a:cubicBezTo>
                        <a:pt x="61" y="175"/>
                        <a:pt x="61" y="175"/>
                        <a:pt x="61" y="175"/>
                      </a:cubicBezTo>
                      <a:cubicBezTo>
                        <a:pt x="55" y="175"/>
                        <a:pt x="50" y="170"/>
                        <a:pt x="50" y="164"/>
                      </a:cubicBezTo>
                      <a:cubicBezTo>
                        <a:pt x="50" y="39"/>
                        <a:pt x="50" y="39"/>
                        <a:pt x="50" y="39"/>
                      </a:cubicBezTo>
                      <a:cubicBezTo>
                        <a:pt x="25" y="61"/>
                        <a:pt x="25" y="61"/>
                        <a:pt x="25" y="61"/>
                      </a:cubicBezTo>
                      <a:cubicBezTo>
                        <a:pt x="19" y="66"/>
                        <a:pt x="10" y="65"/>
                        <a:pt x="4" y="60"/>
                      </a:cubicBezTo>
                      <a:cubicBezTo>
                        <a:pt x="1" y="57"/>
                        <a:pt x="0" y="53"/>
                        <a:pt x="0" y="49"/>
                      </a:cubicBezTo>
                      <a:cubicBezTo>
                        <a:pt x="0" y="45"/>
                        <a:pt x="2" y="41"/>
                        <a:pt x="5" y="38"/>
                      </a:cubicBezTo>
                      <a:cubicBezTo>
                        <a:pt x="40" y="8"/>
                        <a:pt x="40" y="8"/>
                        <a:pt x="40" y="8"/>
                      </a:cubicBezTo>
                      <a:cubicBezTo>
                        <a:pt x="49" y="1"/>
                        <a:pt x="62" y="0"/>
                        <a:pt x="70" y="8"/>
                      </a:cubicBezTo>
                      <a:cubicBezTo>
                        <a:pt x="74" y="11"/>
                        <a:pt x="79" y="12"/>
                        <a:pt x="83" y="12"/>
                      </a:cubicBezTo>
                      <a:cubicBezTo>
                        <a:pt x="88" y="12"/>
                        <a:pt x="92" y="11"/>
                        <a:pt x="96" y="8"/>
                      </a:cubicBezTo>
                      <a:cubicBezTo>
                        <a:pt x="105" y="0"/>
                        <a:pt x="118" y="1"/>
                        <a:pt x="127" y="8"/>
                      </a:cubicBezTo>
                      <a:cubicBezTo>
                        <a:pt x="161" y="38"/>
                        <a:pt x="161" y="38"/>
                        <a:pt x="161" y="38"/>
                      </a:cubicBezTo>
                      <a:cubicBezTo>
                        <a:pt x="164" y="41"/>
                        <a:pt x="166" y="45"/>
                        <a:pt x="166" y="49"/>
                      </a:cubicBezTo>
                      <a:close/>
                      <a:moveTo>
                        <a:pt x="156" y="54"/>
                      </a:moveTo>
                      <a:cubicBezTo>
                        <a:pt x="158" y="53"/>
                        <a:pt x="159" y="51"/>
                        <a:pt x="159" y="49"/>
                      </a:cubicBezTo>
                      <a:cubicBezTo>
                        <a:pt x="159" y="47"/>
                        <a:pt x="158" y="45"/>
                        <a:pt x="156" y="44"/>
                      </a:cubicBezTo>
                      <a:cubicBezTo>
                        <a:pt x="153" y="41"/>
                        <a:pt x="153" y="41"/>
                        <a:pt x="153" y="41"/>
                      </a:cubicBezTo>
                      <a:cubicBezTo>
                        <a:pt x="144" y="53"/>
                        <a:pt x="144" y="53"/>
                        <a:pt x="144" y="53"/>
                      </a:cubicBezTo>
                      <a:cubicBezTo>
                        <a:pt x="147" y="55"/>
                        <a:pt x="147" y="55"/>
                        <a:pt x="147" y="55"/>
                      </a:cubicBezTo>
                      <a:cubicBezTo>
                        <a:pt x="149" y="57"/>
                        <a:pt x="154" y="57"/>
                        <a:pt x="156" y="54"/>
                      </a:cubicBezTo>
                      <a:close/>
                      <a:moveTo>
                        <a:pt x="138" y="48"/>
                      </a:moveTo>
                      <a:cubicBezTo>
                        <a:pt x="147" y="36"/>
                        <a:pt x="147" y="36"/>
                        <a:pt x="147" y="36"/>
                      </a:cubicBezTo>
                      <a:cubicBezTo>
                        <a:pt x="121" y="14"/>
                        <a:pt x="121" y="14"/>
                        <a:pt x="121" y="14"/>
                      </a:cubicBezTo>
                      <a:cubicBezTo>
                        <a:pt x="116" y="9"/>
                        <a:pt x="107" y="9"/>
                        <a:pt x="101" y="14"/>
                      </a:cubicBezTo>
                      <a:cubicBezTo>
                        <a:pt x="96" y="18"/>
                        <a:pt x="90" y="20"/>
                        <a:pt x="83" y="20"/>
                      </a:cubicBezTo>
                      <a:cubicBezTo>
                        <a:pt x="77" y="20"/>
                        <a:pt x="71" y="18"/>
                        <a:pt x="65" y="14"/>
                      </a:cubicBezTo>
                      <a:cubicBezTo>
                        <a:pt x="60" y="9"/>
                        <a:pt x="51" y="9"/>
                        <a:pt x="45" y="14"/>
                      </a:cubicBezTo>
                      <a:cubicBezTo>
                        <a:pt x="19" y="36"/>
                        <a:pt x="19" y="36"/>
                        <a:pt x="19" y="36"/>
                      </a:cubicBezTo>
                      <a:cubicBezTo>
                        <a:pt x="28" y="48"/>
                        <a:pt x="28" y="48"/>
                        <a:pt x="28" y="48"/>
                      </a:cubicBezTo>
                      <a:cubicBezTo>
                        <a:pt x="52" y="27"/>
                        <a:pt x="52" y="27"/>
                        <a:pt x="52" y="27"/>
                      </a:cubicBezTo>
                      <a:cubicBezTo>
                        <a:pt x="52" y="27"/>
                        <a:pt x="53" y="26"/>
                        <a:pt x="54" y="26"/>
                      </a:cubicBezTo>
                      <a:cubicBezTo>
                        <a:pt x="55" y="26"/>
                        <a:pt x="55" y="27"/>
                        <a:pt x="56" y="27"/>
                      </a:cubicBezTo>
                      <a:cubicBezTo>
                        <a:pt x="57" y="27"/>
                        <a:pt x="58" y="29"/>
                        <a:pt x="58" y="30"/>
                      </a:cubicBezTo>
                      <a:cubicBezTo>
                        <a:pt x="58" y="89"/>
                        <a:pt x="58" y="89"/>
                        <a:pt x="58" y="89"/>
                      </a:cubicBezTo>
                      <a:cubicBezTo>
                        <a:pt x="108" y="89"/>
                        <a:pt x="108" y="89"/>
                        <a:pt x="108" y="89"/>
                      </a:cubicBezTo>
                      <a:cubicBezTo>
                        <a:pt x="108" y="30"/>
                        <a:pt x="108" y="30"/>
                        <a:pt x="108" y="30"/>
                      </a:cubicBezTo>
                      <a:cubicBezTo>
                        <a:pt x="108" y="29"/>
                        <a:pt x="109" y="27"/>
                        <a:pt x="111" y="27"/>
                      </a:cubicBezTo>
                      <a:cubicBezTo>
                        <a:pt x="112" y="26"/>
                        <a:pt x="114" y="26"/>
                        <a:pt x="115" y="27"/>
                      </a:cubicBezTo>
                      <a:lnTo>
                        <a:pt x="138" y="48"/>
                      </a:lnTo>
                      <a:close/>
                      <a:moveTo>
                        <a:pt x="108" y="164"/>
                      </a:moveTo>
                      <a:cubicBezTo>
                        <a:pt x="108" y="97"/>
                        <a:pt x="108" y="97"/>
                        <a:pt x="108" y="97"/>
                      </a:cubicBezTo>
                      <a:cubicBezTo>
                        <a:pt x="83" y="97"/>
                        <a:pt x="83" y="97"/>
                        <a:pt x="83" y="97"/>
                      </a:cubicBezTo>
                      <a:cubicBezTo>
                        <a:pt x="58" y="97"/>
                        <a:pt x="58" y="97"/>
                        <a:pt x="58" y="97"/>
                      </a:cubicBezTo>
                      <a:cubicBezTo>
                        <a:pt x="58" y="164"/>
                        <a:pt x="58" y="164"/>
                        <a:pt x="58" y="164"/>
                      </a:cubicBezTo>
                      <a:cubicBezTo>
                        <a:pt x="58" y="166"/>
                        <a:pt x="59" y="167"/>
                        <a:pt x="61" y="167"/>
                      </a:cubicBezTo>
                      <a:cubicBezTo>
                        <a:pt x="79" y="167"/>
                        <a:pt x="79" y="167"/>
                        <a:pt x="79" y="167"/>
                      </a:cubicBezTo>
                      <a:cubicBezTo>
                        <a:pt x="79" y="106"/>
                        <a:pt x="79" y="106"/>
                        <a:pt x="79" y="106"/>
                      </a:cubicBezTo>
                      <a:cubicBezTo>
                        <a:pt x="79" y="104"/>
                        <a:pt x="81" y="102"/>
                        <a:pt x="83" y="102"/>
                      </a:cubicBezTo>
                      <a:cubicBezTo>
                        <a:pt x="85" y="102"/>
                        <a:pt x="87" y="104"/>
                        <a:pt x="87" y="106"/>
                      </a:cubicBezTo>
                      <a:cubicBezTo>
                        <a:pt x="87" y="167"/>
                        <a:pt x="87" y="167"/>
                        <a:pt x="87" y="167"/>
                      </a:cubicBezTo>
                      <a:cubicBezTo>
                        <a:pt x="105" y="167"/>
                        <a:pt x="105" y="167"/>
                        <a:pt x="105" y="167"/>
                      </a:cubicBezTo>
                      <a:cubicBezTo>
                        <a:pt x="107" y="167"/>
                        <a:pt x="108" y="166"/>
                        <a:pt x="108" y="164"/>
                      </a:cubicBezTo>
                      <a:close/>
                      <a:moveTo>
                        <a:pt x="22" y="53"/>
                      </a:moveTo>
                      <a:cubicBezTo>
                        <a:pt x="13" y="41"/>
                        <a:pt x="13" y="41"/>
                        <a:pt x="13" y="41"/>
                      </a:cubicBezTo>
                      <a:cubicBezTo>
                        <a:pt x="10" y="44"/>
                        <a:pt x="10" y="44"/>
                        <a:pt x="10" y="44"/>
                      </a:cubicBezTo>
                      <a:cubicBezTo>
                        <a:pt x="9" y="45"/>
                        <a:pt x="8" y="47"/>
                        <a:pt x="8" y="49"/>
                      </a:cubicBezTo>
                      <a:cubicBezTo>
                        <a:pt x="8" y="51"/>
                        <a:pt x="8" y="53"/>
                        <a:pt x="10" y="54"/>
                      </a:cubicBezTo>
                      <a:cubicBezTo>
                        <a:pt x="13" y="57"/>
                        <a:pt x="17" y="57"/>
                        <a:pt x="20" y="55"/>
                      </a:cubicBezTo>
                      <a:lnTo>
                        <a:pt x="22" y="53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 dirty="0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76" name="Freeform 12">
                  <a:extLst>
                    <a:ext uri="{FF2B5EF4-FFF2-40B4-BE49-F238E27FC236}">
                      <a16:creationId xmlns:a16="http://schemas.microsoft.com/office/drawing/2014/main" id="{032DDE2F-03FB-45D6-91A7-BF2262E4FB87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823729" y="2409009"/>
                  <a:ext cx="176213" cy="192088"/>
                </a:xfrm>
                <a:custGeom>
                  <a:avLst/>
                  <a:gdLst>
                    <a:gd name="T0" fmla="*/ 46 w 46"/>
                    <a:gd name="T1" fmla="*/ 18 h 50"/>
                    <a:gd name="T2" fmla="*/ 41 w 46"/>
                    <a:gd name="T3" fmla="*/ 37 h 50"/>
                    <a:gd name="T4" fmla="*/ 24 w 46"/>
                    <a:gd name="T5" fmla="*/ 50 h 50"/>
                    <a:gd name="T6" fmla="*/ 23 w 46"/>
                    <a:gd name="T7" fmla="*/ 50 h 50"/>
                    <a:gd name="T8" fmla="*/ 5 w 46"/>
                    <a:gd name="T9" fmla="*/ 37 h 50"/>
                    <a:gd name="T10" fmla="*/ 0 w 46"/>
                    <a:gd name="T11" fmla="*/ 18 h 50"/>
                    <a:gd name="T12" fmla="*/ 9 w 46"/>
                    <a:gd name="T13" fmla="*/ 3 h 50"/>
                    <a:gd name="T14" fmla="*/ 23 w 46"/>
                    <a:gd name="T15" fmla="*/ 0 h 50"/>
                    <a:gd name="T16" fmla="*/ 38 w 46"/>
                    <a:gd name="T17" fmla="*/ 4 h 50"/>
                    <a:gd name="T18" fmla="*/ 46 w 46"/>
                    <a:gd name="T19" fmla="*/ 18 h 50"/>
                    <a:gd name="T20" fmla="*/ 34 w 46"/>
                    <a:gd name="T21" fmla="*/ 33 h 50"/>
                    <a:gd name="T22" fmla="*/ 38 w 46"/>
                    <a:gd name="T23" fmla="*/ 18 h 50"/>
                    <a:gd name="T24" fmla="*/ 34 w 46"/>
                    <a:gd name="T25" fmla="*/ 11 h 50"/>
                    <a:gd name="T26" fmla="*/ 23 w 46"/>
                    <a:gd name="T27" fmla="*/ 8 h 50"/>
                    <a:gd name="T28" fmla="*/ 13 w 46"/>
                    <a:gd name="T29" fmla="*/ 10 h 50"/>
                    <a:gd name="T30" fmla="*/ 8 w 46"/>
                    <a:gd name="T31" fmla="*/ 18 h 50"/>
                    <a:gd name="T32" fmla="*/ 12 w 46"/>
                    <a:gd name="T33" fmla="*/ 33 h 50"/>
                    <a:gd name="T34" fmla="*/ 23 w 46"/>
                    <a:gd name="T35" fmla="*/ 42 h 50"/>
                    <a:gd name="T36" fmla="*/ 34 w 46"/>
                    <a:gd name="T37" fmla="*/ 33 h 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</a:cxnLst>
                  <a:rect l="0" t="0" r="r" b="b"/>
                  <a:pathLst>
                    <a:path w="46" h="50">
                      <a:moveTo>
                        <a:pt x="46" y="18"/>
                      </a:moveTo>
                      <a:cubicBezTo>
                        <a:pt x="46" y="25"/>
                        <a:pt x="44" y="31"/>
                        <a:pt x="41" y="37"/>
                      </a:cubicBezTo>
                      <a:cubicBezTo>
                        <a:pt x="36" y="47"/>
                        <a:pt x="29" y="50"/>
                        <a:pt x="24" y="50"/>
                      </a:cubicBezTo>
                      <a:cubicBezTo>
                        <a:pt x="23" y="50"/>
                        <a:pt x="23" y="50"/>
                        <a:pt x="23" y="50"/>
                      </a:cubicBezTo>
                      <a:cubicBezTo>
                        <a:pt x="18" y="50"/>
                        <a:pt x="11" y="48"/>
                        <a:pt x="5" y="37"/>
                      </a:cubicBezTo>
                      <a:cubicBezTo>
                        <a:pt x="2" y="31"/>
                        <a:pt x="0" y="25"/>
                        <a:pt x="0" y="18"/>
                      </a:cubicBezTo>
                      <a:cubicBezTo>
                        <a:pt x="0" y="12"/>
                        <a:pt x="4" y="6"/>
                        <a:pt x="9" y="3"/>
                      </a:cubicBezTo>
                      <a:cubicBezTo>
                        <a:pt x="13" y="2"/>
                        <a:pt x="17" y="0"/>
                        <a:pt x="23" y="0"/>
                      </a:cubicBezTo>
                      <a:cubicBezTo>
                        <a:pt x="30" y="0"/>
                        <a:pt x="35" y="2"/>
                        <a:pt x="38" y="4"/>
                      </a:cubicBezTo>
                      <a:cubicBezTo>
                        <a:pt x="43" y="7"/>
                        <a:pt x="46" y="12"/>
                        <a:pt x="46" y="18"/>
                      </a:cubicBezTo>
                      <a:close/>
                      <a:moveTo>
                        <a:pt x="34" y="33"/>
                      </a:moveTo>
                      <a:cubicBezTo>
                        <a:pt x="37" y="29"/>
                        <a:pt x="38" y="24"/>
                        <a:pt x="38" y="18"/>
                      </a:cubicBezTo>
                      <a:cubicBezTo>
                        <a:pt x="38" y="15"/>
                        <a:pt x="37" y="12"/>
                        <a:pt x="34" y="11"/>
                      </a:cubicBezTo>
                      <a:cubicBezTo>
                        <a:pt x="32" y="9"/>
                        <a:pt x="28" y="8"/>
                        <a:pt x="23" y="8"/>
                      </a:cubicBezTo>
                      <a:cubicBezTo>
                        <a:pt x="19" y="8"/>
                        <a:pt x="15" y="9"/>
                        <a:pt x="13" y="10"/>
                      </a:cubicBezTo>
                      <a:cubicBezTo>
                        <a:pt x="10" y="12"/>
                        <a:pt x="8" y="15"/>
                        <a:pt x="8" y="18"/>
                      </a:cubicBezTo>
                      <a:cubicBezTo>
                        <a:pt x="8" y="24"/>
                        <a:pt x="9" y="29"/>
                        <a:pt x="12" y="33"/>
                      </a:cubicBezTo>
                      <a:cubicBezTo>
                        <a:pt x="15" y="39"/>
                        <a:pt x="19" y="42"/>
                        <a:pt x="23" y="42"/>
                      </a:cubicBezTo>
                      <a:cubicBezTo>
                        <a:pt x="28" y="42"/>
                        <a:pt x="31" y="39"/>
                        <a:pt x="34" y="33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</p:grpSp>
          <p:grpSp>
            <p:nvGrpSpPr>
              <p:cNvPr id="157" name="Group 15">
                <a:extLst>
                  <a:ext uri="{FF2B5EF4-FFF2-40B4-BE49-F238E27FC236}">
                    <a16:creationId xmlns:a16="http://schemas.microsoft.com/office/drawing/2014/main" id="{B85E23A3-1550-46E2-AD8D-DF66D6522283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>
                <a:off x="3622539" y="1827658"/>
                <a:ext cx="349586" cy="284279"/>
                <a:chOff x="867" y="1678"/>
                <a:chExt cx="455" cy="370"/>
              </a:xfrm>
            </p:grpSpPr>
            <p:sp>
              <p:nvSpPr>
                <p:cNvPr id="159" name="AutoShape 14">
                  <a:extLst>
                    <a:ext uri="{FF2B5EF4-FFF2-40B4-BE49-F238E27FC236}">
                      <a16:creationId xmlns:a16="http://schemas.microsoft.com/office/drawing/2014/main" id="{7D6EDBAE-BEC5-4ABB-BAE3-30CC1D39FA1D}"/>
                    </a:ext>
                  </a:extLst>
                </p:cNvPr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867" y="1678"/>
                  <a:ext cx="455" cy="37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60" name="Freeform 16">
                  <a:extLst>
                    <a:ext uri="{FF2B5EF4-FFF2-40B4-BE49-F238E27FC236}">
                      <a16:creationId xmlns:a16="http://schemas.microsoft.com/office/drawing/2014/main" id="{DD004898-60E0-46A2-A6D2-5FB4B749207B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881" y="1702"/>
                  <a:ext cx="422" cy="324"/>
                </a:xfrm>
                <a:custGeom>
                  <a:avLst/>
                  <a:gdLst>
                    <a:gd name="T0" fmla="*/ 175 w 175"/>
                    <a:gd name="T1" fmla="*/ 106 h 134"/>
                    <a:gd name="T2" fmla="*/ 30 w 175"/>
                    <a:gd name="T3" fmla="*/ 134 h 134"/>
                    <a:gd name="T4" fmla="*/ 30 w 175"/>
                    <a:gd name="T5" fmla="*/ 74 h 134"/>
                    <a:gd name="T6" fmla="*/ 63 w 175"/>
                    <a:gd name="T7" fmla="*/ 74 h 134"/>
                    <a:gd name="T8" fmla="*/ 78 w 175"/>
                    <a:gd name="T9" fmla="*/ 70 h 134"/>
                    <a:gd name="T10" fmla="*/ 63 w 175"/>
                    <a:gd name="T11" fmla="*/ 66 h 134"/>
                    <a:gd name="T12" fmla="*/ 26 w 175"/>
                    <a:gd name="T13" fmla="*/ 41 h 134"/>
                    <a:gd name="T14" fmla="*/ 68 w 175"/>
                    <a:gd name="T15" fmla="*/ 0 h 134"/>
                    <a:gd name="T16" fmla="*/ 115 w 175"/>
                    <a:gd name="T17" fmla="*/ 33 h 134"/>
                    <a:gd name="T18" fmla="*/ 142 w 175"/>
                    <a:gd name="T19" fmla="*/ 37 h 134"/>
                    <a:gd name="T20" fmla="*/ 153 w 175"/>
                    <a:gd name="T21" fmla="*/ 66 h 134"/>
                    <a:gd name="T22" fmla="*/ 123 w 175"/>
                    <a:gd name="T23" fmla="*/ 71 h 134"/>
                    <a:gd name="T24" fmla="*/ 123 w 175"/>
                    <a:gd name="T25" fmla="*/ 79 h 134"/>
                    <a:gd name="T26" fmla="*/ 141 w 175"/>
                    <a:gd name="T27" fmla="*/ 79 h 134"/>
                    <a:gd name="T28" fmla="*/ 143 w 175"/>
                    <a:gd name="T29" fmla="*/ 79 h 134"/>
                    <a:gd name="T30" fmla="*/ 148 w 175"/>
                    <a:gd name="T31" fmla="*/ 112 h 134"/>
                    <a:gd name="T32" fmla="*/ 131 w 175"/>
                    <a:gd name="T33" fmla="*/ 108 h 134"/>
                    <a:gd name="T34" fmla="*/ 131 w 175"/>
                    <a:gd name="T35" fmla="*/ 116 h 134"/>
                    <a:gd name="T36" fmla="*/ 148 w 175"/>
                    <a:gd name="T37" fmla="*/ 112 h 134"/>
                    <a:gd name="T38" fmla="*/ 120 w 175"/>
                    <a:gd name="T39" fmla="*/ 51 h 134"/>
                    <a:gd name="T40" fmla="*/ 103 w 175"/>
                    <a:gd name="T41" fmla="*/ 55 h 134"/>
                    <a:gd name="T42" fmla="*/ 120 w 175"/>
                    <a:gd name="T43" fmla="*/ 58 h 134"/>
                    <a:gd name="T44" fmla="*/ 109 w 175"/>
                    <a:gd name="T45" fmla="*/ 98 h 134"/>
                    <a:gd name="T46" fmla="*/ 92 w 175"/>
                    <a:gd name="T47" fmla="*/ 94 h 134"/>
                    <a:gd name="T48" fmla="*/ 92 w 175"/>
                    <a:gd name="T49" fmla="*/ 101 h 134"/>
                    <a:gd name="T50" fmla="*/ 109 w 175"/>
                    <a:gd name="T51" fmla="*/ 98 h 134"/>
                    <a:gd name="T52" fmla="*/ 80 w 175"/>
                    <a:gd name="T53" fmla="*/ 114 h 134"/>
                    <a:gd name="T54" fmla="*/ 63 w 175"/>
                    <a:gd name="T55" fmla="*/ 118 h 134"/>
                    <a:gd name="T56" fmla="*/ 80 w 175"/>
                    <a:gd name="T57" fmla="*/ 122 h 134"/>
                    <a:gd name="T58" fmla="*/ 72 w 175"/>
                    <a:gd name="T59" fmla="*/ 43 h 134"/>
                    <a:gd name="T60" fmla="*/ 55 w 175"/>
                    <a:gd name="T61" fmla="*/ 39 h 134"/>
                    <a:gd name="T62" fmla="*/ 55 w 175"/>
                    <a:gd name="T63" fmla="*/ 47 h 134"/>
                    <a:gd name="T64" fmla="*/ 72 w 175"/>
                    <a:gd name="T65" fmla="*/ 43 h 134"/>
                    <a:gd name="T66" fmla="*/ 47 w 175"/>
                    <a:gd name="T67" fmla="*/ 92 h 134"/>
                    <a:gd name="T68" fmla="*/ 30 w 175"/>
                    <a:gd name="T69" fmla="*/ 96 h 134"/>
                    <a:gd name="T70" fmla="*/ 47 w 175"/>
                    <a:gd name="T71" fmla="*/ 100 h 13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</a:cxnLst>
                  <a:rect l="0" t="0" r="r" b="b"/>
                  <a:pathLst>
                    <a:path w="175" h="134">
                      <a:moveTo>
                        <a:pt x="147" y="79"/>
                      </a:moveTo>
                      <a:cubicBezTo>
                        <a:pt x="163" y="79"/>
                        <a:pt x="175" y="91"/>
                        <a:pt x="175" y="106"/>
                      </a:cubicBezTo>
                      <a:cubicBezTo>
                        <a:pt x="175" y="122"/>
                        <a:pt x="163" y="134"/>
                        <a:pt x="147" y="134"/>
                      </a:cubicBezTo>
                      <a:cubicBezTo>
                        <a:pt x="30" y="134"/>
                        <a:pt x="30" y="134"/>
                        <a:pt x="30" y="134"/>
                      </a:cubicBezTo>
                      <a:cubicBezTo>
                        <a:pt x="14" y="134"/>
                        <a:pt x="0" y="121"/>
                        <a:pt x="0" y="104"/>
                      </a:cubicBezTo>
                      <a:cubicBezTo>
                        <a:pt x="0" y="88"/>
                        <a:pt x="14" y="74"/>
                        <a:pt x="30" y="74"/>
                      </a:cubicBezTo>
                      <a:cubicBezTo>
                        <a:pt x="51" y="74"/>
                        <a:pt x="51" y="74"/>
                        <a:pt x="51" y="74"/>
                      </a:cubicBezTo>
                      <a:cubicBezTo>
                        <a:pt x="63" y="74"/>
                        <a:pt x="63" y="74"/>
                        <a:pt x="63" y="74"/>
                      </a:cubicBezTo>
                      <a:cubicBezTo>
                        <a:pt x="74" y="74"/>
                        <a:pt x="74" y="74"/>
                        <a:pt x="74" y="74"/>
                      </a:cubicBezTo>
                      <a:cubicBezTo>
                        <a:pt x="76" y="74"/>
                        <a:pt x="78" y="72"/>
                        <a:pt x="78" y="70"/>
                      </a:cubicBezTo>
                      <a:cubicBezTo>
                        <a:pt x="78" y="68"/>
                        <a:pt x="76" y="66"/>
                        <a:pt x="74" y="66"/>
                      </a:cubicBezTo>
                      <a:cubicBezTo>
                        <a:pt x="63" y="66"/>
                        <a:pt x="63" y="66"/>
                        <a:pt x="63" y="66"/>
                      </a:cubicBezTo>
                      <a:cubicBezTo>
                        <a:pt x="51" y="66"/>
                        <a:pt x="51" y="66"/>
                        <a:pt x="51" y="66"/>
                      </a:cubicBezTo>
                      <a:cubicBezTo>
                        <a:pt x="37" y="66"/>
                        <a:pt x="26" y="55"/>
                        <a:pt x="26" y="41"/>
                      </a:cubicBezTo>
                      <a:cubicBezTo>
                        <a:pt x="26" y="33"/>
                        <a:pt x="30" y="25"/>
                        <a:pt x="37" y="21"/>
                      </a:cubicBezTo>
                      <a:cubicBezTo>
                        <a:pt x="68" y="0"/>
                        <a:pt x="68" y="0"/>
                        <a:pt x="68" y="0"/>
                      </a:cubicBezTo>
                      <a:cubicBezTo>
                        <a:pt x="73" y="5"/>
                        <a:pt x="73" y="5"/>
                        <a:pt x="73" y="5"/>
                      </a:cubicBezTo>
                      <a:cubicBezTo>
                        <a:pt x="84" y="19"/>
                        <a:pt x="99" y="28"/>
                        <a:pt x="115" y="33"/>
                      </a:cubicBezTo>
                      <a:cubicBezTo>
                        <a:pt x="115" y="33"/>
                        <a:pt x="115" y="33"/>
                        <a:pt x="115" y="33"/>
                      </a:cubicBezTo>
                      <a:cubicBezTo>
                        <a:pt x="124" y="36"/>
                        <a:pt x="133" y="37"/>
                        <a:pt x="142" y="37"/>
                      </a:cubicBezTo>
                      <a:cubicBezTo>
                        <a:pt x="151" y="37"/>
                        <a:pt x="158" y="45"/>
                        <a:pt x="158" y="54"/>
                      </a:cubicBezTo>
                      <a:cubicBezTo>
                        <a:pt x="158" y="59"/>
                        <a:pt x="157" y="63"/>
                        <a:pt x="153" y="66"/>
                      </a:cubicBezTo>
                      <a:cubicBezTo>
                        <a:pt x="150" y="69"/>
                        <a:pt x="147" y="71"/>
                        <a:pt x="142" y="71"/>
                      </a:cubicBezTo>
                      <a:cubicBezTo>
                        <a:pt x="123" y="71"/>
                        <a:pt x="123" y="71"/>
                        <a:pt x="123" y="71"/>
                      </a:cubicBezTo>
                      <a:cubicBezTo>
                        <a:pt x="121" y="71"/>
                        <a:pt x="119" y="73"/>
                        <a:pt x="119" y="75"/>
                      </a:cubicBezTo>
                      <a:cubicBezTo>
                        <a:pt x="119" y="77"/>
                        <a:pt x="121" y="79"/>
                        <a:pt x="123" y="79"/>
                      </a:cubicBezTo>
                      <a:cubicBezTo>
                        <a:pt x="130" y="79"/>
                        <a:pt x="130" y="79"/>
                        <a:pt x="130" y="79"/>
                      </a:cubicBezTo>
                      <a:cubicBezTo>
                        <a:pt x="141" y="79"/>
                        <a:pt x="141" y="79"/>
                        <a:pt x="141" y="79"/>
                      </a:cubicBezTo>
                      <a:cubicBezTo>
                        <a:pt x="141" y="79"/>
                        <a:pt x="142" y="79"/>
                        <a:pt x="142" y="79"/>
                      </a:cubicBezTo>
                      <a:cubicBezTo>
                        <a:pt x="142" y="79"/>
                        <a:pt x="143" y="79"/>
                        <a:pt x="143" y="79"/>
                      </a:cubicBezTo>
                      <a:lnTo>
                        <a:pt x="147" y="79"/>
                      </a:lnTo>
                      <a:close/>
                      <a:moveTo>
                        <a:pt x="148" y="112"/>
                      </a:moveTo>
                      <a:cubicBezTo>
                        <a:pt x="148" y="110"/>
                        <a:pt x="147" y="108"/>
                        <a:pt x="144" y="108"/>
                      </a:cubicBezTo>
                      <a:cubicBezTo>
                        <a:pt x="131" y="108"/>
                        <a:pt x="131" y="108"/>
                        <a:pt x="131" y="108"/>
                      </a:cubicBezTo>
                      <a:cubicBezTo>
                        <a:pt x="129" y="108"/>
                        <a:pt x="127" y="110"/>
                        <a:pt x="127" y="112"/>
                      </a:cubicBezTo>
                      <a:cubicBezTo>
                        <a:pt x="127" y="114"/>
                        <a:pt x="129" y="116"/>
                        <a:pt x="131" y="116"/>
                      </a:cubicBezTo>
                      <a:cubicBezTo>
                        <a:pt x="144" y="116"/>
                        <a:pt x="144" y="116"/>
                        <a:pt x="144" y="116"/>
                      </a:cubicBezTo>
                      <a:cubicBezTo>
                        <a:pt x="147" y="116"/>
                        <a:pt x="148" y="114"/>
                        <a:pt x="148" y="112"/>
                      </a:cubicBezTo>
                      <a:close/>
                      <a:moveTo>
                        <a:pt x="124" y="55"/>
                      </a:moveTo>
                      <a:cubicBezTo>
                        <a:pt x="124" y="52"/>
                        <a:pt x="123" y="51"/>
                        <a:pt x="120" y="51"/>
                      </a:cubicBezTo>
                      <a:cubicBezTo>
                        <a:pt x="107" y="51"/>
                        <a:pt x="107" y="51"/>
                        <a:pt x="107" y="51"/>
                      </a:cubicBezTo>
                      <a:cubicBezTo>
                        <a:pt x="105" y="51"/>
                        <a:pt x="103" y="52"/>
                        <a:pt x="103" y="55"/>
                      </a:cubicBezTo>
                      <a:cubicBezTo>
                        <a:pt x="103" y="57"/>
                        <a:pt x="105" y="58"/>
                        <a:pt x="107" y="58"/>
                      </a:cubicBezTo>
                      <a:cubicBezTo>
                        <a:pt x="120" y="58"/>
                        <a:pt x="120" y="58"/>
                        <a:pt x="120" y="58"/>
                      </a:cubicBezTo>
                      <a:cubicBezTo>
                        <a:pt x="123" y="58"/>
                        <a:pt x="124" y="57"/>
                        <a:pt x="124" y="55"/>
                      </a:cubicBezTo>
                      <a:close/>
                      <a:moveTo>
                        <a:pt x="109" y="98"/>
                      </a:moveTo>
                      <a:cubicBezTo>
                        <a:pt x="109" y="95"/>
                        <a:pt x="107" y="94"/>
                        <a:pt x="105" y="94"/>
                      </a:cubicBezTo>
                      <a:cubicBezTo>
                        <a:pt x="92" y="94"/>
                        <a:pt x="92" y="94"/>
                        <a:pt x="92" y="94"/>
                      </a:cubicBezTo>
                      <a:cubicBezTo>
                        <a:pt x="90" y="94"/>
                        <a:pt x="88" y="95"/>
                        <a:pt x="88" y="98"/>
                      </a:cubicBezTo>
                      <a:cubicBezTo>
                        <a:pt x="88" y="100"/>
                        <a:pt x="90" y="101"/>
                        <a:pt x="92" y="101"/>
                      </a:cubicBezTo>
                      <a:cubicBezTo>
                        <a:pt x="105" y="101"/>
                        <a:pt x="105" y="101"/>
                        <a:pt x="105" y="101"/>
                      </a:cubicBezTo>
                      <a:cubicBezTo>
                        <a:pt x="107" y="101"/>
                        <a:pt x="109" y="100"/>
                        <a:pt x="109" y="98"/>
                      </a:cubicBezTo>
                      <a:close/>
                      <a:moveTo>
                        <a:pt x="84" y="118"/>
                      </a:moveTo>
                      <a:cubicBezTo>
                        <a:pt x="84" y="116"/>
                        <a:pt x="82" y="114"/>
                        <a:pt x="80" y="114"/>
                      </a:cubicBezTo>
                      <a:cubicBezTo>
                        <a:pt x="67" y="114"/>
                        <a:pt x="67" y="114"/>
                        <a:pt x="67" y="114"/>
                      </a:cubicBezTo>
                      <a:cubicBezTo>
                        <a:pt x="64" y="114"/>
                        <a:pt x="63" y="116"/>
                        <a:pt x="63" y="118"/>
                      </a:cubicBezTo>
                      <a:cubicBezTo>
                        <a:pt x="63" y="120"/>
                        <a:pt x="64" y="122"/>
                        <a:pt x="67" y="122"/>
                      </a:cubicBezTo>
                      <a:cubicBezTo>
                        <a:pt x="80" y="122"/>
                        <a:pt x="80" y="122"/>
                        <a:pt x="80" y="122"/>
                      </a:cubicBezTo>
                      <a:cubicBezTo>
                        <a:pt x="82" y="122"/>
                        <a:pt x="84" y="120"/>
                        <a:pt x="84" y="118"/>
                      </a:cubicBezTo>
                      <a:close/>
                      <a:moveTo>
                        <a:pt x="72" y="43"/>
                      </a:moveTo>
                      <a:cubicBezTo>
                        <a:pt x="72" y="41"/>
                        <a:pt x="70" y="39"/>
                        <a:pt x="68" y="39"/>
                      </a:cubicBezTo>
                      <a:cubicBezTo>
                        <a:pt x="55" y="39"/>
                        <a:pt x="55" y="39"/>
                        <a:pt x="55" y="39"/>
                      </a:cubicBezTo>
                      <a:cubicBezTo>
                        <a:pt x="53" y="39"/>
                        <a:pt x="51" y="41"/>
                        <a:pt x="51" y="43"/>
                      </a:cubicBezTo>
                      <a:cubicBezTo>
                        <a:pt x="51" y="45"/>
                        <a:pt x="53" y="47"/>
                        <a:pt x="55" y="47"/>
                      </a:cubicBezTo>
                      <a:cubicBezTo>
                        <a:pt x="68" y="47"/>
                        <a:pt x="68" y="47"/>
                        <a:pt x="68" y="47"/>
                      </a:cubicBezTo>
                      <a:cubicBezTo>
                        <a:pt x="70" y="47"/>
                        <a:pt x="72" y="45"/>
                        <a:pt x="72" y="43"/>
                      </a:cubicBezTo>
                      <a:close/>
                      <a:moveTo>
                        <a:pt x="50" y="96"/>
                      </a:moveTo>
                      <a:cubicBezTo>
                        <a:pt x="50" y="94"/>
                        <a:pt x="49" y="92"/>
                        <a:pt x="47" y="92"/>
                      </a:cubicBezTo>
                      <a:cubicBezTo>
                        <a:pt x="33" y="92"/>
                        <a:pt x="33" y="92"/>
                        <a:pt x="33" y="92"/>
                      </a:cubicBezTo>
                      <a:cubicBezTo>
                        <a:pt x="31" y="92"/>
                        <a:pt x="30" y="94"/>
                        <a:pt x="30" y="96"/>
                      </a:cubicBezTo>
                      <a:cubicBezTo>
                        <a:pt x="30" y="98"/>
                        <a:pt x="31" y="100"/>
                        <a:pt x="33" y="100"/>
                      </a:cubicBezTo>
                      <a:cubicBezTo>
                        <a:pt x="47" y="100"/>
                        <a:pt x="47" y="100"/>
                        <a:pt x="47" y="100"/>
                      </a:cubicBezTo>
                      <a:cubicBezTo>
                        <a:pt x="49" y="100"/>
                        <a:pt x="50" y="98"/>
                        <a:pt x="50" y="96"/>
                      </a:cubicBezTo>
                      <a:close/>
                    </a:path>
                  </a:pathLst>
                </a:custGeom>
                <a:solidFill>
                  <a:srgbClr val="E09D3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61" name="Freeform 17">
                  <a:extLst>
                    <a:ext uri="{FF2B5EF4-FFF2-40B4-BE49-F238E27FC236}">
                      <a16:creationId xmlns:a16="http://schemas.microsoft.com/office/drawing/2014/main" id="{548F87E4-41C5-420C-9123-FBA6BCC91B5D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864" y="1678"/>
                  <a:ext cx="458" cy="368"/>
                </a:xfrm>
                <a:custGeom>
                  <a:avLst/>
                  <a:gdLst>
                    <a:gd name="T0" fmla="*/ 129 w 190"/>
                    <a:gd name="T1" fmla="*/ 37 h 152"/>
                    <a:gd name="T2" fmla="*/ 149 w 190"/>
                    <a:gd name="T3" fmla="*/ 40 h 152"/>
                    <a:gd name="T4" fmla="*/ 173 w 190"/>
                    <a:gd name="T5" fmla="*/ 64 h 152"/>
                    <a:gd name="T6" fmla="*/ 166 w 190"/>
                    <a:gd name="T7" fmla="*/ 82 h 152"/>
                    <a:gd name="T8" fmla="*/ 165 w 190"/>
                    <a:gd name="T9" fmla="*/ 82 h 152"/>
                    <a:gd name="T10" fmla="*/ 190 w 190"/>
                    <a:gd name="T11" fmla="*/ 116 h 152"/>
                    <a:gd name="T12" fmla="*/ 154 w 190"/>
                    <a:gd name="T13" fmla="*/ 152 h 152"/>
                    <a:gd name="T14" fmla="*/ 37 w 190"/>
                    <a:gd name="T15" fmla="*/ 152 h 152"/>
                    <a:gd name="T16" fmla="*/ 0 w 190"/>
                    <a:gd name="T17" fmla="*/ 114 h 152"/>
                    <a:gd name="T18" fmla="*/ 37 w 190"/>
                    <a:gd name="T19" fmla="*/ 76 h 152"/>
                    <a:gd name="T20" fmla="*/ 25 w 190"/>
                    <a:gd name="T21" fmla="*/ 51 h 152"/>
                    <a:gd name="T22" fmla="*/ 40 w 190"/>
                    <a:gd name="T23" fmla="*/ 24 h 152"/>
                    <a:gd name="T24" fmla="*/ 74 w 190"/>
                    <a:gd name="T25" fmla="*/ 1 h 152"/>
                    <a:gd name="T26" fmla="*/ 79 w 190"/>
                    <a:gd name="T27" fmla="*/ 2 h 152"/>
                    <a:gd name="T28" fmla="*/ 86 w 190"/>
                    <a:gd name="T29" fmla="*/ 10 h 152"/>
                    <a:gd name="T30" fmla="*/ 121 w 190"/>
                    <a:gd name="T31" fmla="*/ 35 h 152"/>
                    <a:gd name="T32" fmla="*/ 182 w 190"/>
                    <a:gd name="T33" fmla="*/ 116 h 152"/>
                    <a:gd name="T34" fmla="*/ 154 w 190"/>
                    <a:gd name="T35" fmla="*/ 89 h 152"/>
                    <a:gd name="T36" fmla="*/ 150 w 190"/>
                    <a:gd name="T37" fmla="*/ 89 h 152"/>
                    <a:gd name="T38" fmla="*/ 149 w 190"/>
                    <a:gd name="T39" fmla="*/ 89 h 152"/>
                    <a:gd name="T40" fmla="*/ 148 w 190"/>
                    <a:gd name="T41" fmla="*/ 89 h 152"/>
                    <a:gd name="T42" fmla="*/ 137 w 190"/>
                    <a:gd name="T43" fmla="*/ 89 h 152"/>
                    <a:gd name="T44" fmla="*/ 130 w 190"/>
                    <a:gd name="T45" fmla="*/ 89 h 152"/>
                    <a:gd name="T46" fmla="*/ 126 w 190"/>
                    <a:gd name="T47" fmla="*/ 85 h 152"/>
                    <a:gd name="T48" fmla="*/ 130 w 190"/>
                    <a:gd name="T49" fmla="*/ 81 h 152"/>
                    <a:gd name="T50" fmla="*/ 149 w 190"/>
                    <a:gd name="T51" fmla="*/ 81 h 152"/>
                    <a:gd name="T52" fmla="*/ 160 w 190"/>
                    <a:gd name="T53" fmla="*/ 76 h 152"/>
                    <a:gd name="T54" fmla="*/ 165 w 190"/>
                    <a:gd name="T55" fmla="*/ 64 h 152"/>
                    <a:gd name="T56" fmla="*/ 149 w 190"/>
                    <a:gd name="T57" fmla="*/ 47 h 152"/>
                    <a:gd name="T58" fmla="*/ 122 w 190"/>
                    <a:gd name="T59" fmla="*/ 43 h 152"/>
                    <a:gd name="T60" fmla="*/ 122 w 190"/>
                    <a:gd name="T61" fmla="*/ 43 h 152"/>
                    <a:gd name="T62" fmla="*/ 80 w 190"/>
                    <a:gd name="T63" fmla="*/ 15 h 152"/>
                    <a:gd name="T64" fmla="*/ 75 w 190"/>
                    <a:gd name="T65" fmla="*/ 10 h 152"/>
                    <a:gd name="T66" fmla="*/ 44 w 190"/>
                    <a:gd name="T67" fmla="*/ 31 h 152"/>
                    <a:gd name="T68" fmla="*/ 33 w 190"/>
                    <a:gd name="T69" fmla="*/ 51 h 152"/>
                    <a:gd name="T70" fmla="*/ 58 w 190"/>
                    <a:gd name="T71" fmla="*/ 76 h 152"/>
                    <a:gd name="T72" fmla="*/ 70 w 190"/>
                    <a:gd name="T73" fmla="*/ 76 h 152"/>
                    <a:gd name="T74" fmla="*/ 81 w 190"/>
                    <a:gd name="T75" fmla="*/ 76 h 152"/>
                    <a:gd name="T76" fmla="*/ 85 w 190"/>
                    <a:gd name="T77" fmla="*/ 80 h 152"/>
                    <a:gd name="T78" fmla="*/ 81 w 190"/>
                    <a:gd name="T79" fmla="*/ 84 h 152"/>
                    <a:gd name="T80" fmla="*/ 70 w 190"/>
                    <a:gd name="T81" fmla="*/ 84 h 152"/>
                    <a:gd name="T82" fmla="*/ 58 w 190"/>
                    <a:gd name="T83" fmla="*/ 84 h 152"/>
                    <a:gd name="T84" fmla="*/ 37 w 190"/>
                    <a:gd name="T85" fmla="*/ 84 h 152"/>
                    <a:gd name="T86" fmla="*/ 7 w 190"/>
                    <a:gd name="T87" fmla="*/ 114 h 152"/>
                    <a:gd name="T88" fmla="*/ 37 w 190"/>
                    <a:gd name="T89" fmla="*/ 144 h 152"/>
                    <a:gd name="T90" fmla="*/ 154 w 190"/>
                    <a:gd name="T91" fmla="*/ 144 h 152"/>
                    <a:gd name="T92" fmla="*/ 182 w 190"/>
                    <a:gd name="T93" fmla="*/ 116 h 15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</a:cxnLst>
                  <a:rect l="0" t="0" r="r" b="b"/>
                  <a:pathLst>
                    <a:path w="190" h="152">
                      <a:moveTo>
                        <a:pt x="129" y="37"/>
                      </a:moveTo>
                      <a:cubicBezTo>
                        <a:pt x="136" y="39"/>
                        <a:pt x="142" y="40"/>
                        <a:pt x="149" y="40"/>
                      </a:cubicBezTo>
                      <a:cubicBezTo>
                        <a:pt x="162" y="40"/>
                        <a:pt x="173" y="51"/>
                        <a:pt x="173" y="64"/>
                      </a:cubicBezTo>
                      <a:cubicBezTo>
                        <a:pt x="173" y="71"/>
                        <a:pt x="171" y="77"/>
                        <a:pt x="166" y="82"/>
                      </a:cubicBezTo>
                      <a:cubicBezTo>
                        <a:pt x="166" y="82"/>
                        <a:pt x="165" y="82"/>
                        <a:pt x="165" y="82"/>
                      </a:cubicBezTo>
                      <a:cubicBezTo>
                        <a:pt x="179" y="87"/>
                        <a:pt x="190" y="100"/>
                        <a:pt x="190" y="116"/>
                      </a:cubicBezTo>
                      <a:cubicBezTo>
                        <a:pt x="190" y="136"/>
                        <a:pt x="174" y="152"/>
                        <a:pt x="154" y="152"/>
                      </a:cubicBezTo>
                      <a:cubicBezTo>
                        <a:pt x="37" y="152"/>
                        <a:pt x="37" y="152"/>
                        <a:pt x="37" y="152"/>
                      </a:cubicBezTo>
                      <a:cubicBezTo>
                        <a:pt x="17" y="152"/>
                        <a:pt x="0" y="135"/>
                        <a:pt x="0" y="114"/>
                      </a:cubicBezTo>
                      <a:cubicBezTo>
                        <a:pt x="0" y="94"/>
                        <a:pt x="16" y="77"/>
                        <a:pt x="37" y="76"/>
                      </a:cubicBezTo>
                      <a:cubicBezTo>
                        <a:pt x="29" y="70"/>
                        <a:pt x="25" y="61"/>
                        <a:pt x="25" y="51"/>
                      </a:cubicBezTo>
                      <a:cubicBezTo>
                        <a:pt x="25" y="40"/>
                        <a:pt x="30" y="30"/>
                        <a:pt x="40" y="24"/>
                      </a:cubicBezTo>
                      <a:cubicBezTo>
                        <a:pt x="74" y="1"/>
                        <a:pt x="74" y="1"/>
                        <a:pt x="74" y="1"/>
                      </a:cubicBezTo>
                      <a:cubicBezTo>
                        <a:pt x="76" y="0"/>
                        <a:pt x="78" y="1"/>
                        <a:pt x="79" y="2"/>
                      </a:cubicBezTo>
                      <a:cubicBezTo>
                        <a:pt x="86" y="10"/>
                        <a:pt x="86" y="10"/>
                        <a:pt x="86" y="10"/>
                      </a:cubicBezTo>
                      <a:cubicBezTo>
                        <a:pt x="96" y="22"/>
                        <a:pt x="108" y="30"/>
                        <a:pt x="121" y="35"/>
                      </a:cubicBezTo>
                      <a:moveTo>
                        <a:pt x="182" y="116"/>
                      </a:moveTo>
                      <a:cubicBezTo>
                        <a:pt x="182" y="101"/>
                        <a:pt x="170" y="89"/>
                        <a:pt x="154" y="89"/>
                      </a:cubicBezTo>
                      <a:cubicBezTo>
                        <a:pt x="150" y="89"/>
                        <a:pt x="150" y="89"/>
                        <a:pt x="150" y="89"/>
                      </a:cubicBezTo>
                      <a:cubicBezTo>
                        <a:pt x="150" y="89"/>
                        <a:pt x="149" y="89"/>
                        <a:pt x="149" y="89"/>
                      </a:cubicBezTo>
                      <a:cubicBezTo>
                        <a:pt x="149" y="89"/>
                        <a:pt x="148" y="89"/>
                        <a:pt x="148" y="89"/>
                      </a:cubicBezTo>
                      <a:cubicBezTo>
                        <a:pt x="137" y="89"/>
                        <a:pt x="137" y="89"/>
                        <a:pt x="137" y="89"/>
                      </a:cubicBezTo>
                      <a:cubicBezTo>
                        <a:pt x="130" y="89"/>
                        <a:pt x="130" y="89"/>
                        <a:pt x="130" y="89"/>
                      </a:cubicBezTo>
                      <a:cubicBezTo>
                        <a:pt x="128" y="89"/>
                        <a:pt x="126" y="87"/>
                        <a:pt x="126" y="85"/>
                      </a:cubicBezTo>
                      <a:cubicBezTo>
                        <a:pt x="126" y="83"/>
                        <a:pt x="128" y="81"/>
                        <a:pt x="130" y="81"/>
                      </a:cubicBezTo>
                      <a:cubicBezTo>
                        <a:pt x="149" y="81"/>
                        <a:pt x="149" y="81"/>
                        <a:pt x="149" y="81"/>
                      </a:cubicBezTo>
                      <a:cubicBezTo>
                        <a:pt x="154" y="81"/>
                        <a:pt x="157" y="79"/>
                        <a:pt x="160" y="76"/>
                      </a:cubicBezTo>
                      <a:cubicBezTo>
                        <a:pt x="164" y="73"/>
                        <a:pt x="165" y="69"/>
                        <a:pt x="165" y="64"/>
                      </a:cubicBezTo>
                      <a:cubicBezTo>
                        <a:pt x="165" y="55"/>
                        <a:pt x="158" y="47"/>
                        <a:pt x="149" y="47"/>
                      </a:cubicBezTo>
                      <a:cubicBezTo>
                        <a:pt x="140" y="47"/>
                        <a:pt x="131" y="46"/>
                        <a:pt x="122" y="43"/>
                      </a:cubicBezTo>
                      <a:cubicBezTo>
                        <a:pt x="122" y="43"/>
                        <a:pt x="122" y="43"/>
                        <a:pt x="122" y="43"/>
                      </a:cubicBezTo>
                      <a:cubicBezTo>
                        <a:pt x="106" y="38"/>
                        <a:pt x="91" y="29"/>
                        <a:pt x="80" y="15"/>
                      </a:cubicBezTo>
                      <a:cubicBezTo>
                        <a:pt x="75" y="10"/>
                        <a:pt x="75" y="10"/>
                        <a:pt x="75" y="10"/>
                      </a:cubicBezTo>
                      <a:cubicBezTo>
                        <a:pt x="44" y="31"/>
                        <a:pt x="44" y="31"/>
                        <a:pt x="44" y="31"/>
                      </a:cubicBezTo>
                      <a:cubicBezTo>
                        <a:pt x="37" y="35"/>
                        <a:pt x="33" y="43"/>
                        <a:pt x="33" y="51"/>
                      </a:cubicBezTo>
                      <a:cubicBezTo>
                        <a:pt x="33" y="65"/>
                        <a:pt x="44" y="76"/>
                        <a:pt x="58" y="76"/>
                      </a:cubicBezTo>
                      <a:cubicBezTo>
                        <a:pt x="70" y="76"/>
                        <a:pt x="70" y="76"/>
                        <a:pt x="70" y="76"/>
                      </a:cubicBezTo>
                      <a:cubicBezTo>
                        <a:pt x="81" y="76"/>
                        <a:pt x="81" y="76"/>
                        <a:pt x="81" y="76"/>
                      </a:cubicBezTo>
                      <a:cubicBezTo>
                        <a:pt x="83" y="76"/>
                        <a:pt x="85" y="78"/>
                        <a:pt x="85" y="80"/>
                      </a:cubicBezTo>
                      <a:cubicBezTo>
                        <a:pt x="85" y="82"/>
                        <a:pt x="83" y="84"/>
                        <a:pt x="81" y="84"/>
                      </a:cubicBezTo>
                      <a:cubicBezTo>
                        <a:pt x="70" y="84"/>
                        <a:pt x="70" y="84"/>
                        <a:pt x="70" y="84"/>
                      </a:cubicBezTo>
                      <a:cubicBezTo>
                        <a:pt x="58" y="84"/>
                        <a:pt x="58" y="84"/>
                        <a:pt x="58" y="84"/>
                      </a:cubicBezTo>
                      <a:cubicBezTo>
                        <a:pt x="37" y="84"/>
                        <a:pt x="37" y="84"/>
                        <a:pt x="37" y="84"/>
                      </a:cubicBezTo>
                      <a:cubicBezTo>
                        <a:pt x="21" y="84"/>
                        <a:pt x="7" y="98"/>
                        <a:pt x="7" y="114"/>
                      </a:cubicBezTo>
                      <a:cubicBezTo>
                        <a:pt x="7" y="131"/>
                        <a:pt x="21" y="144"/>
                        <a:pt x="37" y="144"/>
                      </a:cubicBezTo>
                      <a:cubicBezTo>
                        <a:pt x="154" y="144"/>
                        <a:pt x="154" y="144"/>
                        <a:pt x="154" y="144"/>
                      </a:cubicBezTo>
                      <a:cubicBezTo>
                        <a:pt x="170" y="144"/>
                        <a:pt x="182" y="132"/>
                        <a:pt x="182" y="116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62" name="Freeform 18">
                  <a:extLst>
                    <a:ext uri="{FF2B5EF4-FFF2-40B4-BE49-F238E27FC236}">
                      <a16:creationId xmlns:a16="http://schemas.microsoft.com/office/drawing/2014/main" id="{370ECE75-0CDB-4229-9720-42E5EAB0D78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187" y="1963"/>
                  <a:ext cx="51" cy="20"/>
                </a:xfrm>
                <a:custGeom>
                  <a:avLst/>
                  <a:gdLst>
                    <a:gd name="T0" fmla="*/ 17 w 21"/>
                    <a:gd name="T1" fmla="*/ 0 h 8"/>
                    <a:gd name="T2" fmla="*/ 21 w 21"/>
                    <a:gd name="T3" fmla="*/ 4 h 8"/>
                    <a:gd name="T4" fmla="*/ 17 w 21"/>
                    <a:gd name="T5" fmla="*/ 8 h 8"/>
                    <a:gd name="T6" fmla="*/ 4 w 21"/>
                    <a:gd name="T7" fmla="*/ 8 h 8"/>
                    <a:gd name="T8" fmla="*/ 0 w 21"/>
                    <a:gd name="T9" fmla="*/ 4 h 8"/>
                    <a:gd name="T10" fmla="*/ 4 w 21"/>
                    <a:gd name="T11" fmla="*/ 0 h 8"/>
                    <a:gd name="T12" fmla="*/ 17 w 21"/>
                    <a:gd name="T13" fmla="*/ 0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1" h="8">
                      <a:moveTo>
                        <a:pt x="17" y="0"/>
                      </a:moveTo>
                      <a:cubicBezTo>
                        <a:pt x="20" y="0"/>
                        <a:pt x="21" y="2"/>
                        <a:pt x="21" y="4"/>
                      </a:cubicBezTo>
                      <a:cubicBezTo>
                        <a:pt x="21" y="6"/>
                        <a:pt x="20" y="8"/>
                        <a:pt x="17" y="8"/>
                      </a:cubicBezTo>
                      <a:cubicBezTo>
                        <a:pt x="4" y="8"/>
                        <a:pt x="4" y="8"/>
                        <a:pt x="4" y="8"/>
                      </a:cubicBezTo>
                      <a:cubicBezTo>
                        <a:pt x="2" y="8"/>
                        <a:pt x="0" y="6"/>
                        <a:pt x="0" y="4"/>
                      </a:cubicBezTo>
                      <a:cubicBezTo>
                        <a:pt x="0" y="2"/>
                        <a:pt x="2" y="0"/>
                        <a:pt x="4" y="0"/>
                      </a:cubicBez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63" name="Freeform 19">
                  <a:extLst>
                    <a:ext uri="{FF2B5EF4-FFF2-40B4-BE49-F238E27FC236}">
                      <a16:creationId xmlns:a16="http://schemas.microsoft.com/office/drawing/2014/main" id="{74D76834-E34F-48BF-AD04-F4957588FBF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129" y="1825"/>
                  <a:ext cx="51" cy="17"/>
                </a:xfrm>
                <a:custGeom>
                  <a:avLst/>
                  <a:gdLst>
                    <a:gd name="T0" fmla="*/ 17 w 21"/>
                    <a:gd name="T1" fmla="*/ 0 h 7"/>
                    <a:gd name="T2" fmla="*/ 21 w 21"/>
                    <a:gd name="T3" fmla="*/ 4 h 7"/>
                    <a:gd name="T4" fmla="*/ 17 w 21"/>
                    <a:gd name="T5" fmla="*/ 7 h 7"/>
                    <a:gd name="T6" fmla="*/ 4 w 21"/>
                    <a:gd name="T7" fmla="*/ 7 h 7"/>
                    <a:gd name="T8" fmla="*/ 0 w 21"/>
                    <a:gd name="T9" fmla="*/ 4 h 7"/>
                    <a:gd name="T10" fmla="*/ 4 w 21"/>
                    <a:gd name="T11" fmla="*/ 0 h 7"/>
                    <a:gd name="T12" fmla="*/ 17 w 21"/>
                    <a:gd name="T13" fmla="*/ 0 h 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1" h="7">
                      <a:moveTo>
                        <a:pt x="17" y="0"/>
                      </a:moveTo>
                      <a:cubicBezTo>
                        <a:pt x="20" y="0"/>
                        <a:pt x="21" y="1"/>
                        <a:pt x="21" y="4"/>
                      </a:cubicBezTo>
                      <a:cubicBezTo>
                        <a:pt x="21" y="6"/>
                        <a:pt x="20" y="7"/>
                        <a:pt x="17" y="7"/>
                      </a:cubicBezTo>
                      <a:cubicBezTo>
                        <a:pt x="4" y="7"/>
                        <a:pt x="4" y="7"/>
                        <a:pt x="4" y="7"/>
                      </a:cubicBezTo>
                      <a:cubicBezTo>
                        <a:pt x="2" y="7"/>
                        <a:pt x="0" y="6"/>
                        <a:pt x="0" y="4"/>
                      </a:cubicBezTo>
                      <a:cubicBezTo>
                        <a:pt x="0" y="1"/>
                        <a:pt x="2" y="0"/>
                        <a:pt x="4" y="0"/>
                      </a:cubicBez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64" name="Freeform 20">
                  <a:extLst>
                    <a:ext uri="{FF2B5EF4-FFF2-40B4-BE49-F238E27FC236}">
                      <a16:creationId xmlns:a16="http://schemas.microsoft.com/office/drawing/2014/main" id="{F8360811-EEB7-47F2-8A33-00AA910DEFD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93" y="1930"/>
                  <a:ext cx="51" cy="16"/>
                </a:xfrm>
                <a:custGeom>
                  <a:avLst/>
                  <a:gdLst>
                    <a:gd name="T0" fmla="*/ 17 w 21"/>
                    <a:gd name="T1" fmla="*/ 0 h 7"/>
                    <a:gd name="T2" fmla="*/ 21 w 21"/>
                    <a:gd name="T3" fmla="*/ 4 h 7"/>
                    <a:gd name="T4" fmla="*/ 17 w 21"/>
                    <a:gd name="T5" fmla="*/ 7 h 7"/>
                    <a:gd name="T6" fmla="*/ 4 w 21"/>
                    <a:gd name="T7" fmla="*/ 7 h 7"/>
                    <a:gd name="T8" fmla="*/ 0 w 21"/>
                    <a:gd name="T9" fmla="*/ 4 h 7"/>
                    <a:gd name="T10" fmla="*/ 4 w 21"/>
                    <a:gd name="T11" fmla="*/ 0 h 7"/>
                    <a:gd name="T12" fmla="*/ 17 w 21"/>
                    <a:gd name="T13" fmla="*/ 0 h 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1" h="7">
                      <a:moveTo>
                        <a:pt x="17" y="0"/>
                      </a:moveTo>
                      <a:cubicBezTo>
                        <a:pt x="19" y="0"/>
                        <a:pt x="21" y="1"/>
                        <a:pt x="21" y="4"/>
                      </a:cubicBezTo>
                      <a:cubicBezTo>
                        <a:pt x="21" y="6"/>
                        <a:pt x="19" y="7"/>
                        <a:pt x="17" y="7"/>
                      </a:cubicBezTo>
                      <a:cubicBezTo>
                        <a:pt x="4" y="7"/>
                        <a:pt x="4" y="7"/>
                        <a:pt x="4" y="7"/>
                      </a:cubicBezTo>
                      <a:cubicBezTo>
                        <a:pt x="2" y="7"/>
                        <a:pt x="0" y="6"/>
                        <a:pt x="0" y="4"/>
                      </a:cubicBezTo>
                      <a:cubicBezTo>
                        <a:pt x="0" y="1"/>
                        <a:pt x="2" y="0"/>
                        <a:pt x="4" y="0"/>
                      </a:cubicBez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65" name="Freeform 21">
                  <a:extLst>
                    <a:ext uri="{FF2B5EF4-FFF2-40B4-BE49-F238E27FC236}">
                      <a16:creationId xmlns:a16="http://schemas.microsoft.com/office/drawing/2014/main" id="{0DF1C27B-8BAE-4118-8E48-12AB3F42E65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33" y="1978"/>
                  <a:ext cx="51" cy="19"/>
                </a:xfrm>
                <a:custGeom>
                  <a:avLst/>
                  <a:gdLst>
                    <a:gd name="T0" fmla="*/ 17 w 21"/>
                    <a:gd name="T1" fmla="*/ 0 h 8"/>
                    <a:gd name="T2" fmla="*/ 21 w 21"/>
                    <a:gd name="T3" fmla="*/ 4 h 8"/>
                    <a:gd name="T4" fmla="*/ 17 w 21"/>
                    <a:gd name="T5" fmla="*/ 8 h 8"/>
                    <a:gd name="T6" fmla="*/ 4 w 21"/>
                    <a:gd name="T7" fmla="*/ 8 h 8"/>
                    <a:gd name="T8" fmla="*/ 0 w 21"/>
                    <a:gd name="T9" fmla="*/ 4 h 8"/>
                    <a:gd name="T10" fmla="*/ 4 w 21"/>
                    <a:gd name="T11" fmla="*/ 0 h 8"/>
                    <a:gd name="T12" fmla="*/ 17 w 21"/>
                    <a:gd name="T13" fmla="*/ 0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1" h="8">
                      <a:moveTo>
                        <a:pt x="17" y="0"/>
                      </a:moveTo>
                      <a:cubicBezTo>
                        <a:pt x="19" y="0"/>
                        <a:pt x="21" y="2"/>
                        <a:pt x="21" y="4"/>
                      </a:cubicBezTo>
                      <a:cubicBezTo>
                        <a:pt x="21" y="6"/>
                        <a:pt x="19" y="8"/>
                        <a:pt x="17" y="8"/>
                      </a:cubicBezTo>
                      <a:cubicBezTo>
                        <a:pt x="4" y="8"/>
                        <a:pt x="4" y="8"/>
                        <a:pt x="4" y="8"/>
                      </a:cubicBezTo>
                      <a:cubicBezTo>
                        <a:pt x="1" y="8"/>
                        <a:pt x="0" y="6"/>
                        <a:pt x="0" y="4"/>
                      </a:cubicBezTo>
                      <a:cubicBezTo>
                        <a:pt x="0" y="2"/>
                        <a:pt x="1" y="0"/>
                        <a:pt x="4" y="0"/>
                      </a:cubicBez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66" name="Freeform 22">
                  <a:extLst>
                    <a:ext uri="{FF2B5EF4-FFF2-40B4-BE49-F238E27FC236}">
                      <a16:creationId xmlns:a16="http://schemas.microsoft.com/office/drawing/2014/main" id="{FB8805E0-4ECC-4D44-B1D9-77B61E8B6DF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04" y="1796"/>
                  <a:ext cx="51" cy="20"/>
                </a:xfrm>
                <a:custGeom>
                  <a:avLst/>
                  <a:gdLst>
                    <a:gd name="T0" fmla="*/ 17 w 21"/>
                    <a:gd name="T1" fmla="*/ 0 h 8"/>
                    <a:gd name="T2" fmla="*/ 21 w 21"/>
                    <a:gd name="T3" fmla="*/ 4 h 8"/>
                    <a:gd name="T4" fmla="*/ 17 w 21"/>
                    <a:gd name="T5" fmla="*/ 8 h 8"/>
                    <a:gd name="T6" fmla="*/ 4 w 21"/>
                    <a:gd name="T7" fmla="*/ 8 h 8"/>
                    <a:gd name="T8" fmla="*/ 0 w 21"/>
                    <a:gd name="T9" fmla="*/ 4 h 8"/>
                    <a:gd name="T10" fmla="*/ 4 w 21"/>
                    <a:gd name="T11" fmla="*/ 0 h 8"/>
                    <a:gd name="T12" fmla="*/ 17 w 21"/>
                    <a:gd name="T13" fmla="*/ 0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1" h="8">
                      <a:moveTo>
                        <a:pt x="17" y="0"/>
                      </a:moveTo>
                      <a:cubicBezTo>
                        <a:pt x="19" y="0"/>
                        <a:pt x="21" y="2"/>
                        <a:pt x="21" y="4"/>
                      </a:cubicBezTo>
                      <a:cubicBezTo>
                        <a:pt x="21" y="6"/>
                        <a:pt x="19" y="8"/>
                        <a:pt x="17" y="8"/>
                      </a:cubicBezTo>
                      <a:cubicBezTo>
                        <a:pt x="4" y="8"/>
                        <a:pt x="4" y="8"/>
                        <a:pt x="4" y="8"/>
                      </a:cubicBezTo>
                      <a:cubicBezTo>
                        <a:pt x="2" y="8"/>
                        <a:pt x="0" y="6"/>
                        <a:pt x="0" y="4"/>
                      </a:cubicBezTo>
                      <a:cubicBezTo>
                        <a:pt x="0" y="2"/>
                        <a:pt x="2" y="0"/>
                        <a:pt x="4" y="0"/>
                      </a:cubicBez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67" name="Freeform 23">
                  <a:extLst>
                    <a:ext uri="{FF2B5EF4-FFF2-40B4-BE49-F238E27FC236}">
                      <a16:creationId xmlns:a16="http://schemas.microsoft.com/office/drawing/2014/main" id="{091B64E3-F81E-401F-9DC3-F3D06F7F332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54" y="1925"/>
                  <a:ext cx="48" cy="19"/>
                </a:xfrm>
                <a:custGeom>
                  <a:avLst/>
                  <a:gdLst>
                    <a:gd name="T0" fmla="*/ 17 w 20"/>
                    <a:gd name="T1" fmla="*/ 0 h 8"/>
                    <a:gd name="T2" fmla="*/ 20 w 20"/>
                    <a:gd name="T3" fmla="*/ 4 h 8"/>
                    <a:gd name="T4" fmla="*/ 17 w 20"/>
                    <a:gd name="T5" fmla="*/ 8 h 8"/>
                    <a:gd name="T6" fmla="*/ 3 w 20"/>
                    <a:gd name="T7" fmla="*/ 8 h 8"/>
                    <a:gd name="T8" fmla="*/ 0 w 20"/>
                    <a:gd name="T9" fmla="*/ 4 h 8"/>
                    <a:gd name="T10" fmla="*/ 3 w 20"/>
                    <a:gd name="T11" fmla="*/ 0 h 8"/>
                    <a:gd name="T12" fmla="*/ 17 w 20"/>
                    <a:gd name="T13" fmla="*/ 0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0" h="8">
                      <a:moveTo>
                        <a:pt x="17" y="0"/>
                      </a:moveTo>
                      <a:cubicBezTo>
                        <a:pt x="19" y="0"/>
                        <a:pt x="20" y="2"/>
                        <a:pt x="20" y="4"/>
                      </a:cubicBezTo>
                      <a:cubicBezTo>
                        <a:pt x="20" y="6"/>
                        <a:pt x="19" y="8"/>
                        <a:pt x="17" y="8"/>
                      </a:cubicBezTo>
                      <a:cubicBezTo>
                        <a:pt x="3" y="8"/>
                        <a:pt x="3" y="8"/>
                        <a:pt x="3" y="8"/>
                      </a:cubicBezTo>
                      <a:cubicBezTo>
                        <a:pt x="1" y="8"/>
                        <a:pt x="0" y="6"/>
                        <a:pt x="0" y="4"/>
                      </a:cubicBezTo>
                      <a:cubicBezTo>
                        <a:pt x="0" y="2"/>
                        <a:pt x="1" y="0"/>
                        <a:pt x="3" y="0"/>
                      </a:cubicBez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</p:grpSp>
          <p:sp>
            <p:nvSpPr>
              <p:cNvPr id="158" name="직사각형 157">
                <a:extLst>
                  <a:ext uri="{FF2B5EF4-FFF2-40B4-BE49-F238E27FC236}">
                    <a16:creationId xmlns:a16="http://schemas.microsoft.com/office/drawing/2014/main" id="{4A4CDD64-4A09-4C86-8873-42D5BF2B6074}"/>
                  </a:ext>
                </a:extLst>
              </p:cNvPr>
              <p:cNvSpPr/>
              <p:nvPr/>
            </p:nvSpPr>
            <p:spPr>
              <a:xfrm>
                <a:off x="2568967" y="2219424"/>
                <a:ext cx="1960949" cy="36652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defTabSz="545434">
                  <a:defRPr/>
                </a:pPr>
                <a:r>
                  <a:rPr lang="en-US" altLang="ko-KR" sz="1215" dirty="0">
                    <a:ln>
                      <a:solidFill>
                        <a:srgbClr val="1E94A2">
                          <a:shade val="50000"/>
                          <a:alpha val="0"/>
                        </a:srgbClr>
                      </a:solidFill>
                    </a:ln>
                    <a:solidFill>
                      <a:prstClr val="black"/>
                    </a:solidFill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22 </a:t>
                </a:r>
                <a:r>
                  <a:rPr lang="en-US" altLang="ko-KR" sz="1215">
                    <a:ln>
                      <a:solidFill>
                        <a:srgbClr val="1E94A2">
                          <a:shade val="50000"/>
                          <a:alpha val="0"/>
                        </a:srgbClr>
                      </a:solidFill>
                    </a:ln>
                    <a:solidFill>
                      <a:prstClr val="black"/>
                    </a:solidFill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healthy controls</a:t>
                </a:r>
                <a:endParaRPr lang="ko-KR" altLang="en-US" sz="1215" dirty="0">
                  <a:ln>
                    <a:solidFill>
                      <a:srgbClr val="1E94A2">
                        <a:shade val="50000"/>
                        <a:alpha val="0"/>
                      </a:srgbClr>
                    </a:solidFill>
                  </a:ln>
                  <a:solidFill>
                    <a:prstClr val="black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32" name="타원 131">
                <a:extLst>
                  <a:ext uri="{FF2B5EF4-FFF2-40B4-BE49-F238E27FC236}">
                    <a16:creationId xmlns:a16="http://schemas.microsoft.com/office/drawing/2014/main" id="{6A2EED1F-DCA0-48DF-801D-DD0D25F7236A}"/>
                  </a:ext>
                </a:extLst>
              </p:cNvPr>
              <p:cNvSpPr/>
              <p:nvPr/>
            </p:nvSpPr>
            <p:spPr>
              <a:xfrm>
                <a:off x="4635645" y="878298"/>
                <a:ext cx="2302164" cy="2302162"/>
              </a:xfrm>
              <a:prstGeom prst="ellipse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defTabSz="545434"/>
                <a:endParaRPr lang="ko-KR" altLang="en-US" sz="1215">
                  <a:solidFill>
                    <a:prstClr val="white"/>
                  </a:solidFill>
                  <a:latin typeface="맑은 고딕" panose="020F0502020204030204"/>
                  <a:ea typeface="맑은 고딕" panose="020B0503020000020004" pitchFamily="50" charset="-127"/>
                </a:endParaRPr>
              </a:p>
            </p:txBody>
          </p:sp>
          <p:grpSp>
            <p:nvGrpSpPr>
              <p:cNvPr id="134" name="그룹 133">
                <a:extLst>
                  <a:ext uri="{FF2B5EF4-FFF2-40B4-BE49-F238E27FC236}">
                    <a16:creationId xmlns:a16="http://schemas.microsoft.com/office/drawing/2014/main" id="{6BCB805F-6FC5-4075-AEF2-4C5084EBB9AC}"/>
                  </a:ext>
                </a:extLst>
              </p:cNvPr>
              <p:cNvGrpSpPr/>
              <p:nvPr/>
            </p:nvGrpSpPr>
            <p:grpSpPr>
              <a:xfrm>
                <a:off x="5209298" y="1397718"/>
                <a:ext cx="569519" cy="743890"/>
                <a:chOff x="10401300" y="627063"/>
                <a:chExt cx="642938" cy="839788"/>
              </a:xfrm>
            </p:grpSpPr>
            <p:sp>
              <p:nvSpPr>
                <p:cNvPr id="146" name="AutoShape 3">
                  <a:extLst>
                    <a:ext uri="{FF2B5EF4-FFF2-40B4-BE49-F238E27FC236}">
                      <a16:creationId xmlns:a16="http://schemas.microsoft.com/office/drawing/2014/main" id="{CDF61B7F-BE7E-4E3D-AB94-E7465C4F0099}"/>
                    </a:ext>
                  </a:extLst>
                </p:cNvPr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10401300" y="627063"/>
                  <a:ext cx="642938" cy="8350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617202">
                    <a:defRPr/>
                  </a:pPr>
                  <a:endParaRPr lang="ko-KR" altLang="en-US" sz="1215" dirty="0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47" name="Freeform 6">
                  <a:extLst>
                    <a:ext uri="{FF2B5EF4-FFF2-40B4-BE49-F238E27FC236}">
                      <a16:creationId xmlns:a16="http://schemas.microsoft.com/office/drawing/2014/main" id="{A45C64E3-7D6E-4FC8-9E9F-BF54B5E468A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626725" y="1108076"/>
                  <a:ext cx="203200" cy="327025"/>
                </a:xfrm>
                <a:custGeom>
                  <a:avLst/>
                  <a:gdLst>
                    <a:gd name="T0" fmla="*/ 51 w 53"/>
                    <a:gd name="T1" fmla="*/ 39 h 86"/>
                    <a:gd name="T2" fmla="*/ 53 w 53"/>
                    <a:gd name="T3" fmla="*/ 43 h 86"/>
                    <a:gd name="T4" fmla="*/ 51 w 53"/>
                    <a:gd name="T5" fmla="*/ 47 h 86"/>
                    <a:gd name="T6" fmla="*/ 51 w 53"/>
                    <a:gd name="T7" fmla="*/ 86 h 86"/>
                    <a:gd name="T8" fmla="*/ 29 w 53"/>
                    <a:gd name="T9" fmla="*/ 86 h 86"/>
                    <a:gd name="T10" fmla="*/ 29 w 53"/>
                    <a:gd name="T11" fmla="*/ 43 h 86"/>
                    <a:gd name="T12" fmla="*/ 25 w 53"/>
                    <a:gd name="T13" fmla="*/ 39 h 86"/>
                    <a:gd name="T14" fmla="*/ 22 w 53"/>
                    <a:gd name="T15" fmla="*/ 43 h 86"/>
                    <a:gd name="T16" fmla="*/ 22 w 53"/>
                    <a:gd name="T17" fmla="*/ 86 h 86"/>
                    <a:gd name="T18" fmla="*/ 0 w 53"/>
                    <a:gd name="T19" fmla="*/ 86 h 86"/>
                    <a:gd name="T20" fmla="*/ 0 w 53"/>
                    <a:gd name="T21" fmla="*/ 4 h 86"/>
                    <a:gd name="T22" fmla="*/ 7 w 53"/>
                    <a:gd name="T23" fmla="*/ 4 h 86"/>
                    <a:gd name="T24" fmla="*/ 11 w 53"/>
                    <a:gd name="T25" fmla="*/ 0 h 86"/>
                    <a:gd name="T26" fmla="*/ 14 w 53"/>
                    <a:gd name="T27" fmla="*/ 0 h 86"/>
                    <a:gd name="T28" fmla="*/ 14 w 53"/>
                    <a:gd name="T29" fmla="*/ 7 h 86"/>
                    <a:gd name="T30" fmla="*/ 35 w 53"/>
                    <a:gd name="T31" fmla="*/ 38 h 86"/>
                    <a:gd name="T32" fmla="*/ 43 w 53"/>
                    <a:gd name="T33" fmla="*/ 41 h 86"/>
                    <a:gd name="T34" fmla="*/ 44 w 53"/>
                    <a:gd name="T35" fmla="*/ 41 h 86"/>
                    <a:gd name="T36" fmla="*/ 46 w 53"/>
                    <a:gd name="T37" fmla="*/ 41 h 86"/>
                    <a:gd name="T38" fmla="*/ 51 w 53"/>
                    <a:gd name="T39" fmla="*/ 39 h 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</a:cxnLst>
                  <a:rect l="0" t="0" r="r" b="b"/>
                  <a:pathLst>
                    <a:path w="53" h="86">
                      <a:moveTo>
                        <a:pt x="51" y="39"/>
                      </a:moveTo>
                      <a:cubicBezTo>
                        <a:pt x="53" y="43"/>
                        <a:pt x="53" y="43"/>
                        <a:pt x="53" y="43"/>
                      </a:cubicBezTo>
                      <a:cubicBezTo>
                        <a:pt x="52" y="44"/>
                        <a:pt x="51" y="45"/>
                        <a:pt x="51" y="47"/>
                      </a:cubicBezTo>
                      <a:cubicBezTo>
                        <a:pt x="51" y="86"/>
                        <a:pt x="51" y="86"/>
                        <a:pt x="51" y="86"/>
                      </a:cubicBezTo>
                      <a:cubicBezTo>
                        <a:pt x="29" y="86"/>
                        <a:pt x="29" y="86"/>
                        <a:pt x="29" y="86"/>
                      </a:cubicBezTo>
                      <a:cubicBezTo>
                        <a:pt x="29" y="43"/>
                        <a:pt x="29" y="43"/>
                        <a:pt x="29" y="43"/>
                      </a:cubicBezTo>
                      <a:cubicBezTo>
                        <a:pt x="29" y="41"/>
                        <a:pt x="28" y="39"/>
                        <a:pt x="25" y="39"/>
                      </a:cubicBezTo>
                      <a:cubicBezTo>
                        <a:pt x="23" y="39"/>
                        <a:pt x="22" y="41"/>
                        <a:pt x="22" y="43"/>
                      </a:cubicBezTo>
                      <a:cubicBezTo>
                        <a:pt x="22" y="86"/>
                        <a:pt x="22" y="86"/>
                        <a:pt x="22" y="86"/>
                      </a:cubicBezTo>
                      <a:cubicBezTo>
                        <a:pt x="0" y="86"/>
                        <a:pt x="0" y="86"/>
                        <a:pt x="0" y="86"/>
                      </a:cubicBezTo>
                      <a:cubicBezTo>
                        <a:pt x="0" y="4"/>
                        <a:pt x="0" y="4"/>
                        <a:pt x="0" y="4"/>
                      </a:cubicBezTo>
                      <a:cubicBezTo>
                        <a:pt x="7" y="4"/>
                        <a:pt x="7" y="4"/>
                        <a:pt x="7" y="4"/>
                      </a:cubicBezTo>
                      <a:cubicBezTo>
                        <a:pt x="9" y="4"/>
                        <a:pt x="11" y="2"/>
                        <a:pt x="11" y="0"/>
                      </a:cubicBezTo>
                      <a:cubicBezTo>
                        <a:pt x="14" y="0"/>
                        <a:pt x="14" y="0"/>
                        <a:pt x="14" y="0"/>
                      </a:cubicBezTo>
                      <a:cubicBezTo>
                        <a:pt x="14" y="7"/>
                        <a:pt x="14" y="7"/>
                        <a:pt x="14" y="7"/>
                      </a:cubicBezTo>
                      <a:cubicBezTo>
                        <a:pt x="14" y="20"/>
                        <a:pt x="22" y="33"/>
                        <a:pt x="35" y="38"/>
                      </a:cubicBezTo>
                      <a:cubicBezTo>
                        <a:pt x="43" y="41"/>
                        <a:pt x="43" y="41"/>
                        <a:pt x="43" y="41"/>
                      </a:cubicBezTo>
                      <a:cubicBezTo>
                        <a:pt x="43" y="41"/>
                        <a:pt x="44" y="41"/>
                        <a:pt x="44" y="41"/>
                      </a:cubicBezTo>
                      <a:cubicBezTo>
                        <a:pt x="45" y="41"/>
                        <a:pt x="45" y="41"/>
                        <a:pt x="46" y="41"/>
                      </a:cubicBezTo>
                      <a:lnTo>
                        <a:pt x="51" y="39"/>
                      </a:lnTo>
                      <a:close/>
                    </a:path>
                  </a:pathLst>
                </a:custGeom>
                <a:solidFill>
                  <a:srgbClr val="43AAC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48" name="Freeform 7">
                  <a:extLst>
                    <a:ext uri="{FF2B5EF4-FFF2-40B4-BE49-F238E27FC236}">
                      <a16:creationId xmlns:a16="http://schemas.microsoft.com/office/drawing/2014/main" id="{94B578D3-2B1F-4CEA-B1FE-6A8ED2C5D67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436225" y="833438"/>
                  <a:ext cx="577850" cy="274638"/>
                </a:xfrm>
                <a:custGeom>
                  <a:avLst/>
                  <a:gdLst>
                    <a:gd name="T0" fmla="*/ 151 w 151"/>
                    <a:gd name="T1" fmla="*/ 40 h 72"/>
                    <a:gd name="T2" fmla="*/ 149 w 151"/>
                    <a:gd name="T3" fmla="*/ 45 h 72"/>
                    <a:gd name="T4" fmla="*/ 139 w 151"/>
                    <a:gd name="T5" fmla="*/ 46 h 72"/>
                    <a:gd name="T6" fmla="*/ 107 w 151"/>
                    <a:gd name="T7" fmla="*/ 18 h 72"/>
                    <a:gd name="T8" fmla="*/ 103 w 151"/>
                    <a:gd name="T9" fmla="*/ 18 h 72"/>
                    <a:gd name="T10" fmla="*/ 101 w 151"/>
                    <a:gd name="T11" fmla="*/ 21 h 72"/>
                    <a:gd name="T12" fmla="*/ 101 w 151"/>
                    <a:gd name="T13" fmla="*/ 36 h 72"/>
                    <a:gd name="T14" fmla="*/ 101 w 151"/>
                    <a:gd name="T15" fmla="*/ 38 h 72"/>
                    <a:gd name="T16" fmla="*/ 94 w 151"/>
                    <a:gd name="T17" fmla="*/ 41 h 72"/>
                    <a:gd name="T18" fmla="*/ 92 w 151"/>
                    <a:gd name="T19" fmla="*/ 42 h 72"/>
                    <a:gd name="T20" fmla="*/ 68 w 151"/>
                    <a:gd name="T21" fmla="*/ 52 h 72"/>
                    <a:gd name="T22" fmla="*/ 64 w 151"/>
                    <a:gd name="T23" fmla="*/ 56 h 72"/>
                    <a:gd name="T24" fmla="*/ 64 w 151"/>
                    <a:gd name="T25" fmla="*/ 72 h 72"/>
                    <a:gd name="T26" fmla="*/ 61 w 151"/>
                    <a:gd name="T27" fmla="*/ 72 h 72"/>
                    <a:gd name="T28" fmla="*/ 57 w 151"/>
                    <a:gd name="T29" fmla="*/ 68 h 72"/>
                    <a:gd name="T30" fmla="*/ 50 w 151"/>
                    <a:gd name="T31" fmla="*/ 68 h 72"/>
                    <a:gd name="T32" fmla="*/ 50 w 151"/>
                    <a:gd name="T33" fmla="*/ 21 h 72"/>
                    <a:gd name="T34" fmla="*/ 48 w 151"/>
                    <a:gd name="T35" fmla="*/ 18 h 72"/>
                    <a:gd name="T36" fmla="*/ 44 w 151"/>
                    <a:gd name="T37" fmla="*/ 18 h 72"/>
                    <a:gd name="T38" fmla="*/ 12 w 151"/>
                    <a:gd name="T39" fmla="*/ 46 h 72"/>
                    <a:gd name="T40" fmla="*/ 2 w 151"/>
                    <a:gd name="T41" fmla="*/ 45 h 72"/>
                    <a:gd name="T42" fmla="*/ 0 w 151"/>
                    <a:gd name="T43" fmla="*/ 40 h 72"/>
                    <a:gd name="T44" fmla="*/ 3 w 151"/>
                    <a:gd name="T45" fmla="*/ 35 h 72"/>
                    <a:gd name="T46" fmla="*/ 37 w 151"/>
                    <a:gd name="T47" fmla="*/ 5 h 72"/>
                    <a:gd name="T48" fmla="*/ 58 w 151"/>
                    <a:gd name="T49" fmla="*/ 5 h 72"/>
                    <a:gd name="T50" fmla="*/ 76 w 151"/>
                    <a:gd name="T51" fmla="*/ 11 h 72"/>
                    <a:gd name="T52" fmla="*/ 93 w 151"/>
                    <a:gd name="T53" fmla="*/ 5 h 72"/>
                    <a:gd name="T54" fmla="*/ 114 w 151"/>
                    <a:gd name="T55" fmla="*/ 5 h 72"/>
                    <a:gd name="T56" fmla="*/ 148 w 151"/>
                    <a:gd name="T57" fmla="*/ 35 h 72"/>
                    <a:gd name="T58" fmla="*/ 151 w 151"/>
                    <a:gd name="T59" fmla="*/ 40 h 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</a:cxnLst>
                  <a:rect l="0" t="0" r="r" b="b"/>
                  <a:pathLst>
                    <a:path w="151" h="72">
                      <a:moveTo>
                        <a:pt x="151" y="40"/>
                      </a:moveTo>
                      <a:cubicBezTo>
                        <a:pt x="151" y="42"/>
                        <a:pt x="150" y="44"/>
                        <a:pt x="149" y="45"/>
                      </a:cubicBezTo>
                      <a:cubicBezTo>
                        <a:pt x="146" y="48"/>
                        <a:pt x="142" y="48"/>
                        <a:pt x="139" y="46"/>
                      </a:cubicBezTo>
                      <a:cubicBezTo>
                        <a:pt x="107" y="18"/>
                        <a:pt x="107" y="18"/>
                        <a:pt x="107" y="18"/>
                      </a:cubicBezTo>
                      <a:cubicBezTo>
                        <a:pt x="106" y="17"/>
                        <a:pt x="104" y="17"/>
                        <a:pt x="103" y="18"/>
                      </a:cubicBezTo>
                      <a:cubicBezTo>
                        <a:pt x="102" y="18"/>
                        <a:pt x="101" y="20"/>
                        <a:pt x="101" y="21"/>
                      </a:cubicBezTo>
                      <a:cubicBezTo>
                        <a:pt x="101" y="36"/>
                        <a:pt x="101" y="36"/>
                        <a:pt x="101" y="36"/>
                      </a:cubicBezTo>
                      <a:cubicBezTo>
                        <a:pt x="101" y="37"/>
                        <a:pt x="101" y="37"/>
                        <a:pt x="101" y="38"/>
                      </a:cubicBezTo>
                      <a:cubicBezTo>
                        <a:pt x="94" y="41"/>
                        <a:pt x="94" y="41"/>
                        <a:pt x="94" y="41"/>
                      </a:cubicBezTo>
                      <a:cubicBezTo>
                        <a:pt x="93" y="41"/>
                        <a:pt x="92" y="41"/>
                        <a:pt x="92" y="42"/>
                      </a:cubicBezTo>
                      <a:cubicBezTo>
                        <a:pt x="92" y="42"/>
                        <a:pt x="80" y="52"/>
                        <a:pt x="68" y="52"/>
                      </a:cubicBezTo>
                      <a:cubicBezTo>
                        <a:pt x="66" y="52"/>
                        <a:pt x="64" y="54"/>
                        <a:pt x="64" y="56"/>
                      </a:cubicBezTo>
                      <a:cubicBezTo>
                        <a:pt x="64" y="72"/>
                        <a:pt x="64" y="72"/>
                        <a:pt x="64" y="72"/>
                      </a:cubicBezTo>
                      <a:cubicBezTo>
                        <a:pt x="61" y="72"/>
                        <a:pt x="61" y="72"/>
                        <a:pt x="61" y="72"/>
                      </a:cubicBezTo>
                      <a:cubicBezTo>
                        <a:pt x="61" y="70"/>
                        <a:pt x="59" y="68"/>
                        <a:pt x="57" y="68"/>
                      </a:cubicBezTo>
                      <a:cubicBezTo>
                        <a:pt x="50" y="68"/>
                        <a:pt x="50" y="68"/>
                        <a:pt x="50" y="68"/>
                      </a:cubicBezTo>
                      <a:cubicBezTo>
                        <a:pt x="50" y="21"/>
                        <a:pt x="50" y="21"/>
                        <a:pt x="50" y="21"/>
                      </a:cubicBezTo>
                      <a:cubicBezTo>
                        <a:pt x="50" y="20"/>
                        <a:pt x="49" y="18"/>
                        <a:pt x="48" y="18"/>
                      </a:cubicBezTo>
                      <a:cubicBezTo>
                        <a:pt x="47" y="17"/>
                        <a:pt x="45" y="17"/>
                        <a:pt x="44" y="18"/>
                      </a:cubicBezTo>
                      <a:cubicBezTo>
                        <a:pt x="12" y="46"/>
                        <a:pt x="12" y="46"/>
                        <a:pt x="12" y="46"/>
                      </a:cubicBezTo>
                      <a:cubicBezTo>
                        <a:pt x="9" y="48"/>
                        <a:pt x="5" y="48"/>
                        <a:pt x="2" y="45"/>
                      </a:cubicBezTo>
                      <a:cubicBezTo>
                        <a:pt x="1" y="44"/>
                        <a:pt x="0" y="42"/>
                        <a:pt x="0" y="40"/>
                      </a:cubicBezTo>
                      <a:cubicBezTo>
                        <a:pt x="0" y="38"/>
                        <a:pt x="1" y="36"/>
                        <a:pt x="3" y="35"/>
                      </a:cubicBezTo>
                      <a:cubicBezTo>
                        <a:pt x="37" y="5"/>
                        <a:pt x="37" y="5"/>
                        <a:pt x="37" y="5"/>
                      </a:cubicBezTo>
                      <a:cubicBezTo>
                        <a:pt x="43" y="0"/>
                        <a:pt x="52" y="0"/>
                        <a:pt x="58" y="5"/>
                      </a:cubicBezTo>
                      <a:cubicBezTo>
                        <a:pt x="63" y="9"/>
                        <a:pt x="69" y="11"/>
                        <a:pt x="76" y="11"/>
                      </a:cubicBezTo>
                      <a:cubicBezTo>
                        <a:pt x="82" y="11"/>
                        <a:pt x="88" y="9"/>
                        <a:pt x="93" y="5"/>
                      </a:cubicBezTo>
                      <a:cubicBezTo>
                        <a:pt x="99" y="0"/>
                        <a:pt x="108" y="0"/>
                        <a:pt x="114" y="5"/>
                      </a:cubicBezTo>
                      <a:cubicBezTo>
                        <a:pt x="148" y="35"/>
                        <a:pt x="148" y="35"/>
                        <a:pt x="148" y="35"/>
                      </a:cubicBezTo>
                      <a:cubicBezTo>
                        <a:pt x="150" y="36"/>
                        <a:pt x="151" y="38"/>
                        <a:pt x="151" y="40"/>
                      </a:cubicBezTo>
                      <a:close/>
                    </a:path>
                  </a:pathLst>
                </a:custGeom>
                <a:solidFill>
                  <a:srgbClr val="97D0DC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617202">
                    <a:defRPr/>
                  </a:pPr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49" name="Freeform 8">
                  <a:extLst>
                    <a:ext uri="{FF2B5EF4-FFF2-40B4-BE49-F238E27FC236}">
                      <a16:creationId xmlns:a16="http://schemas.microsoft.com/office/drawing/2014/main" id="{6C5A9017-E74C-42BC-93A4-DC02F46C499C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0712117" y="1024110"/>
                  <a:ext cx="173038" cy="209550"/>
                </a:xfrm>
                <a:custGeom>
                  <a:avLst/>
                  <a:gdLst>
                    <a:gd name="T0" fmla="*/ 45 w 45"/>
                    <a:gd name="T1" fmla="*/ 10 h 55"/>
                    <a:gd name="T2" fmla="*/ 45 w 45"/>
                    <a:gd name="T3" fmla="*/ 29 h 55"/>
                    <a:gd name="T4" fmla="*/ 29 w 45"/>
                    <a:gd name="T5" fmla="*/ 52 h 55"/>
                    <a:gd name="T6" fmla="*/ 22 w 45"/>
                    <a:gd name="T7" fmla="*/ 55 h 55"/>
                    <a:gd name="T8" fmla="*/ 16 w 45"/>
                    <a:gd name="T9" fmla="*/ 52 h 55"/>
                    <a:gd name="T10" fmla="*/ 0 w 45"/>
                    <a:gd name="T11" fmla="*/ 29 h 55"/>
                    <a:gd name="T12" fmla="*/ 0 w 45"/>
                    <a:gd name="T13" fmla="*/ 10 h 55"/>
                    <a:gd name="T14" fmla="*/ 22 w 45"/>
                    <a:gd name="T15" fmla="*/ 0 h 55"/>
                    <a:gd name="T16" fmla="*/ 45 w 45"/>
                    <a:gd name="T17" fmla="*/ 10 h 55"/>
                    <a:gd name="T18" fmla="*/ 37 w 45"/>
                    <a:gd name="T19" fmla="*/ 20 h 55"/>
                    <a:gd name="T20" fmla="*/ 36 w 45"/>
                    <a:gd name="T21" fmla="*/ 15 h 55"/>
                    <a:gd name="T22" fmla="*/ 31 w 45"/>
                    <a:gd name="T23" fmla="*/ 16 h 55"/>
                    <a:gd name="T24" fmla="*/ 21 w 45"/>
                    <a:gd name="T25" fmla="*/ 34 h 55"/>
                    <a:gd name="T26" fmla="*/ 14 w 45"/>
                    <a:gd name="T27" fmla="*/ 23 h 55"/>
                    <a:gd name="T28" fmla="*/ 9 w 45"/>
                    <a:gd name="T29" fmla="*/ 22 h 55"/>
                    <a:gd name="T30" fmla="*/ 7 w 45"/>
                    <a:gd name="T31" fmla="*/ 27 h 55"/>
                    <a:gd name="T32" fmla="*/ 18 w 45"/>
                    <a:gd name="T33" fmla="*/ 44 h 55"/>
                    <a:gd name="T34" fmla="*/ 21 w 45"/>
                    <a:gd name="T35" fmla="*/ 46 h 55"/>
                    <a:gd name="T36" fmla="*/ 21 w 45"/>
                    <a:gd name="T37" fmla="*/ 46 h 55"/>
                    <a:gd name="T38" fmla="*/ 24 w 45"/>
                    <a:gd name="T39" fmla="*/ 44 h 55"/>
                    <a:gd name="T40" fmla="*/ 37 w 45"/>
                    <a:gd name="T41" fmla="*/ 20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</a:cxnLst>
                  <a:rect l="0" t="0" r="r" b="b"/>
                  <a:pathLst>
                    <a:path w="45" h="55">
                      <a:moveTo>
                        <a:pt x="45" y="10"/>
                      </a:moveTo>
                      <a:cubicBezTo>
                        <a:pt x="45" y="29"/>
                        <a:pt x="45" y="29"/>
                        <a:pt x="45" y="29"/>
                      </a:cubicBezTo>
                      <a:cubicBezTo>
                        <a:pt x="45" y="39"/>
                        <a:pt x="39" y="49"/>
                        <a:pt x="29" y="52"/>
                      </a:cubicBezTo>
                      <a:cubicBezTo>
                        <a:pt x="22" y="55"/>
                        <a:pt x="22" y="55"/>
                        <a:pt x="22" y="55"/>
                      </a:cubicBezTo>
                      <a:cubicBezTo>
                        <a:pt x="16" y="52"/>
                        <a:pt x="16" y="52"/>
                        <a:pt x="16" y="52"/>
                      </a:cubicBezTo>
                      <a:cubicBezTo>
                        <a:pt x="6" y="49"/>
                        <a:pt x="0" y="39"/>
                        <a:pt x="0" y="29"/>
                      </a:cubicBezTo>
                      <a:cubicBezTo>
                        <a:pt x="0" y="10"/>
                        <a:pt x="0" y="10"/>
                        <a:pt x="0" y="10"/>
                      </a:cubicBezTo>
                      <a:cubicBezTo>
                        <a:pt x="9" y="8"/>
                        <a:pt x="18" y="3"/>
                        <a:pt x="22" y="0"/>
                      </a:cubicBezTo>
                      <a:cubicBezTo>
                        <a:pt x="26" y="3"/>
                        <a:pt x="35" y="8"/>
                        <a:pt x="45" y="10"/>
                      </a:cubicBezTo>
                      <a:close/>
                      <a:moveTo>
                        <a:pt x="37" y="20"/>
                      </a:moveTo>
                      <a:cubicBezTo>
                        <a:pt x="38" y="18"/>
                        <a:pt x="38" y="16"/>
                        <a:pt x="36" y="15"/>
                      </a:cubicBezTo>
                      <a:cubicBezTo>
                        <a:pt x="34" y="14"/>
                        <a:pt x="32" y="14"/>
                        <a:pt x="31" y="16"/>
                      </a:cubicBezTo>
                      <a:cubicBezTo>
                        <a:pt x="21" y="34"/>
                        <a:pt x="21" y="34"/>
                        <a:pt x="21" y="34"/>
                      </a:cubicBezTo>
                      <a:cubicBezTo>
                        <a:pt x="14" y="23"/>
                        <a:pt x="14" y="23"/>
                        <a:pt x="14" y="23"/>
                      </a:cubicBezTo>
                      <a:cubicBezTo>
                        <a:pt x="13" y="21"/>
                        <a:pt x="11" y="21"/>
                        <a:pt x="9" y="22"/>
                      </a:cubicBezTo>
                      <a:cubicBezTo>
                        <a:pt x="7" y="23"/>
                        <a:pt x="6" y="25"/>
                        <a:pt x="7" y="27"/>
                      </a:cubicBezTo>
                      <a:cubicBezTo>
                        <a:pt x="18" y="44"/>
                        <a:pt x="18" y="44"/>
                        <a:pt x="18" y="44"/>
                      </a:cubicBezTo>
                      <a:cubicBezTo>
                        <a:pt x="18" y="45"/>
                        <a:pt x="20" y="46"/>
                        <a:pt x="21" y="46"/>
                      </a:cubicBezTo>
                      <a:cubicBezTo>
                        <a:pt x="21" y="46"/>
                        <a:pt x="21" y="46"/>
                        <a:pt x="21" y="46"/>
                      </a:cubicBezTo>
                      <a:cubicBezTo>
                        <a:pt x="22" y="45"/>
                        <a:pt x="24" y="45"/>
                        <a:pt x="24" y="44"/>
                      </a:cubicBezTo>
                      <a:lnTo>
                        <a:pt x="37" y="20"/>
                      </a:lnTo>
                      <a:close/>
                    </a:path>
                  </a:pathLst>
                </a:custGeom>
                <a:solidFill>
                  <a:srgbClr val="A00000"/>
                </a:solidFill>
                <a:ln>
                  <a:noFill/>
                </a:ln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617202">
                    <a:defRPr/>
                  </a:pPr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50" name="Freeform 9">
                  <a:extLst>
                    <a:ext uri="{FF2B5EF4-FFF2-40B4-BE49-F238E27FC236}">
                      <a16:creationId xmlns:a16="http://schemas.microsoft.com/office/drawing/2014/main" id="{131F2FB1-5F3B-4C32-A773-2619A266E97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669588" y="661988"/>
                  <a:ext cx="111125" cy="128588"/>
                </a:xfrm>
                <a:custGeom>
                  <a:avLst/>
                  <a:gdLst>
                    <a:gd name="T0" fmla="*/ 29 w 29"/>
                    <a:gd name="T1" fmla="*/ 10 h 34"/>
                    <a:gd name="T2" fmla="*/ 26 w 29"/>
                    <a:gd name="T3" fmla="*/ 25 h 34"/>
                    <a:gd name="T4" fmla="*/ 14 w 29"/>
                    <a:gd name="T5" fmla="*/ 34 h 34"/>
                    <a:gd name="T6" fmla="*/ 3 w 29"/>
                    <a:gd name="T7" fmla="*/ 25 h 34"/>
                    <a:gd name="T8" fmla="*/ 0 w 29"/>
                    <a:gd name="T9" fmla="*/ 10 h 34"/>
                    <a:gd name="T10" fmla="*/ 4 w 29"/>
                    <a:gd name="T11" fmla="*/ 2 h 34"/>
                    <a:gd name="T12" fmla="*/ 14 w 29"/>
                    <a:gd name="T13" fmla="*/ 0 h 34"/>
                    <a:gd name="T14" fmla="*/ 25 w 29"/>
                    <a:gd name="T15" fmla="*/ 3 h 34"/>
                    <a:gd name="T16" fmla="*/ 29 w 29"/>
                    <a:gd name="T17" fmla="*/ 10 h 3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29" h="34">
                      <a:moveTo>
                        <a:pt x="29" y="10"/>
                      </a:moveTo>
                      <a:cubicBezTo>
                        <a:pt x="29" y="16"/>
                        <a:pt x="28" y="21"/>
                        <a:pt x="26" y="25"/>
                      </a:cubicBezTo>
                      <a:cubicBezTo>
                        <a:pt x="23" y="31"/>
                        <a:pt x="19" y="34"/>
                        <a:pt x="14" y="34"/>
                      </a:cubicBezTo>
                      <a:cubicBezTo>
                        <a:pt x="10" y="34"/>
                        <a:pt x="6" y="31"/>
                        <a:pt x="3" y="25"/>
                      </a:cubicBezTo>
                      <a:cubicBezTo>
                        <a:pt x="1" y="21"/>
                        <a:pt x="0" y="16"/>
                        <a:pt x="0" y="10"/>
                      </a:cubicBezTo>
                      <a:cubicBezTo>
                        <a:pt x="0" y="7"/>
                        <a:pt x="1" y="4"/>
                        <a:pt x="4" y="2"/>
                      </a:cubicBezTo>
                      <a:cubicBezTo>
                        <a:pt x="7" y="1"/>
                        <a:pt x="10" y="0"/>
                        <a:pt x="14" y="0"/>
                      </a:cubicBezTo>
                      <a:cubicBezTo>
                        <a:pt x="19" y="0"/>
                        <a:pt x="23" y="2"/>
                        <a:pt x="25" y="3"/>
                      </a:cubicBezTo>
                      <a:cubicBezTo>
                        <a:pt x="28" y="4"/>
                        <a:pt x="29" y="7"/>
                        <a:pt x="29" y="10"/>
                      </a:cubicBezTo>
                      <a:close/>
                    </a:path>
                  </a:pathLst>
                </a:custGeom>
                <a:solidFill>
                  <a:srgbClr val="FFEB9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617202">
                    <a:defRPr/>
                  </a:pPr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51" name="Freeform 10">
                  <a:extLst>
                    <a:ext uri="{FF2B5EF4-FFF2-40B4-BE49-F238E27FC236}">
                      <a16:creationId xmlns:a16="http://schemas.microsoft.com/office/drawing/2014/main" id="{607AFA34-2208-4586-9FC8-CA468CF08AB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404475" y="798513"/>
                  <a:ext cx="639763" cy="668338"/>
                </a:xfrm>
                <a:custGeom>
                  <a:avLst/>
                  <a:gdLst>
                    <a:gd name="T0" fmla="*/ 167 w 167"/>
                    <a:gd name="T1" fmla="*/ 49 h 175"/>
                    <a:gd name="T2" fmla="*/ 162 w 167"/>
                    <a:gd name="T3" fmla="*/ 60 h 175"/>
                    <a:gd name="T4" fmla="*/ 142 w 167"/>
                    <a:gd name="T5" fmla="*/ 61 h 175"/>
                    <a:gd name="T6" fmla="*/ 116 w 167"/>
                    <a:gd name="T7" fmla="*/ 39 h 175"/>
                    <a:gd name="T8" fmla="*/ 116 w 167"/>
                    <a:gd name="T9" fmla="*/ 45 h 175"/>
                    <a:gd name="T10" fmla="*/ 113 w 167"/>
                    <a:gd name="T11" fmla="*/ 49 h 175"/>
                    <a:gd name="T12" fmla="*/ 109 w 167"/>
                    <a:gd name="T13" fmla="*/ 47 h 175"/>
                    <a:gd name="T14" fmla="*/ 109 w 167"/>
                    <a:gd name="T15" fmla="*/ 45 h 175"/>
                    <a:gd name="T16" fmla="*/ 109 w 167"/>
                    <a:gd name="T17" fmla="*/ 30 h 175"/>
                    <a:gd name="T18" fmla="*/ 111 w 167"/>
                    <a:gd name="T19" fmla="*/ 27 h 175"/>
                    <a:gd name="T20" fmla="*/ 115 w 167"/>
                    <a:gd name="T21" fmla="*/ 27 h 175"/>
                    <a:gd name="T22" fmla="*/ 147 w 167"/>
                    <a:gd name="T23" fmla="*/ 55 h 175"/>
                    <a:gd name="T24" fmla="*/ 157 w 167"/>
                    <a:gd name="T25" fmla="*/ 54 h 175"/>
                    <a:gd name="T26" fmla="*/ 159 w 167"/>
                    <a:gd name="T27" fmla="*/ 49 h 175"/>
                    <a:gd name="T28" fmla="*/ 156 w 167"/>
                    <a:gd name="T29" fmla="*/ 44 h 175"/>
                    <a:gd name="T30" fmla="*/ 122 w 167"/>
                    <a:gd name="T31" fmla="*/ 14 h 175"/>
                    <a:gd name="T32" fmla="*/ 101 w 167"/>
                    <a:gd name="T33" fmla="*/ 14 h 175"/>
                    <a:gd name="T34" fmla="*/ 84 w 167"/>
                    <a:gd name="T35" fmla="*/ 20 h 175"/>
                    <a:gd name="T36" fmla="*/ 66 w 167"/>
                    <a:gd name="T37" fmla="*/ 14 h 175"/>
                    <a:gd name="T38" fmla="*/ 45 w 167"/>
                    <a:gd name="T39" fmla="*/ 14 h 175"/>
                    <a:gd name="T40" fmla="*/ 11 w 167"/>
                    <a:gd name="T41" fmla="*/ 44 h 175"/>
                    <a:gd name="T42" fmla="*/ 8 w 167"/>
                    <a:gd name="T43" fmla="*/ 49 h 175"/>
                    <a:gd name="T44" fmla="*/ 10 w 167"/>
                    <a:gd name="T45" fmla="*/ 54 h 175"/>
                    <a:gd name="T46" fmla="*/ 20 w 167"/>
                    <a:gd name="T47" fmla="*/ 55 h 175"/>
                    <a:gd name="T48" fmla="*/ 52 w 167"/>
                    <a:gd name="T49" fmla="*/ 27 h 175"/>
                    <a:gd name="T50" fmla="*/ 56 w 167"/>
                    <a:gd name="T51" fmla="*/ 27 h 175"/>
                    <a:gd name="T52" fmla="*/ 58 w 167"/>
                    <a:gd name="T53" fmla="*/ 30 h 175"/>
                    <a:gd name="T54" fmla="*/ 58 w 167"/>
                    <a:gd name="T55" fmla="*/ 77 h 175"/>
                    <a:gd name="T56" fmla="*/ 65 w 167"/>
                    <a:gd name="T57" fmla="*/ 77 h 175"/>
                    <a:gd name="T58" fmla="*/ 69 w 167"/>
                    <a:gd name="T59" fmla="*/ 81 h 175"/>
                    <a:gd name="T60" fmla="*/ 65 w 167"/>
                    <a:gd name="T61" fmla="*/ 85 h 175"/>
                    <a:gd name="T62" fmla="*/ 58 w 167"/>
                    <a:gd name="T63" fmla="*/ 85 h 175"/>
                    <a:gd name="T64" fmla="*/ 58 w 167"/>
                    <a:gd name="T65" fmla="*/ 167 h 175"/>
                    <a:gd name="T66" fmla="*/ 80 w 167"/>
                    <a:gd name="T67" fmla="*/ 167 h 175"/>
                    <a:gd name="T68" fmla="*/ 80 w 167"/>
                    <a:gd name="T69" fmla="*/ 124 h 175"/>
                    <a:gd name="T70" fmla="*/ 83 w 167"/>
                    <a:gd name="T71" fmla="*/ 120 h 175"/>
                    <a:gd name="T72" fmla="*/ 87 w 167"/>
                    <a:gd name="T73" fmla="*/ 124 h 175"/>
                    <a:gd name="T74" fmla="*/ 87 w 167"/>
                    <a:gd name="T75" fmla="*/ 167 h 175"/>
                    <a:gd name="T76" fmla="*/ 109 w 167"/>
                    <a:gd name="T77" fmla="*/ 167 h 175"/>
                    <a:gd name="T78" fmla="*/ 109 w 167"/>
                    <a:gd name="T79" fmla="*/ 128 h 175"/>
                    <a:gd name="T80" fmla="*/ 111 w 167"/>
                    <a:gd name="T81" fmla="*/ 124 h 175"/>
                    <a:gd name="T82" fmla="*/ 113 w 167"/>
                    <a:gd name="T83" fmla="*/ 124 h 175"/>
                    <a:gd name="T84" fmla="*/ 116 w 167"/>
                    <a:gd name="T85" fmla="*/ 128 h 175"/>
                    <a:gd name="T86" fmla="*/ 116 w 167"/>
                    <a:gd name="T87" fmla="*/ 171 h 175"/>
                    <a:gd name="T88" fmla="*/ 113 w 167"/>
                    <a:gd name="T89" fmla="*/ 175 h 175"/>
                    <a:gd name="T90" fmla="*/ 54 w 167"/>
                    <a:gd name="T91" fmla="*/ 175 h 175"/>
                    <a:gd name="T92" fmla="*/ 51 w 167"/>
                    <a:gd name="T93" fmla="*/ 171 h 175"/>
                    <a:gd name="T94" fmla="*/ 51 w 167"/>
                    <a:gd name="T95" fmla="*/ 85 h 175"/>
                    <a:gd name="T96" fmla="*/ 51 w 167"/>
                    <a:gd name="T97" fmla="*/ 39 h 175"/>
                    <a:gd name="T98" fmla="*/ 25 w 167"/>
                    <a:gd name="T99" fmla="*/ 61 h 175"/>
                    <a:gd name="T100" fmla="*/ 5 w 167"/>
                    <a:gd name="T101" fmla="*/ 60 h 175"/>
                    <a:gd name="T102" fmla="*/ 0 w 167"/>
                    <a:gd name="T103" fmla="*/ 49 h 175"/>
                    <a:gd name="T104" fmla="*/ 6 w 167"/>
                    <a:gd name="T105" fmla="*/ 38 h 175"/>
                    <a:gd name="T106" fmla="*/ 40 w 167"/>
                    <a:gd name="T107" fmla="*/ 8 h 175"/>
                    <a:gd name="T108" fmla="*/ 71 w 167"/>
                    <a:gd name="T109" fmla="*/ 8 h 175"/>
                    <a:gd name="T110" fmla="*/ 83 w 167"/>
                    <a:gd name="T111" fmla="*/ 12 h 175"/>
                    <a:gd name="T112" fmla="*/ 96 w 167"/>
                    <a:gd name="T113" fmla="*/ 8 h 175"/>
                    <a:gd name="T114" fmla="*/ 127 w 167"/>
                    <a:gd name="T115" fmla="*/ 8 h 175"/>
                    <a:gd name="T116" fmla="*/ 161 w 167"/>
                    <a:gd name="T117" fmla="*/ 38 h 175"/>
                    <a:gd name="T118" fmla="*/ 167 w 167"/>
                    <a:gd name="T119" fmla="*/ 49 h 17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  <a:cxn ang="0">
                      <a:pos x="T116" y="T117"/>
                    </a:cxn>
                    <a:cxn ang="0">
                      <a:pos x="T118" y="T119"/>
                    </a:cxn>
                  </a:cxnLst>
                  <a:rect l="0" t="0" r="r" b="b"/>
                  <a:pathLst>
                    <a:path w="167" h="175">
                      <a:moveTo>
                        <a:pt x="167" y="49"/>
                      </a:moveTo>
                      <a:cubicBezTo>
                        <a:pt x="167" y="53"/>
                        <a:pt x="165" y="57"/>
                        <a:pt x="162" y="60"/>
                      </a:cubicBezTo>
                      <a:cubicBezTo>
                        <a:pt x="157" y="66"/>
                        <a:pt x="148" y="66"/>
                        <a:pt x="142" y="61"/>
                      </a:cubicBezTo>
                      <a:cubicBezTo>
                        <a:pt x="116" y="39"/>
                        <a:pt x="116" y="39"/>
                        <a:pt x="116" y="39"/>
                      </a:cubicBezTo>
                      <a:cubicBezTo>
                        <a:pt x="116" y="45"/>
                        <a:pt x="116" y="45"/>
                        <a:pt x="116" y="45"/>
                      </a:cubicBezTo>
                      <a:cubicBezTo>
                        <a:pt x="116" y="48"/>
                        <a:pt x="115" y="49"/>
                        <a:pt x="113" y="49"/>
                      </a:cubicBezTo>
                      <a:cubicBezTo>
                        <a:pt x="111" y="49"/>
                        <a:pt x="110" y="48"/>
                        <a:pt x="109" y="47"/>
                      </a:cubicBezTo>
                      <a:cubicBezTo>
                        <a:pt x="109" y="46"/>
                        <a:pt x="109" y="46"/>
                        <a:pt x="109" y="45"/>
                      </a:cubicBezTo>
                      <a:cubicBezTo>
                        <a:pt x="109" y="30"/>
                        <a:pt x="109" y="30"/>
                        <a:pt x="109" y="30"/>
                      </a:cubicBezTo>
                      <a:cubicBezTo>
                        <a:pt x="109" y="29"/>
                        <a:pt x="110" y="27"/>
                        <a:pt x="111" y="27"/>
                      </a:cubicBezTo>
                      <a:cubicBezTo>
                        <a:pt x="112" y="26"/>
                        <a:pt x="114" y="26"/>
                        <a:pt x="115" y="27"/>
                      </a:cubicBezTo>
                      <a:cubicBezTo>
                        <a:pt x="147" y="55"/>
                        <a:pt x="147" y="55"/>
                        <a:pt x="147" y="55"/>
                      </a:cubicBezTo>
                      <a:cubicBezTo>
                        <a:pt x="150" y="57"/>
                        <a:pt x="154" y="57"/>
                        <a:pt x="157" y="54"/>
                      </a:cubicBezTo>
                      <a:cubicBezTo>
                        <a:pt x="158" y="53"/>
                        <a:pt x="159" y="51"/>
                        <a:pt x="159" y="49"/>
                      </a:cubicBezTo>
                      <a:cubicBezTo>
                        <a:pt x="159" y="47"/>
                        <a:pt x="158" y="45"/>
                        <a:pt x="156" y="44"/>
                      </a:cubicBezTo>
                      <a:cubicBezTo>
                        <a:pt x="122" y="14"/>
                        <a:pt x="122" y="14"/>
                        <a:pt x="122" y="14"/>
                      </a:cubicBezTo>
                      <a:cubicBezTo>
                        <a:pt x="116" y="9"/>
                        <a:pt x="107" y="9"/>
                        <a:pt x="101" y="14"/>
                      </a:cubicBezTo>
                      <a:cubicBezTo>
                        <a:pt x="96" y="18"/>
                        <a:pt x="90" y="20"/>
                        <a:pt x="84" y="20"/>
                      </a:cubicBezTo>
                      <a:cubicBezTo>
                        <a:pt x="77" y="20"/>
                        <a:pt x="71" y="18"/>
                        <a:pt x="66" y="14"/>
                      </a:cubicBezTo>
                      <a:cubicBezTo>
                        <a:pt x="60" y="9"/>
                        <a:pt x="51" y="9"/>
                        <a:pt x="45" y="14"/>
                      </a:cubicBezTo>
                      <a:cubicBezTo>
                        <a:pt x="11" y="44"/>
                        <a:pt x="11" y="44"/>
                        <a:pt x="11" y="44"/>
                      </a:cubicBezTo>
                      <a:cubicBezTo>
                        <a:pt x="9" y="45"/>
                        <a:pt x="8" y="47"/>
                        <a:pt x="8" y="49"/>
                      </a:cubicBezTo>
                      <a:cubicBezTo>
                        <a:pt x="8" y="51"/>
                        <a:pt x="9" y="53"/>
                        <a:pt x="10" y="54"/>
                      </a:cubicBezTo>
                      <a:cubicBezTo>
                        <a:pt x="13" y="57"/>
                        <a:pt x="17" y="57"/>
                        <a:pt x="20" y="55"/>
                      </a:cubicBezTo>
                      <a:cubicBezTo>
                        <a:pt x="52" y="27"/>
                        <a:pt x="52" y="27"/>
                        <a:pt x="52" y="27"/>
                      </a:cubicBezTo>
                      <a:cubicBezTo>
                        <a:pt x="53" y="26"/>
                        <a:pt x="55" y="26"/>
                        <a:pt x="56" y="27"/>
                      </a:cubicBezTo>
                      <a:cubicBezTo>
                        <a:pt x="57" y="27"/>
                        <a:pt x="58" y="29"/>
                        <a:pt x="58" y="30"/>
                      </a:cubicBezTo>
                      <a:cubicBezTo>
                        <a:pt x="58" y="77"/>
                        <a:pt x="58" y="77"/>
                        <a:pt x="58" y="77"/>
                      </a:cubicBezTo>
                      <a:cubicBezTo>
                        <a:pt x="65" y="77"/>
                        <a:pt x="65" y="77"/>
                        <a:pt x="65" y="77"/>
                      </a:cubicBezTo>
                      <a:cubicBezTo>
                        <a:pt x="67" y="77"/>
                        <a:pt x="69" y="79"/>
                        <a:pt x="69" y="81"/>
                      </a:cubicBezTo>
                      <a:cubicBezTo>
                        <a:pt x="69" y="83"/>
                        <a:pt x="67" y="85"/>
                        <a:pt x="65" y="85"/>
                      </a:cubicBezTo>
                      <a:cubicBezTo>
                        <a:pt x="58" y="85"/>
                        <a:pt x="58" y="85"/>
                        <a:pt x="58" y="85"/>
                      </a:cubicBezTo>
                      <a:cubicBezTo>
                        <a:pt x="58" y="167"/>
                        <a:pt x="58" y="167"/>
                        <a:pt x="58" y="167"/>
                      </a:cubicBezTo>
                      <a:cubicBezTo>
                        <a:pt x="80" y="167"/>
                        <a:pt x="80" y="167"/>
                        <a:pt x="80" y="167"/>
                      </a:cubicBezTo>
                      <a:cubicBezTo>
                        <a:pt x="80" y="124"/>
                        <a:pt x="80" y="124"/>
                        <a:pt x="80" y="124"/>
                      </a:cubicBezTo>
                      <a:cubicBezTo>
                        <a:pt x="80" y="122"/>
                        <a:pt x="81" y="120"/>
                        <a:pt x="83" y="120"/>
                      </a:cubicBezTo>
                      <a:cubicBezTo>
                        <a:pt x="86" y="120"/>
                        <a:pt x="87" y="122"/>
                        <a:pt x="87" y="124"/>
                      </a:cubicBezTo>
                      <a:cubicBezTo>
                        <a:pt x="87" y="167"/>
                        <a:pt x="87" y="167"/>
                        <a:pt x="87" y="167"/>
                      </a:cubicBezTo>
                      <a:cubicBezTo>
                        <a:pt x="109" y="167"/>
                        <a:pt x="109" y="167"/>
                        <a:pt x="109" y="167"/>
                      </a:cubicBezTo>
                      <a:cubicBezTo>
                        <a:pt x="109" y="128"/>
                        <a:pt x="109" y="128"/>
                        <a:pt x="109" y="128"/>
                      </a:cubicBezTo>
                      <a:cubicBezTo>
                        <a:pt x="109" y="126"/>
                        <a:pt x="110" y="125"/>
                        <a:pt x="111" y="124"/>
                      </a:cubicBezTo>
                      <a:cubicBezTo>
                        <a:pt x="111" y="124"/>
                        <a:pt x="112" y="124"/>
                        <a:pt x="113" y="124"/>
                      </a:cubicBezTo>
                      <a:cubicBezTo>
                        <a:pt x="115" y="124"/>
                        <a:pt x="116" y="126"/>
                        <a:pt x="116" y="128"/>
                      </a:cubicBezTo>
                      <a:cubicBezTo>
                        <a:pt x="116" y="171"/>
                        <a:pt x="116" y="171"/>
                        <a:pt x="116" y="171"/>
                      </a:cubicBezTo>
                      <a:cubicBezTo>
                        <a:pt x="116" y="173"/>
                        <a:pt x="115" y="175"/>
                        <a:pt x="113" y="175"/>
                      </a:cubicBezTo>
                      <a:cubicBezTo>
                        <a:pt x="54" y="175"/>
                        <a:pt x="54" y="175"/>
                        <a:pt x="54" y="175"/>
                      </a:cubicBezTo>
                      <a:cubicBezTo>
                        <a:pt x="52" y="175"/>
                        <a:pt x="51" y="173"/>
                        <a:pt x="51" y="171"/>
                      </a:cubicBezTo>
                      <a:cubicBezTo>
                        <a:pt x="51" y="85"/>
                        <a:pt x="51" y="85"/>
                        <a:pt x="51" y="85"/>
                      </a:cubicBezTo>
                      <a:cubicBezTo>
                        <a:pt x="51" y="39"/>
                        <a:pt x="51" y="39"/>
                        <a:pt x="51" y="39"/>
                      </a:cubicBezTo>
                      <a:cubicBezTo>
                        <a:pt x="25" y="61"/>
                        <a:pt x="25" y="61"/>
                        <a:pt x="25" y="61"/>
                      </a:cubicBezTo>
                      <a:cubicBezTo>
                        <a:pt x="19" y="66"/>
                        <a:pt x="10" y="66"/>
                        <a:pt x="5" y="60"/>
                      </a:cubicBezTo>
                      <a:cubicBezTo>
                        <a:pt x="2" y="57"/>
                        <a:pt x="0" y="53"/>
                        <a:pt x="0" y="49"/>
                      </a:cubicBezTo>
                      <a:cubicBezTo>
                        <a:pt x="0" y="45"/>
                        <a:pt x="2" y="41"/>
                        <a:pt x="6" y="38"/>
                      </a:cubicBezTo>
                      <a:cubicBezTo>
                        <a:pt x="40" y="8"/>
                        <a:pt x="40" y="8"/>
                        <a:pt x="40" y="8"/>
                      </a:cubicBezTo>
                      <a:cubicBezTo>
                        <a:pt x="49" y="1"/>
                        <a:pt x="62" y="0"/>
                        <a:pt x="71" y="8"/>
                      </a:cubicBezTo>
                      <a:cubicBezTo>
                        <a:pt x="75" y="11"/>
                        <a:pt x="79" y="12"/>
                        <a:pt x="83" y="12"/>
                      </a:cubicBezTo>
                      <a:cubicBezTo>
                        <a:pt x="88" y="12"/>
                        <a:pt x="93" y="11"/>
                        <a:pt x="96" y="8"/>
                      </a:cubicBezTo>
                      <a:cubicBezTo>
                        <a:pt x="105" y="0"/>
                        <a:pt x="118" y="1"/>
                        <a:pt x="127" y="8"/>
                      </a:cubicBezTo>
                      <a:cubicBezTo>
                        <a:pt x="161" y="38"/>
                        <a:pt x="161" y="38"/>
                        <a:pt x="161" y="38"/>
                      </a:cubicBezTo>
                      <a:cubicBezTo>
                        <a:pt x="165" y="41"/>
                        <a:pt x="167" y="45"/>
                        <a:pt x="167" y="49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617202">
                    <a:defRPr/>
                  </a:pPr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52" name="Freeform 11">
                  <a:extLst>
                    <a:ext uri="{FF2B5EF4-FFF2-40B4-BE49-F238E27FC236}">
                      <a16:creationId xmlns:a16="http://schemas.microsoft.com/office/drawing/2014/main" id="{B7BA79FD-9D7C-483A-9843-3731BF0A9F0A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0680700" y="989013"/>
                  <a:ext cx="233363" cy="274638"/>
                </a:xfrm>
                <a:custGeom>
                  <a:avLst/>
                  <a:gdLst>
                    <a:gd name="T0" fmla="*/ 61 w 61"/>
                    <a:gd name="T1" fmla="*/ 15 h 72"/>
                    <a:gd name="T2" fmla="*/ 61 w 61"/>
                    <a:gd name="T3" fmla="*/ 38 h 72"/>
                    <a:gd name="T4" fmla="*/ 40 w 61"/>
                    <a:gd name="T5" fmla="*/ 69 h 72"/>
                    <a:gd name="T6" fmla="*/ 37 w 61"/>
                    <a:gd name="T7" fmla="*/ 70 h 72"/>
                    <a:gd name="T8" fmla="*/ 32 w 61"/>
                    <a:gd name="T9" fmla="*/ 72 h 72"/>
                    <a:gd name="T10" fmla="*/ 30 w 61"/>
                    <a:gd name="T11" fmla="*/ 72 h 72"/>
                    <a:gd name="T12" fmla="*/ 29 w 61"/>
                    <a:gd name="T13" fmla="*/ 72 h 72"/>
                    <a:gd name="T14" fmla="*/ 21 w 61"/>
                    <a:gd name="T15" fmla="*/ 69 h 72"/>
                    <a:gd name="T16" fmla="*/ 0 w 61"/>
                    <a:gd name="T17" fmla="*/ 38 h 72"/>
                    <a:gd name="T18" fmla="*/ 0 w 61"/>
                    <a:gd name="T19" fmla="*/ 31 h 72"/>
                    <a:gd name="T20" fmla="*/ 0 w 61"/>
                    <a:gd name="T21" fmla="*/ 15 h 72"/>
                    <a:gd name="T22" fmla="*/ 4 w 61"/>
                    <a:gd name="T23" fmla="*/ 11 h 72"/>
                    <a:gd name="T24" fmla="*/ 28 w 61"/>
                    <a:gd name="T25" fmla="*/ 1 h 72"/>
                    <a:gd name="T26" fmla="*/ 30 w 61"/>
                    <a:gd name="T27" fmla="*/ 0 h 72"/>
                    <a:gd name="T28" fmla="*/ 33 w 61"/>
                    <a:gd name="T29" fmla="*/ 1 h 72"/>
                    <a:gd name="T30" fmla="*/ 57 w 61"/>
                    <a:gd name="T31" fmla="*/ 11 h 72"/>
                    <a:gd name="T32" fmla="*/ 61 w 61"/>
                    <a:gd name="T33" fmla="*/ 15 h 72"/>
                    <a:gd name="T34" fmla="*/ 53 w 61"/>
                    <a:gd name="T35" fmla="*/ 38 h 72"/>
                    <a:gd name="T36" fmla="*/ 53 w 61"/>
                    <a:gd name="T37" fmla="*/ 19 h 72"/>
                    <a:gd name="T38" fmla="*/ 30 w 61"/>
                    <a:gd name="T39" fmla="*/ 9 h 72"/>
                    <a:gd name="T40" fmla="*/ 8 w 61"/>
                    <a:gd name="T41" fmla="*/ 19 h 72"/>
                    <a:gd name="T42" fmla="*/ 8 w 61"/>
                    <a:gd name="T43" fmla="*/ 38 h 72"/>
                    <a:gd name="T44" fmla="*/ 24 w 61"/>
                    <a:gd name="T45" fmla="*/ 61 h 72"/>
                    <a:gd name="T46" fmla="*/ 30 w 61"/>
                    <a:gd name="T47" fmla="*/ 64 h 72"/>
                    <a:gd name="T48" fmla="*/ 37 w 61"/>
                    <a:gd name="T49" fmla="*/ 61 h 72"/>
                    <a:gd name="T50" fmla="*/ 53 w 61"/>
                    <a:gd name="T51" fmla="*/ 38 h 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</a:cxnLst>
                  <a:rect l="0" t="0" r="r" b="b"/>
                  <a:pathLst>
                    <a:path w="61" h="72">
                      <a:moveTo>
                        <a:pt x="61" y="15"/>
                      </a:moveTo>
                      <a:cubicBezTo>
                        <a:pt x="61" y="38"/>
                        <a:pt x="61" y="38"/>
                        <a:pt x="61" y="38"/>
                      </a:cubicBezTo>
                      <a:cubicBezTo>
                        <a:pt x="61" y="51"/>
                        <a:pt x="53" y="64"/>
                        <a:pt x="40" y="69"/>
                      </a:cubicBezTo>
                      <a:cubicBezTo>
                        <a:pt x="37" y="70"/>
                        <a:pt x="37" y="70"/>
                        <a:pt x="37" y="70"/>
                      </a:cubicBezTo>
                      <a:cubicBezTo>
                        <a:pt x="32" y="72"/>
                        <a:pt x="32" y="72"/>
                        <a:pt x="32" y="72"/>
                      </a:cubicBezTo>
                      <a:cubicBezTo>
                        <a:pt x="31" y="72"/>
                        <a:pt x="31" y="72"/>
                        <a:pt x="30" y="72"/>
                      </a:cubicBezTo>
                      <a:cubicBezTo>
                        <a:pt x="30" y="72"/>
                        <a:pt x="29" y="72"/>
                        <a:pt x="29" y="72"/>
                      </a:cubicBezTo>
                      <a:cubicBezTo>
                        <a:pt x="21" y="69"/>
                        <a:pt x="21" y="69"/>
                        <a:pt x="21" y="69"/>
                      </a:cubicBezTo>
                      <a:cubicBezTo>
                        <a:pt x="8" y="64"/>
                        <a:pt x="0" y="51"/>
                        <a:pt x="0" y="38"/>
                      </a:cubicBezTo>
                      <a:cubicBezTo>
                        <a:pt x="0" y="31"/>
                        <a:pt x="0" y="31"/>
                        <a:pt x="0" y="31"/>
                      </a:cubicBezTo>
                      <a:cubicBezTo>
                        <a:pt x="0" y="15"/>
                        <a:pt x="0" y="15"/>
                        <a:pt x="0" y="15"/>
                      </a:cubicBezTo>
                      <a:cubicBezTo>
                        <a:pt x="0" y="13"/>
                        <a:pt x="2" y="11"/>
                        <a:pt x="4" y="11"/>
                      </a:cubicBezTo>
                      <a:cubicBezTo>
                        <a:pt x="16" y="11"/>
                        <a:pt x="28" y="1"/>
                        <a:pt x="28" y="1"/>
                      </a:cubicBezTo>
                      <a:cubicBezTo>
                        <a:pt x="28" y="0"/>
                        <a:pt x="29" y="0"/>
                        <a:pt x="30" y="0"/>
                      </a:cubicBezTo>
                      <a:cubicBezTo>
                        <a:pt x="31" y="0"/>
                        <a:pt x="32" y="0"/>
                        <a:pt x="33" y="1"/>
                      </a:cubicBezTo>
                      <a:cubicBezTo>
                        <a:pt x="33" y="1"/>
                        <a:pt x="45" y="11"/>
                        <a:pt x="57" y="11"/>
                      </a:cubicBezTo>
                      <a:cubicBezTo>
                        <a:pt x="59" y="11"/>
                        <a:pt x="61" y="13"/>
                        <a:pt x="61" y="15"/>
                      </a:cubicBezTo>
                      <a:close/>
                      <a:moveTo>
                        <a:pt x="53" y="38"/>
                      </a:moveTo>
                      <a:cubicBezTo>
                        <a:pt x="53" y="19"/>
                        <a:pt x="53" y="19"/>
                        <a:pt x="53" y="19"/>
                      </a:cubicBezTo>
                      <a:cubicBezTo>
                        <a:pt x="43" y="17"/>
                        <a:pt x="34" y="12"/>
                        <a:pt x="30" y="9"/>
                      </a:cubicBezTo>
                      <a:cubicBezTo>
                        <a:pt x="26" y="12"/>
                        <a:pt x="17" y="17"/>
                        <a:pt x="8" y="19"/>
                      </a:cubicBezTo>
                      <a:cubicBezTo>
                        <a:pt x="8" y="38"/>
                        <a:pt x="8" y="38"/>
                        <a:pt x="8" y="38"/>
                      </a:cubicBezTo>
                      <a:cubicBezTo>
                        <a:pt x="8" y="48"/>
                        <a:pt x="14" y="58"/>
                        <a:pt x="24" y="61"/>
                      </a:cubicBezTo>
                      <a:cubicBezTo>
                        <a:pt x="30" y="64"/>
                        <a:pt x="30" y="64"/>
                        <a:pt x="30" y="64"/>
                      </a:cubicBezTo>
                      <a:cubicBezTo>
                        <a:pt x="37" y="61"/>
                        <a:pt x="37" y="61"/>
                        <a:pt x="37" y="61"/>
                      </a:cubicBezTo>
                      <a:cubicBezTo>
                        <a:pt x="47" y="58"/>
                        <a:pt x="53" y="48"/>
                        <a:pt x="53" y="38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617202">
                    <a:defRPr/>
                  </a:pPr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53" name="Freeform 13">
                  <a:extLst>
                    <a:ext uri="{FF2B5EF4-FFF2-40B4-BE49-F238E27FC236}">
                      <a16:creationId xmlns:a16="http://schemas.microsoft.com/office/drawing/2014/main" id="{5469451C-BD68-40BC-BAFE-ECD8809002DD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0639425" y="630238"/>
                  <a:ext cx="171450" cy="192088"/>
                </a:xfrm>
                <a:custGeom>
                  <a:avLst/>
                  <a:gdLst>
                    <a:gd name="T0" fmla="*/ 45 w 45"/>
                    <a:gd name="T1" fmla="*/ 18 h 50"/>
                    <a:gd name="T2" fmla="*/ 41 w 45"/>
                    <a:gd name="T3" fmla="*/ 37 h 50"/>
                    <a:gd name="T4" fmla="*/ 22 w 45"/>
                    <a:gd name="T5" fmla="*/ 50 h 50"/>
                    <a:gd name="T6" fmla="*/ 22 w 45"/>
                    <a:gd name="T7" fmla="*/ 50 h 50"/>
                    <a:gd name="T8" fmla="*/ 4 w 45"/>
                    <a:gd name="T9" fmla="*/ 37 h 50"/>
                    <a:gd name="T10" fmla="*/ 0 w 45"/>
                    <a:gd name="T11" fmla="*/ 18 h 50"/>
                    <a:gd name="T12" fmla="*/ 9 w 45"/>
                    <a:gd name="T13" fmla="*/ 3 h 50"/>
                    <a:gd name="T14" fmla="*/ 22 w 45"/>
                    <a:gd name="T15" fmla="*/ 0 h 50"/>
                    <a:gd name="T16" fmla="*/ 37 w 45"/>
                    <a:gd name="T17" fmla="*/ 4 h 50"/>
                    <a:gd name="T18" fmla="*/ 45 w 45"/>
                    <a:gd name="T19" fmla="*/ 18 h 50"/>
                    <a:gd name="T20" fmla="*/ 34 w 45"/>
                    <a:gd name="T21" fmla="*/ 33 h 50"/>
                    <a:gd name="T22" fmla="*/ 37 w 45"/>
                    <a:gd name="T23" fmla="*/ 18 h 50"/>
                    <a:gd name="T24" fmla="*/ 33 w 45"/>
                    <a:gd name="T25" fmla="*/ 11 h 50"/>
                    <a:gd name="T26" fmla="*/ 22 w 45"/>
                    <a:gd name="T27" fmla="*/ 8 h 50"/>
                    <a:gd name="T28" fmla="*/ 12 w 45"/>
                    <a:gd name="T29" fmla="*/ 10 h 50"/>
                    <a:gd name="T30" fmla="*/ 8 w 45"/>
                    <a:gd name="T31" fmla="*/ 18 h 50"/>
                    <a:gd name="T32" fmla="*/ 11 w 45"/>
                    <a:gd name="T33" fmla="*/ 33 h 50"/>
                    <a:gd name="T34" fmla="*/ 22 w 45"/>
                    <a:gd name="T35" fmla="*/ 42 h 50"/>
                    <a:gd name="T36" fmla="*/ 34 w 45"/>
                    <a:gd name="T37" fmla="*/ 33 h 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</a:cxnLst>
                  <a:rect l="0" t="0" r="r" b="b"/>
                  <a:pathLst>
                    <a:path w="45" h="50">
                      <a:moveTo>
                        <a:pt x="45" y="18"/>
                      </a:moveTo>
                      <a:cubicBezTo>
                        <a:pt x="45" y="25"/>
                        <a:pt x="44" y="31"/>
                        <a:pt x="41" y="37"/>
                      </a:cubicBezTo>
                      <a:cubicBezTo>
                        <a:pt x="35" y="48"/>
                        <a:pt x="28" y="50"/>
                        <a:pt x="22" y="50"/>
                      </a:cubicBezTo>
                      <a:cubicBezTo>
                        <a:pt x="22" y="50"/>
                        <a:pt x="22" y="50"/>
                        <a:pt x="22" y="50"/>
                      </a:cubicBezTo>
                      <a:cubicBezTo>
                        <a:pt x="17" y="50"/>
                        <a:pt x="10" y="47"/>
                        <a:pt x="4" y="37"/>
                      </a:cubicBezTo>
                      <a:cubicBezTo>
                        <a:pt x="1" y="31"/>
                        <a:pt x="0" y="25"/>
                        <a:pt x="0" y="18"/>
                      </a:cubicBezTo>
                      <a:cubicBezTo>
                        <a:pt x="0" y="12"/>
                        <a:pt x="3" y="6"/>
                        <a:pt x="9" y="3"/>
                      </a:cubicBezTo>
                      <a:cubicBezTo>
                        <a:pt x="12" y="2"/>
                        <a:pt x="17" y="0"/>
                        <a:pt x="22" y="0"/>
                      </a:cubicBezTo>
                      <a:cubicBezTo>
                        <a:pt x="29" y="0"/>
                        <a:pt x="34" y="2"/>
                        <a:pt x="37" y="4"/>
                      </a:cubicBezTo>
                      <a:cubicBezTo>
                        <a:pt x="42" y="7"/>
                        <a:pt x="45" y="12"/>
                        <a:pt x="45" y="18"/>
                      </a:cubicBezTo>
                      <a:close/>
                      <a:moveTo>
                        <a:pt x="34" y="33"/>
                      </a:moveTo>
                      <a:cubicBezTo>
                        <a:pt x="36" y="29"/>
                        <a:pt x="37" y="24"/>
                        <a:pt x="37" y="18"/>
                      </a:cubicBezTo>
                      <a:cubicBezTo>
                        <a:pt x="37" y="15"/>
                        <a:pt x="36" y="12"/>
                        <a:pt x="33" y="11"/>
                      </a:cubicBezTo>
                      <a:cubicBezTo>
                        <a:pt x="31" y="10"/>
                        <a:pt x="27" y="8"/>
                        <a:pt x="22" y="8"/>
                      </a:cubicBezTo>
                      <a:cubicBezTo>
                        <a:pt x="18" y="8"/>
                        <a:pt x="15" y="9"/>
                        <a:pt x="12" y="10"/>
                      </a:cubicBezTo>
                      <a:cubicBezTo>
                        <a:pt x="9" y="12"/>
                        <a:pt x="8" y="15"/>
                        <a:pt x="8" y="18"/>
                      </a:cubicBezTo>
                      <a:cubicBezTo>
                        <a:pt x="8" y="24"/>
                        <a:pt x="9" y="29"/>
                        <a:pt x="11" y="33"/>
                      </a:cubicBezTo>
                      <a:cubicBezTo>
                        <a:pt x="14" y="39"/>
                        <a:pt x="18" y="42"/>
                        <a:pt x="22" y="42"/>
                      </a:cubicBezTo>
                      <a:cubicBezTo>
                        <a:pt x="27" y="42"/>
                        <a:pt x="31" y="39"/>
                        <a:pt x="34" y="33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617202">
                    <a:defRPr/>
                  </a:pPr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</p:grpSp>
          <p:sp>
            <p:nvSpPr>
              <p:cNvPr id="135" name="직사각형 134">
                <a:extLst>
                  <a:ext uri="{FF2B5EF4-FFF2-40B4-BE49-F238E27FC236}">
                    <a16:creationId xmlns:a16="http://schemas.microsoft.com/office/drawing/2014/main" id="{78989448-61F7-47DC-840C-F2B58CFCFD7B}"/>
                  </a:ext>
                </a:extLst>
              </p:cNvPr>
              <p:cNvSpPr/>
              <p:nvPr/>
            </p:nvSpPr>
            <p:spPr>
              <a:xfrm>
                <a:off x="4880126" y="2232292"/>
                <a:ext cx="1721142" cy="61188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defTabSz="545434"/>
                <a:r>
                  <a:rPr lang="en-US" altLang="ko-KR" sz="1215" dirty="0">
                    <a:ln>
                      <a:solidFill>
                        <a:srgbClr val="1E94A2">
                          <a:shade val="50000"/>
                          <a:alpha val="0"/>
                        </a:srgbClr>
                      </a:solidFill>
                    </a:ln>
                    <a:solidFill>
                      <a:prstClr val="black"/>
                    </a:solidFill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66 patients with </a:t>
                </a:r>
                <a:br>
                  <a:rPr lang="en-US" altLang="ko-KR" sz="1215" dirty="0">
                    <a:ln>
                      <a:solidFill>
                        <a:srgbClr val="1E94A2">
                          <a:shade val="50000"/>
                          <a:alpha val="0"/>
                        </a:srgbClr>
                      </a:solidFill>
                    </a:ln>
                    <a:solidFill>
                      <a:prstClr val="black"/>
                    </a:solidFill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</a:br>
                <a:r>
                  <a:rPr lang="en-US" altLang="ko-KR" sz="1215" dirty="0">
                    <a:ln>
                      <a:solidFill>
                        <a:srgbClr val="1E94A2">
                          <a:shade val="50000"/>
                          <a:alpha val="0"/>
                        </a:srgbClr>
                      </a:solidFill>
                    </a:ln>
                    <a:solidFill>
                      <a:prstClr val="black"/>
                    </a:solidFill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food allergy</a:t>
                </a:r>
                <a:endParaRPr lang="ko-KR" altLang="en-US" sz="1215" dirty="0">
                  <a:solidFill>
                    <a:prstClr val="black"/>
                  </a:solidFill>
                  <a:latin typeface="맑은 고딕" panose="020F0502020204030204"/>
                  <a:ea typeface="맑은 고딕" panose="020B0503020000020004" pitchFamily="50" charset="-127"/>
                </a:endParaRPr>
              </a:p>
            </p:txBody>
          </p:sp>
          <p:grpSp>
            <p:nvGrpSpPr>
              <p:cNvPr id="177" name="Group 15">
                <a:extLst>
                  <a:ext uri="{FF2B5EF4-FFF2-40B4-BE49-F238E27FC236}">
                    <a16:creationId xmlns:a16="http://schemas.microsoft.com/office/drawing/2014/main" id="{FD705791-0C09-49E7-A092-D49C73DFC46E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>
                <a:off x="5878059" y="1827658"/>
                <a:ext cx="349586" cy="284279"/>
                <a:chOff x="867" y="1678"/>
                <a:chExt cx="455" cy="370"/>
              </a:xfrm>
            </p:grpSpPr>
            <p:sp>
              <p:nvSpPr>
                <p:cNvPr id="178" name="AutoShape 14">
                  <a:extLst>
                    <a:ext uri="{FF2B5EF4-FFF2-40B4-BE49-F238E27FC236}">
                      <a16:creationId xmlns:a16="http://schemas.microsoft.com/office/drawing/2014/main" id="{E43B6343-1ADE-4A39-BBB2-C59BA597348C}"/>
                    </a:ext>
                  </a:extLst>
                </p:cNvPr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867" y="1678"/>
                  <a:ext cx="455" cy="37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79" name="Freeform 16">
                  <a:extLst>
                    <a:ext uri="{FF2B5EF4-FFF2-40B4-BE49-F238E27FC236}">
                      <a16:creationId xmlns:a16="http://schemas.microsoft.com/office/drawing/2014/main" id="{BC1F57A6-0177-43B4-B55A-EADD8785947B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881" y="1702"/>
                  <a:ext cx="422" cy="324"/>
                </a:xfrm>
                <a:custGeom>
                  <a:avLst/>
                  <a:gdLst>
                    <a:gd name="T0" fmla="*/ 175 w 175"/>
                    <a:gd name="T1" fmla="*/ 106 h 134"/>
                    <a:gd name="T2" fmla="*/ 30 w 175"/>
                    <a:gd name="T3" fmla="*/ 134 h 134"/>
                    <a:gd name="T4" fmla="*/ 30 w 175"/>
                    <a:gd name="T5" fmla="*/ 74 h 134"/>
                    <a:gd name="T6" fmla="*/ 63 w 175"/>
                    <a:gd name="T7" fmla="*/ 74 h 134"/>
                    <a:gd name="T8" fmla="*/ 78 w 175"/>
                    <a:gd name="T9" fmla="*/ 70 h 134"/>
                    <a:gd name="T10" fmla="*/ 63 w 175"/>
                    <a:gd name="T11" fmla="*/ 66 h 134"/>
                    <a:gd name="T12" fmla="*/ 26 w 175"/>
                    <a:gd name="T13" fmla="*/ 41 h 134"/>
                    <a:gd name="T14" fmla="*/ 68 w 175"/>
                    <a:gd name="T15" fmla="*/ 0 h 134"/>
                    <a:gd name="T16" fmla="*/ 115 w 175"/>
                    <a:gd name="T17" fmla="*/ 33 h 134"/>
                    <a:gd name="T18" fmla="*/ 142 w 175"/>
                    <a:gd name="T19" fmla="*/ 37 h 134"/>
                    <a:gd name="T20" fmla="*/ 153 w 175"/>
                    <a:gd name="T21" fmla="*/ 66 h 134"/>
                    <a:gd name="T22" fmla="*/ 123 w 175"/>
                    <a:gd name="T23" fmla="*/ 71 h 134"/>
                    <a:gd name="T24" fmla="*/ 123 w 175"/>
                    <a:gd name="T25" fmla="*/ 79 h 134"/>
                    <a:gd name="T26" fmla="*/ 141 w 175"/>
                    <a:gd name="T27" fmla="*/ 79 h 134"/>
                    <a:gd name="T28" fmla="*/ 143 w 175"/>
                    <a:gd name="T29" fmla="*/ 79 h 134"/>
                    <a:gd name="T30" fmla="*/ 148 w 175"/>
                    <a:gd name="T31" fmla="*/ 112 h 134"/>
                    <a:gd name="T32" fmla="*/ 131 w 175"/>
                    <a:gd name="T33" fmla="*/ 108 h 134"/>
                    <a:gd name="T34" fmla="*/ 131 w 175"/>
                    <a:gd name="T35" fmla="*/ 116 h 134"/>
                    <a:gd name="T36" fmla="*/ 148 w 175"/>
                    <a:gd name="T37" fmla="*/ 112 h 134"/>
                    <a:gd name="T38" fmla="*/ 120 w 175"/>
                    <a:gd name="T39" fmla="*/ 51 h 134"/>
                    <a:gd name="T40" fmla="*/ 103 w 175"/>
                    <a:gd name="T41" fmla="*/ 55 h 134"/>
                    <a:gd name="T42" fmla="*/ 120 w 175"/>
                    <a:gd name="T43" fmla="*/ 58 h 134"/>
                    <a:gd name="T44" fmla="*/ 109 w 175"/>
                    <a:gd name="T45" fmla="*/ 98 h 134"/>
                    <a:gd name="T46" fmla="*/ 92 w 175"/>
                    <a:gd name="T47" fmla="*/ 94 h 134"/>
                    <a:gd name="T48" fmla="*/ 92 w 175"/>
                    <a:gd name="T49" fmla="*/ 101 h 134"/>
                    <a:gd name="T50" fmla="*/ 109 w 175"/>
                    <a:gd name="T51" fmla="*/ 98 h 134"/>
                    <a:gd name="T52" fmla="*/ 80 w 175"/>
                    <a:gd name="T53" fmla="*/ 114 h 134"/>
                    <a:gd name="T54" fmla="*/ 63 w 175"/>
                    <a:gd name="T55" fmla="*/ 118 h 134"/>
                    <a:gd name="T56" fmla="*/ 80 w 175"/>
                    <a:gd name="T57" fmla="*/ 122 h 134"/>
                    <a:gd name="T58" fmla="*/ 72 w 175"/>
                    <a:gd name="T59" fmla="*/ 43 h 134"/>
                    <a:gd name="T60" fmla="*/ 55 w 175"/>
                    <a:gd name="T61" fmla="*/ 39 h 134"/>
                    <a:gd name="T62" fmla="*/ 55 w 175"/>
                    <a:gd name="T63" fmla="*/ 47 h 134"/>
                    <a:gd name="T64" fmla="*/ 72 w 175"/>
                    <a:gd name="T65" fmla="*/ 43 h 134"/>
                    <a:gd name="T66" fmla="*/ 47 w 175"/>
                    <a:gd name="T67" fmla="*/ 92 h 134"/>
                    <a:gd name="T68" fmla="*/ 30 w 175"/>
                    <a:gd name="T69" fmla="*/ 96 h 134"/>
                    <a:gd name="T70" fmla="*/ 47 w 175"/>
                    <a:gd name="T71" fmla="*/ 100 h 13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</a:cxnLst>
                  <a:rect l="0" t="0" r="r" b="b"/>
                  <a:pathLst>
                    <a:path w="175" h="134">
                      <a:moveTo>
                        <a:pt x="147" y="79"/>
                      </a:moveTo>
                      <a:cubicBezTo>
                        <a:pt x="163" y="79"/>
                        <a:pt x="175" y="91"/>
                        <a:pt x="175" y="106"/>
                      </a:cubicBezTo>
                      <a:cubicBezTo>
                        <a:pt x="175" y="122"/>
                        <a:pt x="163" y="134"/>
                        <a:pt x="147" y="134"/>
                      </a:cubicBezTo>
                      <a:cubicBezTo>
                        <a:pt x="30" y="134"/>
                        <a:pt x="30" y="134"/>
                        <a:pt x="30" y="134"/>
                      </a:cubicBezTo>
                      <a:cubicBezTo>
                        <a:pt x="14" y="134"/>
                        <a:pt x="0" y="121"/>
                        <a:pt x="0" y="104"/>
                      </a:cubicBezTo>
                      <a:cubicBezTo>
                        <a:pt x="0" y="88"/>
                        <a:pt x="14" y="74"/>
                        <a:pt x="30" y="74"/>
                      </a:cubicBezTo>
                      <a:cubicBezTo>
                        <a:pt x="51" y="74"/>
                        <a:pt x="51" y="74"/>
                        <a:pt x="51" y="74"/>
                      </a:cubicBezTo>
                      <a:cubicBezTo>
                        <a:pt x="63" y="74"/>
                        <a:pt x="63" y="74"/>
                        <a:pt x="63" y="74"/>
                      </a:cubicBezTo>
                      <a:cubicBezTo>
                        <a:pt x="74" y="74"/>
                        <a:pt x="74" y="74"/>
                        <a:pt x="74" y="74"/>
                      </a:cubicBezTo>
                      <a:cubicBezTo>
                        <a:pt x="76" y="74"/>
                        <a:pt x="78" y="72"/>
                        <a:pt x="78" y="70"/>
                      </a:cubicBezTo>
                      <a:cubicBezTo>
                        <a:pt x="78" y="68"/>
                        <a:pt x="76" y="66"/>
                        <a:pt x="74" y="66"/>
                      </a:cubicBezTo>
                      <a:cubicBezTo>
                        <a:pt x="63" y="66"/>
                        <a:pt x="63" y="66"/>
                        <a:pt x="63" y="66"/>
                      </a:cubicBezTo>
                      <a:cubicBezTo>
                        <a:pt x="51" y="66"/>
                        <a:pt x="51" y="66"/>
                        <a:pt x="51" y="66"/>
                      </a:cubicBezTo>
                      <a:cubicBezTo>
                        <a:pt x="37" y="66"/>
                        <a:pt x="26" y="55"/>
                        <a:pt x="26" y="41"/>
                      </a:cubicBezTo>
                      <a:cubicBezTo>
                        <a:pt x="26" y="33"/>
                        <a:pt x="30" y="25"/>
                        <a:pt x="37" y="21"/>
                      </a:cubicBezTo>
                      <a:cubicBezTo>
                        <a:pt x="68" y="0"/>
                        <a:pt x="68" y="0"/>
                        <a:pt x="68" y="0"/>
                      </a:cubicBezTo>
                      <a:cubicBezTo>
                        <a:pt x="73" y="5"/>
                        <a:pt x="73" y="5"/>
                        <a:pt x="73" y="5"/>
                      </a:cubicBezTo>
                      <a:cubicBezTo>
                        <a:pt x="84" y="19"/>
                        <a:pt x="99" y="28"/>
                        <a:pt x="115" y="33"/>
                      </a:cubicBezTo>
                      <a:cubicBezTo>
                        <a:pt x="115" y="33"/>
                        <a:pt x="115" y="33"/>
                        <a:pt x="115" y="33"/>
                      </a:cubicBezTo>
                      <a:cubicBezTo>
                        <a:pt x="124" y="36"/>
                        <a:pt x="133" y="37"/>
                        <a:pt x="142" y="37"/>
                      </a:cubicBezTo>
                      <a:cubicBezTo>
                        <a:pt x="151" y="37"/>
                        <a:pt x="158" y="45"/>
                        <a:pt x="158" y="54"/>
                      </a:cubicBezTo>
                      <a:cubicBezTo>
                        <a:pt x="158" y="59"/>
                        <a:pt x="157" y="63"/>
                        <a:pt x="153" y="66"/>
                      </a:cubicBezTo>
                      <a:cubicBezTo>
                        <a:pt x="150" y="69"/>
                        <a:pt x="147" y="71"/>
                        <a:pt x="142" y="71"/>
                      </a:cubicBezTo>
                      <a:cubicBezTo>
                        <a:pt x="123" y="71"/>
                        <a:pt x="123" y="71"/>
                        <a:pt x="123" y="71"/>
                      </a:cubicBezTo>
                      <a:cubicBezTo>
                        <a:pt x="121" y="71"/>
                        <a:pt x="119" y="73"/>
                        <a:pt x="119" y="75"/>
                      </a:cubicBezTo>
                      <a:cubicBezTo>
                        <a:pt x="119" y="77"/>
                        <a:pt x="121" y="79"/>
                        <a:pt x="123" y="79"/>
                      </a:cubicBezTo>
                      <a:cubicBezTo>
                        <a:pt x="130" y="79"/>
                        <a:pt x="130" y="79"/>
                        <a:pt x="130" y="79"/>
                      </a:cubicBezTo>
                      <a:cubicBezTo>
                        <a:pt x="141" y="79"/>
                        <a:pt x="141" y="79"/>
                        <a:pt x="141" y="79"/>
                      </a:cubicBezTo>
                      <a:cubicBezTo>
                        <a:pt x="141" y="79"/>
                        <a:pt x="142" y="79"/>
                        <a:pt x="142" y="79"/>
                      </a:cubicBezTo>
                      <a:cubicBezTo>
                        <a:pt x="142" y="79"/>
                        <a:pt x="143" y="79"/>
                        <a:pt x="143" y="79"/>
                      </a:cubicBezTo>
                      <a:lnTo>
                        <a:pt x="147" y="79"/>
                      </a:lnTo>
                      <a:close/>
                      <a:moveTo>
                        <a:pt x="148" y="112"/>
                      </a:moveTo>
                      <a:cubicBezTo>
                        <a:pt x="148" y="110"/>
                        <a:pt x="147" y="108"/>
                        <a:pt x="144" y="108"/>
                      </a:cubicBezTo>
                      <a:cubicBezTo>
                        <a:pt x="131" y="108"/>
                        <a:pt x="131" y="108"/>
                        <a:pt x="131" y="108"/>
                      </a:cubicBezTo>
                      <a:cubicBezTo>
                        <a:pt x="129" y="108"/>
                        <a:pt x="127" y="110"/>
                        <a:pt x="127" y="112"/>
                      </a:cubicBezTo>
                      <a:cubicBezTo>
                        <a:pt x="127" y="114"/>
                        <a:pt x="129" y="116"/>
                        <a:pt x="131" y="116"/>
                      </a:cubicBezTo>
                      <a:cubicBezTo>
                        <a:pt x="144" y="116"/>
                        <a:pt x="144" y="116"/>
                        <a:pt x="144" y="116"/>
                      </a:cubicBezTo>
                      <a:cubicBezTo>
                        <a:pt x="147" y="116"/>
                        <a:pt x="148" y="114"/>
                        <a:pt x="148" y="112"/>
                      </a:cubicBezTo>
                      <a:close/>
                      <a:moveTo>
                        <a:pt x="124" y="55"/>
                      </a:moveTo>
                      <a:cubicBezTo>
                        <a:pt x="124" y="52"/>
                        <a:pt x="123" y="51"/>
                        <a:pt x="120" y="51"/>
                      </a:cubicBezTo>
                      <a:cubicBezTo>
                        <a:pt x="107" y="51"/>
                        <a:pt x="107" y="51"/>
                        <a:pt x="107" y="51"/>
                      </a:cubicBezTo>
                      <a:cubicBezTo>
                        <a:pt x="105" y="51"/>
                        <a:pt x="103" y="52"/>
                        <a:pt x="103" y="55"/>
                      </a:cubicBezTo>
                      <a:cubicBezTo>
                        <a:pt x="103" y="57"/>
                        <a:pt x="105" y="58"/>
                        <a:pt x="107" y="58"/>
                      </a:cubicBezTo>
                      <a:cubicBezTo>
                        <a:pt x="120" y="58"/>
                        <a:pt x="120" y="58"/>
                        <a:pt x="120" y="58"/>
                      </a:cubicBezTo>
                      <a:cubicBezTo>
                        <a:pt x="123" y="58"/>
                        <a:pt x="124" y="57"/>
                        <a:pt x="124" y="55"/>
                      </a:cubicBezTo>
                      <a:close/>
                      <a:moveTo>
                        <a:pt x="109" y="98"/>
                      </a:moveTo>
                      <a:cubicBezTo>
                        <a:pt x="109" y="95"/>
                        <a:pt x="107" y="94"/>
                        <a:pt x="105" y="94"/>
                      </a:cubicBezTo>
                      <a:cubicBezTo>
                        <a:pt x="92" y="94"/>
                        <a:pt x="92" y="94"/>
                        <a:pt x="92" y="94"/>
                      </a:cubicBezTo>
                      <a:cubicBezTo>
                        <a:pt x="90" y="94"/>
                        <a:pt x="88" y="95"/>
                        <a:pt x="88" y="98"/>
                      </a:cubicBezTo>
                      <a:cubicBezTo>
                        <a:pt x="88" y="100"/>
                        <a:pt x="90" y="101"/>
                        <a:pt x="92" y="101"/>
                      </a:cubicBezTo>
                      <a:cubicBezTo>
                        <a:pt x="105" y="101"/>
                        <a:pt x="105" y="101"/>
                        <a:pt x="105" y="101"/>
                      </a:cubicBezTo>
                      <a:cubicBezTo>
                        <a:pt x="107" y="101"/>
                        <a:pt x="109" y="100"/>
                        <a:pt x="109" y="98"/>
                      </a:cubicBezTo>
                      <a:close/>
                      <a:moveTo>
                        <a:pt x="84" y="118"/>
                      </a:moveTo>
                      <a:cubicBezTo>
                        <a:pt x="84" y="116"/>
                        <a:pt x="82" y="114"/>
                        <a:pt x="80" y="114"/>
                      </a:cubicBezTo>
                      <a:cubicBezTo>
                        <a:pt x="67" y="114"/>
                        <a:pt x="67" y="114"/>
                        <a:pt x="67" y="114"/>
                      </a:cubicBezTo>
                      <a:cubicBezTo>
                        <a:pt x="64" y="114"/>
                        <a:pt x="63" y="116"/>
                        <a:pt x="63" y="118"/>
                      </a:cubicBezTo>
                      <a:cubicBezTo>
                        <a:pt x="63" y="120"/>
                        <a:pt x="64" y="122"/>
                        <a:pt x="67" y="122"/>
                      </a:cubicBezTo>
                      <a:cubicBezTo>
                        <a:pt x="80" y="122"/>
                        <a:pt x="80" y="122"/>
                        <a:pt x="80" y="122"/>
                      </a:cubicBezTo>
                      <a:cubicBezTo>
                        <a:pt x="82" y="122"/>
                        <a:pt x="84" y="120"/>
                        <a:pt x="84" y="118"/>
                      </a:cubicBezTo>
                      <a:close/>
                      <a:moveTo>
                        <a:pt x="72" y="43"/>
                      </a:moveTo>
                      <a:cubicBezTo>
                        <a:pt x="72" y="41"/>
                        <a:pt x="70" y="39"/>
                        <a:pt x="68" y="39"/>
                      </a:cubicBezTo>
                      <a:cubicBezTo>
                        <a:pt x="55" y="39"/>
                        <a:pt x="55" y="39"/>
                        <a:pt x="55" y="39"/>
                      </a:cubicBezTo>
                      <a:cubicBezTo>
                        <a:pt x="53" y="39"/>
                        <a:pt x="51" y="41"/>
                        <a:pt x="51" y="43"/>
                      </a:cubicBezTo>
                      <a:cubicBezTo>
                        <a:pt x="51" y="45"/>
                        <a:pt x="53" y="47"/>
                        <a:pt x="55" y="47"/>
                      </a:cubicBezTo>
                      <a:cubicBezTo>
                        <a:pt x="68" y="47"/>
                        <a:pt x="68" y="47"/>
                        <a:pt x="68" y="47"/>
                      </a:cubicBezTo>
                      <a:cubicBezTo>
                        <a:pt x="70" y="47"/>
                        <a:pt x="72" y="45"/>
                        <a:pt x="72" y="43"/>
                      </a:cubicBezTo>
                      <a:close/>
                      <a:moveTo>
                        <a:pt x="50" y="96"/>
                      </a:moveTo>
                      <a:cubicBezTo>
                        <a:pt x="50" y="94"/>
                        <a:pt x="49" y="92"/>
                        <a:pt x="47" y="92"/>
                      </a:cubicBezTo>
                      <a:cubicBezTo>
                        <a:pt x="33" y="92"/>
                        <a:pt x="33" y="92"/>
                        <a:pt x="33" y="92"/>
                      </a:cubicBezTo>
                      <a:cubicBezTo>
                        <a:pt x="31" y="92"/>
                        <a:pt x="30" y="94"/>
                        <a:pt x="30" y="96"/>
                      </a:cubicBezTo>
                      <a:cubicBezTo>
                        <a:pt x="30" y="98"/>
                        <a:pt x="31" y="100"/>
                        <a:pt x="33" y="100"/>
                      </a:cubicBezTo>
                      <a:cubicBezTo>
                        <a:pt x="47" y="100"/>
                        <a:pt x="47" y="100"/>
                        <a:pt x="47" y="100"/>
                      </a:cubicBezTo>
                      <a:cubicBezTo>
                        <a:pt x="49" y="100"/>
                        <a:pt x="50" y="98"/>
                        <a:pt x="50" y="96"/>
                      </a:cubicBezTo>
                      <a:close/>
                    </a:path>
                  </a:pathLst>
                </a:custGeom>
                <a:solidFill>
                  <a:srgbClr val="E09D3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80" name="Freeform 17">
                  <a:extLst>
                    <a:ext uri="{FF2B5EF4-FFF2-40B4-BE49-F238E27FC236}">
                      <a16:creationId xmlns:a16="http://schemas.microsoft.com/office/drawing/2014/main" id="{B6289C35-6593-4EE9-B375-363D660FB092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864" y="1678"/>
                  <a:ext cx="458" cy="368"/>
                </a:xfrm>
                <a:custGeom>
                  <a:avLst/>
                  <a:gdLst>
                    <a:gd name="T0" fmla="*/ 129 w 190"/>
                    <a:gd name="T1" fmla="*/ 37 h 152"/>
                    <a:gd name="T2" fmla="*/ 149 w 190"/>
                    <a:gd name="T3" fmla="*/ 40 h 152"/>
                    <a:gd name="T4" fmla="*/ 173 w 190"/>
                    <a:gd name="T5" fmla="*/ 64 h 152"/>
                    <a:gd name="T6" fmla="*/ 166 w 190"/>
                    <a:gd name="T7" fmla="*/ 82 h 152"/>
                    <a:gd name="T8" fmla="*/ 165 w 190"/>
                    <a:gd name="T9" fmla="*/ 82 h 152"/>
                    <a:gd name="T10" fmla="*/ 190 w 190"/>
                    <a:gd name="T11" fmla="*/ 116 h 152"/>
                    <a:gd name="T12" fmla="*/ 154 w 190"/>
                    <a:gd name="T13" fmla="*/ 152 h 152"/>
                    <a:gd name="T14" fmla="*/ 37 w 190"/>
                    <a:gd name="T15" fmla="*/ 152 h 152"/>
                    <a:gd name="T16" fmla="*/ 0 w 190"/>
                    <a:gd name="T17" fmla="*/ 114 h 152"/>
                    <a:gd name="T18" fmla="*/ 37 w 190"/>
                    <a:gd name="T19" fmla="*/ 76 h 152"/>
                    <a:gd name="T20" fmla="*/ 25 w 190"/>
                    <a:gd name="T21" fmla="*/ 51 h 152"/>
                    <a:gd name="T22" fmla="*/ 40 w 190"/>
                    <a:gd name="T23" fmla="*/ 24 h 152"/>
                    <a:gd name="T24" fmla="*/ 74 w 190"/>
                    <a:gd name="T25" fmla="*/ 1 h 152"/>
                    <a:gd name="T26" fmla="*/ 79 w 190"/>
                    <a:gd name="T27" fmla="*/ 2 h 152"/>
                    <a:gd name="T28" fmla="*/ 86 w 190"/>
                    <a:gd name="T29" fmla="*/ 10 h 152"/>
                    <a:gd name="T30" fmla="*/ 121 w 190"/>
                    <a:gd name="T31" fmla="*/ 35 h 152"/>
                    <a:gd name="T32" fmla="*/ 182 w 190"/>
                    <a:gd name="T33" fmla="*/ 116 h 152"/>
                    <a:gd name="T34" fmla="*/ 154 w 190"/>
                    <a:gd name="T35" fmla="*/ 89 h 152"/>
                    <a:gd name="T36" fmla="*/ 150 w 190"/>
                    <a:gd name="T37" fmla="*/ 89 h 152"/>
                    <a:gd name="T38" fmla="*/ 149 w 190"/>
                    <a:gd name="T39" fmla="*/ 89 h 152"/>
                    <a:gd name="T40" fmla="*/ 148 w 190"/>
                    <a:gd name="T41" fmla="*/ 89 h 152"/>
                    <a:gd name="T42" fmla="*/ 137 w 190"/>
                    <a:gd name="T43" fmla="*/ 89 h 152"/>
                    <a:gd name="T44" fmla="*/ 130 w 190"/>
                    <a:gd name="T45" fmla="*/ 89 h 152"/>
                    <a:gd name="T46" fmla="*/ 126 w 190"/>
                    <a:gd name="T47" fmla="*/ 85 h 152"/>
                    <a:gd name="T48" fmla="*/ 130 w 190"/>
                    <a:gd name="T49" fmla="*/ 81 h 152"/>
                    <a:gd name="T50" fmla="*/ 149 w 190"/>
                    <a:gd name="T51" fmla="*/ 81 h 152"/>
                    <a:gd name="T52" fmla="*/ 160 w 190"/>
                    <a:gd name="T53" fmla="*/ 76 h 152"/>
                    <a:gd name="T54" fmla="*/ 165 w 190"/>
                    <a:gd name="T55" fmla="*/ 64 h 152"/>
                    <a:gd name="T56" fmla="*/ 149 w 190"/>
                    <a:gd name="T57" fmla="*/ 47 h 152"/>
                    <a:gd name="T58" fmla="*/ 122 w 190"/>
                    <a:gd name="T59" fmla="*/ 43 h 152"/>
                    <a:gd name="T60" fmla="*/ 122 w 190"/>
                    <a:gd name="T61" fmla="*/ 43 h 152"/>
                    <a:gd name="T62" fmla="*/ 80 w 190"/>
                    <a:gd name="T63" fmla="*/ 15 h 152"/>
                    <a:gd name="T64" fmla="*/ 75 w 190"/>
                    <a:gd name="T65" fmla="*/ 10 h 152"/>
                    <a:gd name="T66" fmla="*/ 44 w 190"/>
                    <a:gd name="T67" fmla="*/ 31 h 152"/>
                    <a:gd name="T68" fmla="*/ 33 w 190"/>
                    <a:gd name="T69" fmla="*/ 51 h 152"/>
                    <a:gd name="T70" fmla="*/ 58 w 190"/>
                    <a:gd name="T71" fmla="*/ 76 h 152"/>
                    <a:gd name="T72" fmla="*/ 70 w 190"/>
                    <a:gd name="T73" fmla="*/ 76 h 152"/>
                    <a:gd name="T74" fmla="*/ 81 w 190"/>
                    <a:gd name="T75" fmla="*/ 76 h 152"/>
                    <a:gd name="T76" fmla="*/ 85 w 190"/>
                    <a:gd name="T77" fmla="*/ 80 h 152"/>
                    <a:gd name="T78" fmla="*/ 81 w 190"/>
                    <a:gd name="T79" fmla="*/ 84 h 152"/>
                    <a:gd name="T80" fmla="*/ 70 w 190"/>
                    <a:gd name="T81" fmla="*/ 84 h 152"/>
                    <a:gd name="T82" fmla="*/ 58 w 190"/>
                    <a:gd name="T83" fmla="*/ 84 h 152"/>
                    <a:gd name="T84" fmla="*/ 37 w 190"/>
                    <a:gd name="T85" fmla="*/ 84 h 152"/>
                    <a:gd name="T86" fmla="*/ 7 w 190"/>
                    <a:gd name="T87" fmla="*/ 114 h 152"/>
                    <a:gd name="T88" fmla="*/ 37 w 190"/>
                    <a:gd name="T89" fmla="*/ 144 h 152"/>
                    <a:gd name="T90" fmla="*/ 154 w 190"/>
                    <a:gd name="T91" fmla="*/ 144 h 152"/>
                    <a:gd name="T92" fmla="*/ 182 w 190"/>
                    <a:gd name="T93" fmla="*/ 116 h 15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</a:cxnLst>
                  <a:rect l="0" t="0" r="r" b="b"/>
                  <a:pathLst>
                    <a:path w="190" h="152">
                      <a:moveTo>
                        <a:pt x="129" y="37"/>
                      </a:moveTo>
                      <a:cubicBezTo>
                        <a:pt x="136" y="39"/>
                        <a:pt x="142" y="40"/>
                        <a:pt x="149" y="40"/>
                      </a:cubicBezTo>
                      <a:cubicBezTo>
                        <a:pt x="162" y="40"/>
                        <a:pt x="173" y="51"/>
                        <a:pt x="173" y="64"/>
                      </a:cubicBezTo>
                      <a:cubicBezTo>
                        <a:pt x="173" y="71"/>
                        <a:pt x="171" y="77"/>
                        <a:pt x="166" y="82"/>
                      </a:cubicBezTo>
                      <a:cubicBezTo>
                        <a:pt x="166" y="82"/>
                        <a:pt x="165" y="82"/>
                        <a:pt x="165" y="82"/>
                      </a:cubicBezTo>
                      <a:cubicBezTo>
                        <a:pt x="179" y="87"/>
                        <a:pt x="190" y="100"/>
                        <a:pt x="190" y="116"/>
                      </a:cubicBezTo>
                      <a:cubicBezTo>
                        <a:pt x="190" y="136"/>
                        <a:pt x="174" y="152"/>
                        <a:pt x="154" y="152"/>
                      </a:cubicBezTo>
                      <a:cubicBezTo>
                        <a:pt x="37" y="152"/>
                        <a:pt x="37" y="152"/>
                        <a:pt x="37" y="152"/>
                      </a:cubicBezTo>
                      <a:cubicBezTo>
                        <a:pt x="17" y="152"/>
                        <a:pt x="0" y="135"/>
                        <a:pt x="0" y="114"/>
                      </a:cubicBezTo>
                      <a:cubicBezTo>
                        <a:pt x="0" y="94"/>
                        <a:pt x="16" y="77"/>
                        <a:pt x="37" y="76"/>
                      </a:cubicBezTo>
                      <a:cubicBezTo>
                        <a:pt x="29" y="70"/>
                        <a:pt x="25" y="61"/>
                        <a:pt x="25" y="51"/>
                      </a:cubicBezTo>
                      <a:cubicBezTo>
                        <a:pt x="25" y="40"/>
                        <a:pt x="30" y="30"/>
                        <a:pt x="40" y="24"/>
                      </a:cubicBezTo>
                      <a:cubicBezTo>
                        <a:pt x="74" y="1"/>
                        <a:pt x="74" y="1"/>
                        <a:pt x="74" y="1"/>
                      </a:cubicBezTo>
                      <a:cubicBezTo>
                        <a:pt x="76" y="0"/>
                        <a:pt x="78" y="1"/>
                        <a:pt x="79" y="2"/>
                      </a:cubicBezTo>
                      <a:cubicBezTo>
                        <a:pt x="86" y="10"/>
                        <a:pt x="86" y="10"/>
                        <a:pt x="86" y="10"/>
                      </a:cubicBezTo>
                      <a:cubicBezTo>
                        <a:pt x="96" y="22"/>
                        <a:pt x="108" y="30"/>
                        <a:pt x="121" y="35"/>
                      </a:cubicBezTo>
                      <a:moveTo>
                        <a:pt x="182" y="116"/>
                      </a:moveTo>
                      <a:cubicBezTo>
                        <a:pt x="182" y="101"/>
                        <a:pt x="170" y="89"/>
                        <a:pt x="154" y="89"/>
                      </a:cubicBezTo>
                      <a:cubicBezTo>
                        <a:pt x="150" y="89"/>
                        <a:pt x="150" y="89"/>
                        <a:pt x="150" y="89"/>
                      </a:cubicBezTo>
                      <a:cubicBezTo>
                        <a:pt x="150" y="89"/>
                        <a:pt x="149" y="89"/>
                        <a:pt x="149" y="89"/>
                      </a:cubicBezTo>
                      <a:cubicBezTo>
                        <a:pt x="149" y="89"/>
                        <a:pt x="148" y="89"/>
                        <a:pt x="148" y="89"/>
                      </a:cubicBezTo>
                      <a:cubicBezTo>
                        <a:pt x="137" y="89"/>
                        <a:pt x="137" y="89"/>
                        <a:pt x="137" y="89"/>
                      </a:cubicBezTo>
                      <a:cubicBezTo>
                        <a:pt x="130" y="89"/>
                        <a:pt x="130" y="89"/>
                        <a:pt x="130" y="89"/>
                      </a:cubicBezTo>
                      <a:cubicBezTo>
                        <a:pt x="128" y="89"/>
                        <a:pt x="126" y="87"/>
                        <a:pt x="126" y="85"/>
                      </a:cubicBezTo>
                      <a:cubicBezTo>
                        <a:pt x="126" y="83"/>
                        <a:pt x="128" y="81"/>
                        <a:pt x="130" y="81"/>
                      </a:cubicBezTo>
                      <a:cubicBezTo>
                        <a:pt x="149" y="81"/>
                        <a:pt x="149" y="81"/>
                        <a:pt x="149" y="81"/>
                      </a:cubicBezTo>
                      <a:cubicBezTo>
                        <a:pt x="154" y="81"/>
                        <a:pt x="157" y="79"/>
                        <a:pt x="160" y="76"/>
                      </a:cubicBezTo>
                      <a:cubicBezTo>
                        <a:pt x="164" y="73"/>
                        <a:pt x="165" y="69"/>
                        <a:pt x="165" y="64"/>
                      </a:cubicBezTo>
                      <a:cubicBezTo>
                        <a:pt x="165" y="55"/>
                        <a:pt x="158" y="47"/>
                        <a:pt x="149" y="47"/>
                      </a:cubicBezTo>
                      <a:cubicBezTo>
                        <a:pt x="140" y="47"/>
                        <a:pt x="131" y="46"/>
                        <a:pt x="122" y="43"/>
                      </a:cubicBezTo>
                      <a:cubicBezTo>
                        <a:pt x="122" y="43"/>
                        <a:pt x="122" y="43"/>
                        <a:pt x="122" y="43"/>
                      </a:cubicBezTo>
                      <a:cubicBezTo>
                        <a:pt x="106" y="38"/>
                        <a:pt x="91" y="29"/>
                        <a:pt x="80" y="15"/>
                      </a:cubicBezTo>
                      <a:cubicBezTo>
                        <a:pt x="75" y="10"/>
                        <a:pt x="75" y="10"/>
                        <a:pt x="75" y="10"/>
                      </a:cubicBezTo>
                      <a:cubicBezTo>
                        <a:pt x="44" y="31"/>
                        <a:pt x="44" y="31"/>
                        <a:pt x="44" y="31"/>
                      </a:cubicBezTo>
                      <a:cubicBezTo>
                        <a:pt x="37" y="35"/>
                        <a:pt x="33" y="43"/>
                        <a:pt x="33" y="51"/>
                      </a:cubicBezTo>
                      <a:cubicBezTo>
                        <a:pt x="33" y="65"/>
                        <a:pt x="44" y="76"/>
                        <a:pt x="58" y="76"/>
                      </a:cubicBezTo>
                      <a:cubicBezTo>
                        <a:pt x="70" y="76"/>
                        <a:pt x="70" y="76"/>
                        <a:pt x="70" y="76"/>
                      </a:cubicBezTo>
                      <a:cubicBezTo>
                        <a:pt x="81" y="76"/>
                        <a:pt x="81" y="76"/>
                        <a:pt x="81" y="76"/>
                      </a:cubicBezTo>
                      <a:cubicBezTo>
                        <a:pt x="83" y="76"/>
                        <a:pt x="85" y="78"/>
                        <a:pt x="85" y="80"/>
                      </a:cubicBezTo>
                      <a:cubicBezTo>
                        <a:pt x="85" y="82"/>
                        <a:pt x="83" y="84"/>
                        <a:pt x="81" y="84"/>
                      </a:cubicBezTo>
                      <a:cubicBezTo>
                        <a:pt x="70" y="84"/>
                        <a:pt x="70" y="84"/>
                        <a:pt x="70" y="84"/>
                      </a:cubicBezTo>
                      <a:cubicBezTo>
                        <a:pt x="58" y="84"/>
                        <a:pt x="58" y="84"/>
                        <a:pt x="58" y="84"/>
                      </a:cubicBezTo>
                      <a:cubicBezTo>
                        <a:pt x="37" y="84"/>
                        <a:pt x="37" y="84"/>
                        <a:pt x="37" y="84"/>
                      </a:cubicBezTo>
                      <a:cubicBezTo>
                        <a:pt x="21" y="84"/>
                        <a:pt x="7" y="98"/>
                        <a:pt x="7" y="114"/>
                      </a:cubicBezTo>
                      <a:cubicBezTo>
                        <a:pt x="7" y="131"/>
                        <a:pt x="21" y="144"/>
                        <a:pt x="37" y="144"/>
                      </a:cubicBezTo>
                      <a:cubicBezTo>
                        <a:pt x="154" y="144"/>
                        <a:pt x="154" y="144"/>
                        <a:pt x="154" y="144"/>
                      </a:cubicBezTo>
                      <a:cubicBezTo>
                        <a:pt x="170" y="144"/>
                        <a:pt x="182" y="132"/>
                        <a:pt x="182" y="116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81" name="Freeform 18">
                  <a:extLst>
                    <a:ext uri="{FF2B5EF4-FFF2-40B4-BE49-F238E27FC236}">
                      <a16:creationId xmlns:a16="http://schemas.microsoft.com/office/drawing/2014/main" id="{517E7112-EC66-4297-995C-3BDA3371C40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187" y="1963"/>
                  <a:ext cx="51" cy="20"/>
                </a:xfrm>
                <a:custGeom>
                  <a:avLst/>
                  <a:gdLst>
                    <a:gd name="T0" fmla="*/ 17 w 21"/>
                    <a:gd name="T1" fmla="*/ 0 h 8"/>
                    <a:gd name="T2" fmla="*/ 21 w 21"/>
                    <a:gd name="T3" fmla="*/ 4 h 8"/>
                    <a:gd name="T4" fmla="*/ 17 w 21"/>
                    <a:gd name="T5" fmla="*/ 8 h 8"/>
                    <a:gd name="T6" fmla="*/ 4 w 21"/>
                    <a:gd name="T7" fmla="*/ 8 h 8"/>
                    <a:gd name="T8" fmla="*/ 0 w 21"/>
                    <a:gd name="T9" fmla="*/ 4 h 8"/>
                    <a:gd name="T10" fmla="*/ 4 w 21"/>
                    <a:gd name="T11" fmla="*/ 0 h 8"/>
                    <a:gd name="T12" fmla="*/ 17 w 21"/>
                    <a:gd name="T13" fmla="*/ 0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1" h="8">
                      <a:moveTo>
                        <a:pt x="17" y="0"/>
                      </a:moveTo>
                      <a:cubicBezTo>
                        <a:pt x="20" y="0"/>
                        <a:pt x="21" y="2"/>
                        <a:pt x="21" y="4"/>
                      </a:cubicBezTo>
                      <a:cubicBezTo>
                        <a:pt x="21" y="6"/>
                        <a:pt x="20" y="8"/>
                        <a:pt x="17" y="8"/>
                      </a:cubicBezTo>
                      <a:cubicBezTo>
                        <a:pt x="4" y="8"/>
                        <a:pt x="4" y="8"/>
                        <a:pt x="4" y="8"/>
                      </a:cubicBezTo>
                      <a:cubicBezTo>
                        <a:pt x="2" y="8"/>
                        <a:pt x="0" y="6"/>
                        <a:pt x="0" y="4"/>
                      </a:cubicBezTo>
                      <a:cubicBezTo>
                        <a:pt x="0" y="2"/>
                        <a:pt x="2" y="0"/>
                        <a:pt x="4" y="0"/>
                      </a:cubicBez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82" name="Freeform 19">
                  <a:extLst>
                    <a:ext uri="{FF2B5EF4-FFF2-40B4-BE49-F238E27FC236}">
                      <a16:creationId xmlns:a16="http://schemas.microsoft.com/office/drawing/2014/main" id="{65DA6329-BE49-4EB8-B710-7B564396BA8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129" y="1825"/>
                  <a:ext cx="51" cy="17"/>
                </a:xfrm>
                <a:custGeom>
                  <a:avLst/>
                  <a:gdLst>
                    <a:gd name="T0" fmla="*/ 17 w 21"/>
                    <a:gd name="T1" fmla="*/ 0 h 7"/>
                    <a:gd name="T2" fmla="*/ 21 w 21"/>
                    <a:gd name="T3" fmla="*/ 4 h 7"/>
                    <a:gd name="T4" fmla="*/ 17 w 21"/>
                    <a:gd name="T5" fmla="*/ 7 h 7"/>
                    <a:gd name="T6" fmla="*/ 4 w 21"/>
                    <a:gd name="T7" fmla="*/ 7 h 7"/>
                    <a:gd name="T8" fmla="*/ 0 w 21"/>
                    <a:gd name="T9" fmla="*/ 4 h 7"/>
                    <a:gd name="T10" fmla="*/ 4 w 21"/>
                    <a:gd name="T11" fmla="*/ 0 h 7"/>
                    <a:gd name="T12" fmla="*/ 17 w 21"/>
                    <a:gd name="T13" fmla="*/ 0 h 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1" h="7">
                      <a:moveTo>
                        <a:pt x="17" y="0"/>
                      </a:moveTo>
                      <a:cubicBezTo>
                        <a:pt x="20" y="0"/>
                        <a:pt x="21" y="1"/>
                        <a:pt x="21" y="4"/>
                      </a:cubicBezTo>
                      <a:cubicBezTo>
                        <a:pt x="21" y="6"/>
                        <a:pt x="20" y="7"/>
                        <a:pt x="17" y="7"/>
                      </a:cubicBezTo>
                      <a:cubicBezTo>
                        <a:pt x="4" y="7"/>
                        <a:pt x="4" y="7"/>
                        <a:pt x="4" y="7"/>
                      </a:cubicBezTo>
                      <a:cubicBezTo>
                        <a:pt x="2" y="7"/>
                        <a:pt x="0" y="6"/>
                        <a:pt x="0" y="4"/>
                      </a:cubicBezTo>
                      <a:cubicBezTo>
                        <a:pt x="0" y="1"/>
                        <a:pt x="2" y="0"/>
                        <a:pt x="4" y="0"/>
                      </a:cubicBez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83" name="Freeform 20">
                  <a:extLst>
                    <a:ext uri="{FF2B5EF4-FFF2-40B4-BE49-F238E27FC236}">
                      <a16:creationId xmlns:a16="http://schemas.microsoft.com/office/drawing/2014/main" id="{B8FF8D1B-2EE2-455C-8C4D-FB8757CE094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93" y="1930"/>
                  <a:ext cx="51" cy="16"/>
                </a:xfrm>
                <a:custGeom>
                  <a:avLst/>
                  <a:gdLst>
                    <a:gd name="T0" fmla="*/ 17 w 21"/>
                    <a:gd name="T1" fmla="*/ 0 h 7"/>
                    <a:gd name="T2" fmla="*/ 21 w 21"/>
                    <a:gd name="T3" fmla="*/ 4 h 7"/>
                    <a:gd name="T4" fmla="*/ 17 w 21"/>
                    <a:gd name="T5" fmla="*/ 7 h 7"/>
                    <a:gd name="T6" fmla="*/ 4 w 21"/>
                    <a:gd name="T7" fmla="*/ 7 h 7"/>
                    <a:gd name="T8" fmla="*/ 0 w 21"/>
                    <a:gd name="T9" fmla="*/ 4 h 7"/>
                    <a:gd name="T10" fmla="*/ 4 w 21"/>
                    <a:gd name="T11" fmla="*/ 0 h 7"/>
                    <a:gd name="T12" fmla="*/ 17 w 21"/>
                    <a:gd name="T13" fmla="*/ 0 h 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1" h="7">
                      <a:moveTo>
                        <a:pt x="17" y="0"/>
                      </a:moveTo>
                      <a:cubicBezTo>
                        <a:pt x="19" y="0"/>
                        <a:pt x="21" y="1"/>
                        <a:pt x="21" y="4"/>
                      </a:cubicBezTo>
                      <a:cubicBezTo>
                        <a:pt x="21" y="6"/>
                        <a:pt x="19" y="7"/>
                        <a:pt x="17" y="7"/>
                      </a:cubicBezTo>
                      <a:cubicBezTo>
                        <a:pt x="4" y="7"/>
                        <a:pt x="4" y="7"/>
                        <a:pt x="4" y="7"/>
                      </a:cubicBezTo>
                      <a:cubicBezTo>
                        <a:pt x="2" y="7"/>
                        <a:pt x="0" y="6"/>
                        <a:pt x="0" y="4"/>
                      </a:cubicBezTo>
                      <a:cubicBezTo>
                        <a:pt x="0" y="1"/>
                        <a:pt x="2" y="0"/>
                        <a:pt x="4" y="0"/>
                      </a:cubicBez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84" name="Freeform 21">
                  <a:extLst>
                    <a:ext uri="{FF2B5EF4-FFF2-40B4-BE49-F238E27FC236}">
                      <a16:creationId xmlns:a16="http://schemas.microsoft.com/office/drawing/2014/main" id="{912AAB43-B9E4-4D56-A01C-282BF269A9F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33" y="1978"/>
                  <a:ext cx="51" cy="19"/>
                </a:xfrm>
                <a:custGeom>
                  <a:avLst/>
                  <a:gdLst>
                    <a:gd name="T0" fmla="*/ 17 w 21"/>
                    <a:gd name="T1" fmla="*/ 0 h 8"/>
                    <a:gd name="T2" fmla="*/ 21 w 21"/>
                    <a:gd name="T3" fmla="*/ 4 h 8"/>
                    <a:gd name="T4" fmla="*/ 17 w 21"/>
                    <a:gd name="T5" fmla="*/ 8 h 8"/>
                    <a:gd name="T6" fmla="*/ 4 w 21"/>
                    <a:gd name="T7" fmla="*/ 8 h 8"/>
                    <a:gd name="T8" fmla="*/ 0 w 21"/>
                    <a:gd name="T9" fmla="*/ 4 h 8"/>
                    <a:gd name="T10" fmla="*/ 4 w 21"/>
                    <a:gd name="T11" fmla="*/ 0 h 8"/>
                    <a:gd name="T12" fmla="*/ 17 w 21"/>
                    <a:gd name="T13" fmla="*/ 0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1" h="8">
                      <a:moveTo>
                        <a:pt x="17" y="0"/>
                      </a:moveTo>
                      <a:cubicBezTo>
                        <a:pt x="19" y="0"/>
                        <a:pt x="21" y="2"/>
                        <a:pt x="21" y="4"/>
                      </a:cubicBezTo>
                      <a:cubicBezTo>
                        <a:pt x="21" y="6"/>
                        <a:pt x="19" y="8"/>
                        <a:pt x="17" y="8"/>
                      </a:cubicBezTo>
                      <a:cubicBezTo>
                        <a:pt x="4" y="8"/>
                        <a:pt x="4" y="8"/>
                        <a:pt x="4" y="8"/>
                      </a:cubicBezTo>
                      <a:cubicBezTo>
                        <a:pt x="1" y="8"/>
                        <a:pt x="0" y="6"/>
                        <a:pt x="0" y="4"/>
                      </a:cubicBezTo>
                      <a:cubicBezTo>
                        <a:pt x="0" y="2"/>
                        <a:pt x="1" y="0"/>
                        <a:pt x="4" y="0"/>
                      </a:cubicBez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85" name="Freeform 22">
                  <a:extLst>
                    <a:ext uri="{FF2B5EF4-FFF2-40B4-BE49-F238E27FC236}">
                      <a16:creationId xmlns:a16="http://schemas.microsoft.com/office/drawing/2014/main" id="{04E8C6E1-5CB6-4DBA-943D-B7D0FF81C04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04" y="1796"/>
                  <a:ext cx="51" cy="20"/>
                </a:xfrm>
                <a:custGeom>
                  <a:avLst/>
                  <a:gdLst>
                    <a:gd name="T0" fmla="*/ 17 w 21"/>
                    <a:gd name="T1" fmla="*/ 0 h 8"/>
                    <a:gd name="T2" fmla="*/ 21 w 21"/>
                    <a:gd name="T3" fmla="*/ 4 h 8"/>
                    <a:gd name="T4" fmla="*/ 17 w 21"/>
                    <a:gd name="T5" fmla="*/ 8 h 8"/>
                    <a:gd name="T6" fmla="*/ 4 w 21"/>
                    <a:gd name="T7" fmla="*/ 8 h 8"/>
                    <a:gd name="T8" fmla="*/ 0 w 21"/>
                    <a:gd name="T9" fmla="*/ 4 h 8"/>
                    <a:gd name="T10" fmla="*/ 4 w 21"/>
                    <a:gd name="T11" fmla="*/ 0 h 8"/>
                    <a:gd name="T12" fmla="*/ 17 w 21"/>
                    <a:gd name="T13" fmla="*/ 0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1" h="8">
                      <a:moveTo>
                        <a:pt x="17" y="0"/>
                      </a:moveTo>
                      <a:cubicBezTo>
                        <a:pt x="19" y="0"/>
                        <a:pt x="21" y="2"/>
                        <a:pt x="21" y="4"/>
                      </a:cubicBezTo>
                      <a:cubicBezTo>
                        <a:pt x="21" y="6"/>
                        <a:pt x="19" y="8"/>
                        <a:pt x="17" y="8"/>
                      </a:cubicBezTo>
                      <a:cubicBezTo>
                        <a:pt x="4" y="8"/>
                        <a:pt x="4" y="8"/>
                        <a:pt x="4" y="8"/>
                      </a:cubicBezTo>
                      <a:cubicBezTo>
                        <a:pt x="2" y="8"/>
                        <a:pt x="0" y="6"/>
                        <a:pt x="0" y="4"/>
                      </a:cubicBezTo>
                      <a:cubicBezTo>
                        <a:pt x="0" y="2"/>
                        <a:pt x="2" y="0"/>
                        <a:pt x="4" y="0"/>
                      </a:cubicBez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186" name="Freeform 23">
                  <a:extLst>
                    <a:ext uri="{FF2B5EF4-FFF2-40B4-BE49-F238E27FC236}">
                      <a16:creationId xmlns:a16="http://schemas.microsoft.com/office/drawing/2014/main" id="{DDDD5EE6-4DFA-4598-911D-A3140FE00E3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54" y="1925"/>
                  <a:ext cx="48" cy="19"/>
                </a:xfrm>
                <a:custGeom>
                  <a:avLst/>
                  <a:gdLst>
                    <a:gd name="T0" fmla="*/ 17 w 20"/>
                    <a:gd name="T1" fmla="*/ 0 h 8"/>
                    <a:gd name="T2" fmla="*/ 20 w 20"/>
                    <a:gd name="T3" fmla="*/ 4 h 8"/>
                    <a:gd name="T4" fmla="*/ 17 w 20"/>
                    <a:gd name="T5" fmla="*/ 8 h 8"/>
                    <a:gd name="T6" fmla="*/ 3 w 20"/>
                    <a:gd name="T7" fmla="*/ 8 h 8"/>
                    <a:gd name="T8" fmla="*/ 0 w 20"/>
                    <a:gd name="T9" fmla="*/ 4 h 8"/>
                    <a:gd name="T10" fmla="*/ 3 w 20"/>
                    <a:gd name="T11" fmla="*/ 0 h 8"/>
                    <a:gd name="T12" fmla="*/ 17 w 20"/>
                    <a:gd name="T13" fmla="*/ 0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0" h="8">
                      <a:moveTo>
                        <a:pt x="17" y="0"/>
                      </a:moveTo>
                      <a:cubicBezTo>
                        <a:pt x="19" y="0"/>
                        <a:pt x="20" y="2"/>
                        <a:pt x="20" y="4"/>
                      </a:cubicBezTo>
                      <a:cubicBezTo>
                        <a:pt x="20" y="6"/>
                        <a:pt x="19" y="8"/>
                        <a:pt x="17" y="8"/>
                      </a:cubicBezTo>
                      <a:cubicBezTo>
                        <a:pt x="3" y="8"/>
                        <a:pt x="3" y="8"/>
                        <a:pt x="3" y="8"/>
                      </a:cubicBezTo>
                      <a:cubicBezTo>
                        <a:pt x="1" y="8"/>
                        <a:pt x="0" y="6"/>
                        <a:pt x="0" y="4"/>
                      </a:cubicBezTo>
                      <a:cubicBezTo>
                        <a:pt x="0" y="2"/>
                        <a:pt x="1" y="0"/>
                        <a:pt x="3" y="0"/>
                      </a:cubicBez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61724" tIns="30862" rIns="61724" bIns="30862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545434"/>
                  <a:endParaRPr lang="ko-KR" altLang="en-US" sz="1215">
                    <a:solidFill>
                      <a:prstClr val="black"/>
                    </a:solidFill>
                    <a:latin typeface="맑은 고딕" panose="020F0502020204030204"/>
                    <a:ea typeface="맑은 고딕" panose="020B0503020000020004" pitchFamily="50" charset="-127"/>
                  </a:endParaRPr>
                </a:p>
              </p:txBody>
            </p:sp>
          </p:grpSp>
        </p:grpSp>
        <p:pic>
          <p:nvPicPr>
            <p:cNvPr id="74" name="그림 73">
              <a:extLst>
                <a:ext uri="{FF2B5EF4-FFF2-40B4-BE49-F238E27FC236}">
                  <a16:creationId xmlns:a16="http://schemas.microsoft.com/office/drawing/2014/main" id="{A7FB3DC5-704A-4576-9A82-0316EB70EDB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66379" y="5444976"/>
              <a:ext cx="1574041" cy="87228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4508232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테마">
  <a:themeElements>
    <a:clrScheme name="사용자 지정 10">
      <a:dk1>
        <a:sysClr val="windowText" lastClr="000000"/>
      </a:dk1>
      <a:lt1>
        <a:sysClr val="window" lastClr="FFFFFF"/>
      </a:lt1>
      <a:dk2>
        <a:srgbClr val="0B2327"/>
      </a:dk2>
      <a:lt2>
        <a:srgbClr val="0845CC"/>
      </a:lt2>
      <a:accent1>
        <a:srgbClr val="1E94A2"/>
      </a:accent1>
      <a:accent2>
        <a:srgbClr val="EEDA93"/>
      </a:accent2>
      <a:accent3>
        <a:srgbClr val="00A3D9"/>
      </a:accent3>
      <a:accent4>
        <a:srgbClr val="EEEFF6"/>
      </a:accent4>
      <a:accent5>
        <a:srgbClr val="F86B6B"/>
      </a:accent5>
      <a:accent6>
        <a:srgbClr val="E8404F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9</TotalTime>
  <Words>28</Words>
  <Application>Microsoft Office PowerPoint</Application>
  <PresentationFormat>와이드스크린</PresentationFormat>
  <Paragraphs>1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1_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nji Kim</dc:creator>
  <cp:lastModifiedBy>김지현</cp:lastModifiedBy>
  <cp:revision>9</cp:revision>
  <dcterms:created xsi:type="dcterms:W3CDTF">2024-03-13T12:05:10Z</dcterms:created>
  <dcterms:modified xsi:type="dcterms:W3CDTF">2025-01-22T07:57:06Z</dcterms:modified>
</cp:coreProperties>
</file>